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321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6A6A6"/>
    <a:srgbClr val="181717"/>
    <a:srgbClr val="D9D9D9"/>
    <a:srgbClr val="002060"/>
    <a:srgbClr val="FF0000"/>
    <a:srgbClr val="00B050"/>
    <a:srgbClr val="FFC000"/>
    <a:srgbClr val="ED7D31"/>
    <a:srgbClr val="0070C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434" autoAdjust="0"/>
    <p:restoredTop sz="96758" autoAdjust="0"/>
  </p:normalViewPr>
  <p:slideViewPr>
    <p:cSldViewPr snapToGrid="0">
      <p:cViewPr varScale="1">
        <p:scale>
          <a:sx n="111" d="100"/>
          <a:sy n="111" d="100"/>
        </p:scale>
        <p:origin x="37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52C005-EB7E-4D12-B01B-701B8ACB9EC4}" type="datetimeFigureOut">
              <a:rPr lang="ko-KR" altLang="en-US" smtClean="0"/>
              <a:t>2020-12-2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59919C-B1E1-453C-A686-076CB3AF29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461701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52C005-EB7E-4D12-B01B-701B8ACB9EC4}" type="datetimeFigureOut">
              <a:rPr lang="ko-KR" altLang="en-US" smtClean="0"/>
              <a:t>2020-12-2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59919C-B1E1-453C-A686-076CB3AF29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766155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52C005-EB7E-4D12-B01B-701B8ACB9EC4}" type="datetimeFigureOut">
              <a:rPr lang="ko-KR" altLang="en-US" smtClean="0"/>
              <a:t>2020-12-2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59919C-B1E1-453C-A686-076CB3AF29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681902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52C005-EB7E-4D12-B01B-701B8ACB9EC4}" type="datetimeFigureOut">
              <a:rPr lang="ko-KR" altLang="en-US" smtClean="0"/>
              <a:t>2020-12-2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59919C-B1E1-453C-A686-076CB3AF29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292846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52C005-EB7E-4D12-B01B-701B8ACB9EC4}" type="datetimeFigureOut">
              <a:rPr lang="ko-KR" altLang="en-US" smtClean="0"/>
              <a:t>2020-12-2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59919C-B1E1-453C-A686-076CB3AF29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997496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52C005-EB7E-4D12-B01B-701B8ACB9EC4}" type="datetimeFigureOut">
              <a:rPr lang="ko-KR" altLang="en-US" smtClean="0"/>
              <a:t>2020-12-2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59919C-B1E1-453C-A686-076CB3AF29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829441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52C005-EB7E-4D12-B01B-701B8ACB9EC4}" type="datetimeFigureOut">
              <a:rPr lang="ko-KR" altLang="en-US" smtClean="0"/>
              <a:t>2020-12-23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59919C-B1E1-453C-A686-076CB3AF29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617612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52C005-EB7E-4D12-B01B-701B8ACB9EC4}" type="datetimeFigureOut">
              <a:rPr lang="ko-KR" altLang="en-US" smtClean="0"/>
              <a:t>2020-12-23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59919C-B1E1-453C-A686-076CB3AF29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38436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52C005-EB7E-4D12-B01B-701B8ACB9EC4}" type="datetimeFigureOut">
              <a:rPr lang="ko-KR" altLang="en-US" smtClean="0"/>
              <a:t>2020-12-23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59919C-B1E1-453C-A686-076CB3AF29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718222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52C005-EB7E-4D12-B01B-701B8ACB9EC4}" type="datetimeFigureOut">
              <a:rPr lang="ko-KR" altLang="en-US" smtClean="0"/>
              <a:t>2020-12-2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59919C-B1E1-453C-A686-076CB3AF29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357687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52C005-EB7E-4D12-B01B-701B8ACB9EC4}" type="datetimeFigureOut">
              <a:rPr lang="ko-KR" altLang="en-US" smtClean="0"/>
              <a:t>2020-12-2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59919C-B1E1-453C-A686-076CB3AF29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554305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52C005-EB7E-4D12-B01B-701B8ACB9EC4}" type="datetimeFigureOut">
              <a:rPr lang="ko-KR" altLang="en-US" smtClean="0"/>
              <a:t>2020-12-2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59919C-B1E1-453C-A686-076CB3AF29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049289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0" y="0"/>
            <a:ext cx="12192000" cy="166199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0">
              <a:lnSpc>
                <a:spcPct val="170000"/>
              </a:lnSpc>
              <a:spcAft>
                <a:spcPts val="0"/>
              </a:spcAft>
            </a:pPr>
            <a:r>
              <a:rPr lang="en-US" altLang="ko-KR" sz="1200" b="1" kern="100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Supplementary Figure S1. </a:t>
            </a:r>
            <a:r>
              <a:rPr lang="en-US" altLang="ko-KR" sz="1200" kern="100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Unique genomic regions of </a:t>
            </a:r>
            <a:r>
              <a:rPr lang="en-US" altLang="ko-KR" sz="1200" i="1" kern="100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V. </a:t>
            </a:r>
            <a:r>
              <a:rPr lang="en-US" altLang="ko-KR" sz="1200" i="1" kern="100" dirty="0" err="1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vulnificus</a:t>
            </a:r>
            <a:r>
              <a:rPr lang="en-US" altLang="ko-KR" sz="1200" kern="100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 FORC_016. The unique genomic region of </a:t>
            </a:r>
            <a:r>
              <a:rPr lang="en-US" altLang="ko-KR" sz="1200" i="1" kern="100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V. </a:t>
            </a:r>
            <a:r>
              <a:rPr lang="en-US" altLang="ko-KR" sz="1200" i="1" kern="100" dirty="0" err="1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vulnificus</a:t>
            </a:r>
            <a:r>
              <a:rPr lang="en-US" altLang="ko-KR" sz="1200" i="1" kern="100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 </a:t>
            </a:r>
            <a:r>
              <a:rPr lang="en-US" altLang="ko-KR" sz="1200" kern="100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FORC_016 was compared with similar region of </a:t>
            </a:r>
            <a:r>
              <a:rPr lang="en-US" altLang="ko-KR" sz="1200" i="1" kern="100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V. </a:t>
            </a:r>
            <a:r>
              <a:rPr lang="en-US" altLang="ko-KR" sz="1200" i="1" kern="100" dirty="0" err="1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vulnificus</a:t>
            </a:r>
            <a:r>
              <a:rPr lang="en-US" altLang="ko-KR" sz="1200" i="1" kern="100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 </a:t>
            </a:r>
            <a:r>
              <a:rPr lang="en-US" altLang="ko-KR" sz="1200" kern="100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MO6-24/O. The arrows represent the coding regions of (A) CPS gene cluster, (B) </a:t>
            </a:r>
            <a:r>
              <a:rPr lang="en-US" altLang="ko-KR" sz="1200" kern="100" dirty="0" err="1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enterobactin</a:t>
            </a:r>
            <a:r>
              <a:rPr lang="en-US" altLang="ko-KR" sz="1200" kern="100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 receptor, and (C) </a:t>
            </a:r>
            <a:r>
              <a:rPr lang="en-US" altLang="ko-KR" sz="1200" kern="100" dirty="0" err="1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heme</a:t>
            </a:r>
            <a:r>
              <a:rPr lang="en-US" altLang="ko-KR" sz="1200" kern="100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 receptor in </a:t>
            </a:r>
            <a:r>
              <a:rPr lang="en-US" altLang="ko-KR" sz="1200" i="1" kern="100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V. </a:t>
            </a:r>
            <a:r>
              <a:rPr lang="en-US" altLang="ko-KR" sz="1200" i="1" kern="100" dirty="0" err="1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vulnificus</a:t>
            </a:r>
            <a:r>
              <a:rPr lang="en-US" altLang="ko-KR" sz="1200" i="1" kern="100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 </a:t>
            </a:r>
            <a:r>
              <a:rPr lang="en-US" altLang="ko-KR" sz="1200" kern="100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FORC_016. The middle line indicates amino acid sequence homology of each gene pair. The unique genes in </a:t>
            </a:r>
            <a:r>
              <a:rPr lang="en-US" altLang="ko-KR" sz="1200" i="1" kern="100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V. </a:t>
            </a:r>
            <a:r>
              <a:rPr lang="en-US" altLang="ko-KR" sz="1200" i="1" kern="100" dirty="0" err="1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vulnificus</a:t>
            </a:r>
            <a:r>
              <a:rPr lang="en-US" altLang="ko-KR" sz="1200" i="1" kern="100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 </a:t>
            </a:r>
            <a:r>
              <a:rPr lang="en-US" altLang="ko-KR" sz="1200" kern="100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FORC_016 was highlighted with orange color. The figure was derived using the nucleotide sequences of the </a:t>
            </a:r>
            <a:r>
              <a:rPr lang="en-US" altLang="ko-KR" sz="1200" i="1" kern="100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V. vulnificus</a:t>
            </a:r>
            <a:r>
              <a:rPr lang="en-US" altLang="ko-KR" sz="1200" kern="100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 FORC_016 (CP011775, CP011776), and </a:t>
            </a:r>
            <a:r>
              <a:rPr lang="en-US" altLang="ko-KR" sz="1200" i="1" kern="100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V. vulnificus</a:t>
            </a:r>
            <a:r>
              <a:rPr lang="en-US" altLang="ko-KR" sz="1200" kern="100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 MO6-24/O (CP002469 and CP002470).</a:t>
            </a:r>
            <a:endParaRPr lang="ko-KR" altLang="ko-KR" sz="1200" kern="100" dirty="0">
              <a:latin typeface="Times New Roman" panose="02020603050405020304" pitchFamily="18" charset="0"/>
              <a:ea typeface="HY신명조" panose="02030600000101010101" pitchFamily="18" charset="-127"/>
              <a:cs typeface="Times New Roman" panose="02020603050405020304" pitchFamily="18" charset="0"/>
            </a:endParaRPr>
          </a:p>
          <a:p>
            <a:pPr algn="just" latinLnBrk="0">
              <a:lnSpc>
                <a:spcPct val="170000"/>
              </a:lnSpc>
              <a:spcAft>
                <a:spcPts val="0"/>
              </a:spcAft>
            </a:pPr>
            <a:r>
              <a:rPr lang="en-US" altLang="ko-KR" sz="1200" kern="100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 </a:t>
            </a:r>
            <a:endParaRPr lang="ko-KR" altLang="ko-KR" sz="1200" kern="100" dirty="0">
              <a:effectLst/>
              <a:latin typeface="Times New Roman" panose="02020603050405020304" pitchFamily="18" charset="0"/>
              <a:ea typeface="HY신명조" panose="02030600000101010101" pitchFamily="18" charset="-127"/>
              <a:cs typeface="Times New Roman" panose="02020603050405020304" pitchFamily="18" charset="0"/>
            </a:endParaRPr>
          </a:p>
        </p:txBody>
      </p:sp>
      <p:grpSp>
        <p:nvGrpSpPr>
          <p:cNvPr id="3" name="그룹 2"/>
          <p:cNvGrpSpPr/>
          <p:nvPr/>
        </p:nvGrpSpPr>
        <p:grpSpPr>
          <a:xfrm>
            <a:off x="128088" y="1654918"/>
            <a:ext cx="5826260" cy="2824985"/>
            <a:chOff x="128088" y="1654918"/>
            <a:chExt cx="5826260" cy="2824985"/>
          </a:xfrm>
        </p:grpSpPr>
        <p:grpSp>
          <p:nvGrpSpPr>
            <p:cNvPr id="104" name="그룹 103"/>
            <p:cNvGrpSpPr/>
            <p:nvPr/>
          </p:nvGrpSpPr>
          <p:grpSpPr>
            <a:xfrm>
              <a:off x="128088" y="1738577"/>
              <a:ext cx="5826260" cy="2741326"/>
              <a:chOff x="96440" y="3429149"/>
              <a:chExt cx="4313266" cy="2029444"/>
            </a:xfrm>
          </p:grpSpPr>
          <p:grpSp>
            <p:nvGrpSpPr>
              <p:cNvPr id="105" name="그룹 104"/>
              <p:cNvGrpSpPr/>
              <p:nvPr/>
            </p:nvGrpSpPr>
            <p:grpSpPr>
              <a:xfrm>
                <a:off x="96440" y="3429149"/>
                <a:ext cx="4313266" cy="1650965"/>
                <a:chOff x="439679" y="2480900"/>
                <a:chExt cx="5401132" cy="1956012"/>
              </a:xfrm>
            </p:grpSpPr>
            <p:sp>
              <p:nvSpPr>
                <p:cNvPr id="116" name="직사각형 121"/>
                <p:cNvSpPr/>
                <p:nvPr/>
              </p:nvSpPr>
              <p:spPr>
                <a:xfrm>
                  <a:off x="5204127" y="2982062"/>
                  <a:ext cx="530071" cy="934306"/>
                </a:xfrm>
                <a:custGeom>
                  <a:avLst/>
                  <a:gdLst>
                    <a:gd name="connsiteX0" fmla="*/ 0 w 620327"/>
                    <a:gd name="connsiteY0" fmla="*/ 0 h 1275293"/>
                    <a:gd name="connsiteX1" fmla="*/ 620327 w 620327"/>
                    <a:gd name="connsiteY1" fmla="*/ 0 h 1275293"/>
                    <a:gd name="connsiteX2" fmla="*/ 620327 w 620327"/>
                    <a:gd name="connsiteY2" fmla="*/ 1275293 h 1275293"/>
                    <a:gd name="connsiteX3" fmla="*/ 0 w 620327"/>
                    <a:gd name="connsiteY3" fmla="*/ 1275293 h 1275293"/>
                    <a:gd name="connsiteX4" fmla="*/ 0 w 620327"/>
                    <a:gd name="connsiteY4" fmla="*/ 0 h 1275293"/>
                    <a:gd name="connsiteX0" fmla="*/ 0 w 1435667"/>
                    <a:gd name="connsiteY0" fmla="*/ 0 h 1275293"/>
                    <a:gd name="connsiteX1" fmla="*/ 620327 w 1435667"/>
                    <a:gd name="connsiteY1" fmla="*/ 0 h 1275293"/>
                    <a:gd name="connsiteX2" fmla="*/ 1435667 w 1435667"/>
                    <a:gd name="connsiteY2" fmla="*/ 1275293 h 1275293"/>
                    <a:gd name="connsiteX3" fmla="*/ 0 w 1435667"/>
                    <a:gd name="connsiteY3" fmla="*/ 1275293 h 1275293"/>
                    <a:gd name="connsiteX4" fmla="*/ 0 w 1435667"/>
                    <a:gd name="connsiteY4" fmla="*/ 0 h 1275293"/>
                    <a:gd name="connsiteX0" fmla="*/ 0 w 1435667"/>
                    <a:gd name="connsiteY0" fmla="*/ 0 h 1275293"/>
                    <a:gd name="connsiteX1" fmla="*/ 620327 w 1435667"/>
                    <a:gd name="connsiteY1" fmla="*/ 0 h 1275293"/>
                    <a:gd name="connsiteX2" fmla="*/ 1435667 w 1435667"/>
                    <a:gd name="connsiteY2" fmla="*/ 1275293 h 1275293"/>
                    <a:gd name="connsiteX3" fmla="*/ 845820 w 1435667"/>
                    <a:gd name="connsiteY3" fmla="*/ 1275293 h 1275293"/>
                    <a:gd name="connsiteX4" fmla="*/ 0 w 1435667"/>
                    <a:gd name="connsiteY4" fmla="*/ 0 h 1275293"/>
                    <a:gd name="connsiteX0" fmla="*/ 0 w 1435667"/>
                    <a:gd name="connsiteY0" fmla="*/ 0 h 1275293"/>
                    <a:gd name="connsiteX1" fmla="*/ 1053464 w 1435667"/>
                    <a:gd name="connsiteY1" fmla="*/ 0 h 1275293"/>
                    <a:gd name="connsiteX2" fmla="*/ 1435667 w 1435667"/>
                    <a:gd name="connsiteY2" fmla="*/ 1275293 h 1275293"/>
                    <a:gd name="connsiteX3" fmla="*/ 845820 w 1435667"/>
                    <a:gd name="connsiteY3" fmla="*/ 1275293 h 1275293"/>
                    <a:gd name="connsiteX4" fmla="*/ 0 w 1435667"/>
                    <a:gd name="connsiteY4" fmla="*/ 0 h 1275293"/>
                    <a:gd name="connsiteX0" fmla="*/ 0 w 838901"/>
                    <a:gd name="connsiteY0" fmla="*/ 9626 h 1275293"/>
                    <a:gd name="connsiteX1" fmla="*/ 456698 w 838901"/>
                    <a:gd name="connsiteY1" fmla="*/ 0 h 1275293"/>
                    <a:gd name="connsiteX2" fmla="*/ 838901 w 838901"/>
                    <a:gd name="connsiteY2" fmla="*/ 1275293 h 1275293"/>
                    <a:gd name="connsiteX3" fmla="*/ 249054 w 838901"/>
                    <a:gd name="connsiteY3" fmla="*/ 1275293 h 1275293"/>
                    <a:gd name="connsiteX4" fmla="*/ 0 w 838901"/>
                    <a:gd name="connsiteY4" fmla="*/ 9626 h 1275293"/>
                    <a:gd name="connsiteX0" fmla="*/ 0 w 838901"/>
                    <a:gd name="connsiteY0" fmla="*/ 9626 h 1275293"/>
                    <a:gd name="connsiteX1" fmla="*/ 456698 w 838901"/>
                    <a:gd name="connsiteY1" fmla="*/ 0 h 1275293"/>
                    <a:gd name="connsiteX2" fmla="*/ 838901 w 838901"/>
                    <a:gd name="connsiteY2" fmla="*/ 1275293 h 1275293"/>
                    <a:gd name="connsiteX3" fmla="*/ 374182 w 838901"/>
                    <a:gd name="connsiteY3" fmla="*/ 1265668 h 1275293"/>
                    <a:gd name="connsiteX4" fmla="*/ 0 w 838901"/>
                    <a:gd name="connsiteY4" fmla="*/ 9626 h 1275293"/>
                    <a:gd name="connsiteX0" fmla="*/ 0 w 838901"/>
                    <a:gd name="connsiteY0" fmla="*/ 9626 h 1275293"/>
                    <a:gd name="connsiteX1" fmla="*/ 456698 w 838901"/>
                    <a:gd name="connsiteY1" fmla="*/ 0 h 1275293"/>
                    <a:gd name="connsiteX2" fmla="*/ 838901 w 838901"/>
                    <a:gd name="connsiteY2" fmla="*/ 1275293 h 1275293"/>
                    <a:gd name="connsiteX3" fmla="*/ 441559 w 838901"/>
                    <a:gd name="connsiteY3" fmla="*/ 1256043 h 1275293"/>
                    <a:gd name="connsiteX4" fmla="*/ 0 w 838901"/>
                    <a:gd name="connsiteY4" fmla="*/ 9626 h 1275293"/>
                    <a:gd name="connsiteX0" fmla="*/ 0 w 800399"/>
                    <a:gd name="connsiteY0" fmla="*/ 9626 h 1275293"/>
                    <a:gd name="connsiteX1" fmla="*/ 418196 w 800399"/>
                    <a:gd name="connsiteY1" fmla="*/ 0 h 1275293"/>
                    <a:gd name="connsiteX2" fmla="*/ 800399 w 800399"/>
                    <a:gd name="connsiteY2" fmla="*/ 1275293 h 1275293"/>
                    <a:gd name="connsiteX3" fmla="*/ 403057 w 800399"/>
                    <a:gd name="connsiteY3" fmla="*/ 1256043 h 1275293"/>
                    <a:gd name="connsiteX4" fmla="*/ 0 w 800399"/>
                    <a:gd name="connsiteY4" fmla="*/ 9626 h 1275293"/>
                    <a:gd name="connsiteX0" fmla="*/ 0 w 800399"/>
                    <a:gd name="connsiteY0" fmla="*/ 9626 h 1275293"/>
                    <a:gd name="connsiteX1" fmla="*/ 601076 w 800399"/>
                    <a:gd name="connsiteY1" fmla="*/ 0 h 1275293"/>
                    <a:gd name="connsiteX2" fmla="*/ 800399 w 800399"/>
                    <a:gd name="connsiteY2" fmla="*/ 1275293 h 1275293"/>
                    <a:gd name="connsiteX3" fmla="*/ 403057 w 800399"/>
                    <a:gd name="connsiteY3" fmla="*/ 1256043 h 1275293"/>
                    <a:gd name="connsiteX4" fmla="*/ 0 w 800399"/>
                    <a:gd name="connsiteY4" fmla="*/ 9626 h 1275293"/>
                    <a:gd name="connsiteX0" fmla="*/ 0 w 684896"/>
                    <a:gd name="connsiteY0" fmla="*/ 9626 h 1275293"/>
                    <a:gd name="connsiteX1" fmla="*/ 485573 w 684896"/>
                    <a:gd name="connsiteY1" fmla="*/ 0 h 1275293"/>
                    <a:gd name="connsiteX2" fmla="*/ 684896 w 684896"/>
                    <a:gd name="connsiteY2" fmla="*/ 1275293 h 1275293"/>
                    <a:gd name="connsiteX3" fmla="*/ 287554 w 684896"/>
                    <a:gd name="connsiteY3" fmla="*/ 1256043 h 1275293"/>
                    <a:gd name="connsiteX4" fmla="*/ 0 w 684896"/>
                    <a:gd name="connsiteY4" fmla="*/ 9626 h 1275293"/>
                    <a:gd name="connsiteX0" fmla="*/ 0 w 684896"/>
                    <a:gd name="connsiteY0" fmla="*/ 9626 h 1275294"/>
                    <a:gd name="connsiteX1" fmla="*/ 485573 w 684896"/>
                    <a:gd name="connsiteY1" fmla="*/ 0 h 1275294"/>
                    <a:gd name="connsiteX2" fmla="*/ 684896 w 684896"/>
                    <a:gd name="connsiteY2" fmla="*/ 1275293 h 1275294"/>
                    <a:gd name="connsiteX3" fmla="*/ 172050 w 684896"/>
                    <a:gd name="connsiteY3" fmla="*/ 1275294 h 1275294"/>
                    <a:gd name="connsiteX4" fmla="*/ 0 w 684896"/>
                    <a:gd name="connsiteY4" fmla="*/ 9626 h 1275294"/>
                    <a:gd name="connsiteX0" fmla="*/ 0 w 684896"/>
                    <a:gd name="connsiteY0" fmla="*/ 9626 h 1275294"/>
                    <a:gd name="connsiteX1" fmla="*/ 485573 w 684896"/>
                    <a:gd name="connsiteY1" fmla="*/ 0 h 1275294"/>
                    <a:gd name="connsiteX2" fmla="*/ 684896 w 684896"/>
                    <a:gd name="connsiteY2" fmla="*/ 1275293 h 1275294"/>
                    <a:gd name="connsiteX3" fmla="*/ 200926 w 684896"/>
                    <a:gd name="connsiteY3" fmla="*/ 1275294 h 1275294"/>
                    <a:gd name="connsiteX4" fmla="*/ 0 w 684896"/>
                    <a:gd name="connsiteY4" fmla="*/ 9626 h 1275294"/>
                    <a:gd name="connsiteX0" fmla="*/ 0 w 684896"/>
                    <a:gd name="connsiteY0" fmla="*/ 0 h 1265668"/>
                    <a:gd name="connsiteX1" fmla="*/ 341194 w 684896"/>
                    <a:gd name="connsiteY1" fmla="*/ 9624 h 1265668"/>
                    <a:gd name="connsiteX2" fmla="*/ 684896 w 684896"/>
                    <a:gd name="connsiteY2" fmla="*/ 1265667 h 1265668"/>
                    <a:gd name="connsiteX3" fmla="*/ 200926 w 684896"/>
                    <a:gd name="connsiteY3" fmla="*/ 1265668 h 1265668"/>
                    <a:gd name="connsiteX4" fmla="*/ 0 w 684896"/>
                    <a:gd name="connsiteY4" fmla="*/ 0 h 1265668"/>
                    <a:gd name="connsiteX0" fmla="*/ 0 w 800399"/>
                    <a:gd name="connsiteY0" fmla="*/ 0 h 1265668"/>
                    <a:gd name="connsiteX1" fmla="*/ 341194 w 800399"/>
                    <a:gd name="connsiteY1" fmla="*/ 9624 h 1265668"/>
                    <a:gd name="connsiteX2" fmla="*/ 800399 w 800399"/>
                    <a:gd name="connsiteY2" fmla="*/ 1265667 h 1265668"/>
                    <a:gd name="connsiteX3" fmla="*/ 200926 w 800399"/>
                    <a:gd name="connsiteY3" fmla="*/ 1265668 h 1265668"/>
                    <a:gd name="connsiteX4" fmla="*/ 0 w 800399"/>
                    <a:gd name="connsiteY4" fmla="*/ 0 h 1265668"/>
                    <a:gd name="connsiteX0" fmla="*/ 0 w 800399"/>
                    <a:gd name="connsiteY0" fmla="*/ 0 h 1275293"/>
                    <a:gd name="connsiteX1" fmla="*/ 341194 w 800399"/>
                    <a:gd name="connsiteY1" fmla="*/ 9624 h 1275293"/>
                    <a:gd name="connsiteX2" fmla="*/ 800399 w 800399"/>
                    <a:gd name="connsiteY2" fmla="*/ 1265667 h 1275293"/>
                    <a:gd name="connsiteX3" fmla="*/ 460808 w 800399"/>
                    <a:gd name="connsiteY3" fmla="*/ 1275293 h 1275293"/>
                    <a:gd name="connsiteX4" fmla="*/ 0 w 800399"/>
                    <a:gd name="connsiteY4" fmla="*/ 0 h 1275293"/>
                    <a:gd name="connsiteX0" fmla="*/ 0 w 781148"/>
                    <a:gd name="connsiteY0" fmla="*/ 9626 h 1265669"/>
                    <a:gd name="connsiteX1" fmla="*/ 321943 w 781148"/>
                    <a:gd name="connsiteY1" fmla="*/ 0 h 1265669"/>
                    <a:gd name="connsiteX2" fmla="*/ 781148 w 781148"/>
                    <a:gd name="connsiteY2" fmla="*/ 1256043 h 1265669"/>
                    <a:gd name="connsiteX3" fmla="*/ 441557 w 781148"/>
                    <a:gd name="connsiteY3" fmla="*/ 1265669 h 1265669"/>
                    <a:gd name="connsiteX4" fmla="*/ 0 w 781148"/>
                    <a:gd name="connsiteY4" fmla="*/ 9626 h 1265669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1148" h="1265669">
                      <a:moveTo>
                        <a:pt x="0" y="9626"/>
                      </a:moveTo>
                      <a:lnTo>
                        <a:pt x="321943" y="0"/>
                      </a:lnTo>
                      <a:lnTo>
                        <a:pt x="781148" y="1256043"/>
                      </a:lnTo>
                      <a:lnTo>
                        <a:pt x="441557" y="1265669"/>
                      </a:lnTo>
                      <a:lnTo>
                        <a:pt x="0" y="9626"/>
                      </a:lnTo>
                      <a:close/>
                    </a:path>
                  </a:pathLst>
                </a:custGeom>
                <a:solidFill>
                  <a:srgbClr val="E7E6E6"/>
                </a:solidFill>
                <a:ln w="1270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ko-KR" altLang="en-US" sz="1200" b="0" i="0" u="none" strike="noStrike" kern="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7" name="직사각형 121"/>
                <p:cNvSpPr/>
                <p:nvPr/>
              </p:nvSpPr>
              <p:spPr>
                <a:xfrm flipH="1">
                  <a:off x="1881648" y="2982135"/>
                  <a:ext cx="464757" cy="941411"/>
                </a:xfrm>
                <a:custGeom>
                  <a:avLst/>
                  <a:gdLst>
                    <a:gd name="connsiteX0" fmla="*/ 0 w 620327"/>
                    <a:gd name="connsiteY0" fmla="*/ 0 h 1275293"/>
                    <a:gd name="connsiteX1" fmla="*/ 620327 w 620327"/>
                    <a:gd name="connsiteY1" fmla="*/ 0 h 1275293"/>
                    <a:gd name="connsiteX2" fmla="*/ 620327 w 620327"/>
                    <a:gd name="connsiteY2" fmla="*/ 1275293 h 1275293"/>
                    <a:gd name="connsiteX3" fmla="*/ 0 w 620327"/>
                    <a:gd name="connsiteY3" fmla="*/ 1275293 h 1275293"/>
                    <a:gd name="connsiteX4" fmla="*/ 0 w 620327"/>
                    <a:gd name="connsiteY4" fmla="*/ 0 h 1275293"/>
                    <a:gd name="connsiteX0" fmla="*/ 0 w 1435667"/>
                    <a:gd name="connsiteY0" fmla="*/ 0 h 1275293"/>
                    <a:gd name="connsiteX1" fmla="*/ 620327 w 1435667"/>
                    <a:gd name="connsiteY1" fmla="*/ 0 h 1275293"/>
                    <a:gd name="connsiteX2" fmla="*/ 1435667 w 1435667"/>
                    <a:gd name="connsiteY2" fmla="*/ 1275293 h 1275293"/>
                    <a:gd name="connsiteX3" fmla="*/ 0 w 1435667"/>
                    <a:gd name="connsiteY3" fmla="*/ 1275293 h 1275293"/>
                    <a:gd name="connsiteX4" fmla="*/ 0 w 1435667"/>
                    <a:gd name="connsiteY4" fmla="*/ 0 h 1275293"/>
                    <a:gd name="connsiteX0" fmla="*/ 0 w 1435667"/>
                    <a:gd name="connsiteY0" fmla="*/ 0 h 1275293"/>
                    <a:gd name="connsiteX1" fmla="*/ 620327 w 1435667"/>
                    <a:gd name="connsiteY1" fmla="*/ 0 h 1275293"/>
                    <a:gd name="connsiteX2" fmla="*/ 1435667 w 1435667"/>
                    <a:gd name="connsiteY2" fmla="*/ 1275293 h 1275293"/>
                    <a:gd name="connsiteX3" fmla="*/ 845820 w 1435667"/>
                    <a:gd name="connsiteY3" fmla="*/ 1275293 h 1275293"/>
                    <a:gd name="connsiteX4" fmla="*/ 0 w 1435667"/>
                    <a:gd name="connsiteY4" fmla="*/ 0 h 1275293"/>
                    <a:gd name="connsiteX0" fmla="*/ 0 w 1435667"/>
                    <a:gd name="connsiteY0" fmla="*/ 0 h 1275293"/>
                    <a:gd name="connsiteX1" fmla="*/ 1053464 w 1435667"/>
                    <a:gd name="connsiteY1" fmla="*/ 0 h 1275293"/>
                    <a:gd name="connsiteX2" fmla="*/ 1435667 w 1435667"/>
                    <a:gd name="connsiteY2" fmla="*/ 1275293 h 1275293"/>
                    <a:gd name="connsiteX3" fmla="*/ 845820 w 1435667"/>
                    <a:gd name="connsiteY3" fmla="*/ 1275293 h 1275293"/>
                    <a:gd name="connsiteX4" fmla="*/ 0 w 1435667"/>
                    <a:gd name="connsiteY4" fmla="*/ 0 h 1275293"/>
                    <a:gd name="connsiteX0" fmla="*/ 0 w 838901"/>
                    <a:gd name="connsiteY0" fmla="*/ 9626 h 1275293"/>
                    <a:gd name="connsiteX1" fmla="*/ 456698 w 838901"/>
                    <a:gd name="connsiteY1" fmla="*/ 0 h 1275293"/>
                    <a:gd name="connsiteX2" fmla="*/ 838901 w 838901"/>
                    <a:gd name="connsiteY2" fmla="*/ 1275293 h 1275293"/>
                    <a:gd name="connsiteX3" fmla="*/ 249054 w 838901"/>
                    <a:gd name="connsiteY3" fmla="*/ 1275293 h 1275293"/>
                    <a:gd name="connsiteX4" fmla="*/ 0 w 838901"/>
                    <a:gd name="connsiteY4" fmla="*/ 9626 h 1275293"/>
                    <a:gd name="connsiteX0" fmla="*/ 0 w 838901"/>
                    <a:gd name="connsiteY0" fmla="*/ 9626 h 1275293"/>
                    <a:gd name="connsiteX1" fmla="*/ 456698 w 838901"/>
                    <a:gd name="connsiteY1" fmla="*/ 0 h 1275293"/>
                    <a:gd name="connsiteX2" fmla="*/ 838901 w 838901"/>
                    <a:gd name="connsiteY2" fmla="*/ 1275293 h 1275293"/>
                    <a:gd name="connsiteX3" fmla="*/ 374182 w 838901"/>
                    <a:gd name="connsiteY3" fmla="*/ 1265668 h 1275293"/>
                    <a:gd name="connsiteX4" fmla="*/ 0 w 838901"/>
                    <a:gd name="connsiteY4" fmla="*/ 9626 h 1275293"/>
                    <a:gd name="connsiteX0" fmla="*/ 0 w 838901"/>
                    <a:gd name="connsiteY0" fmla="*/ 9626 h 1275293"/>
                    <a:gd name="connsiteX1" fmla="*/ 456698 w 838901"/>
                    <a:gd name="connsiteY1" fmla="*/ 0 h 1275293"/>
                    <a:gd name="connsiteX2" fmla="*/ 838901 w 838901"/>
                    <a:gd name="connsiteY2" fmla="*/ 1275293 h 1275293"/>
                    <a:gd name="connsiteX3" fmla="*/ 441559 w 838901"/>
                    <a:gd name="connsiteY3" fmla="*/ 1256043 h 1275293"/>
                    <a:gd name="connsiteX4" fmla="*/ 0 w 838901"/>
                    <a:gd name="connsiteY4" fmla="*/ 9626 h 1275293"/>
                    <a:gd name="connsiteX0" fmla="*/ 0 w 800399"/>
                    <a:gd name="connsiteY0" fmla="*/ 9626 h 1275293"/>
                    <a:gd name="connsiteX1" fmla="*/ 418196 w 800399"/>
                    <a:gd name="connsiteY1" fmla="*/ 0 h 1275293"/>
                    <a:gd name="connsiteX2" fmla="*/ 800399 w 800399"/>
                    <a:gd name="connsiteY2" fmla="*/ 1275293 h 1275293"/>
                    <a:gd name="connsiteX3" fmla="*/ 403057 w 800399"/>
                    <a:gd name="connsiteY3" fmla="*/ 1256043 h 1275293"/>
                    <a:gd name="connsiteX4" fmla="*/ 0 w 800399"/>
                    <a:gd name="connsiteY4" fmla="*/ 9626 h 1275293"/>
                    <a:gd name="connsiteX0" fmla="*/ 0 w 800399"/>
                    <a:gd name="connsiteY0" fmla="*/ 9626 h 1275293"/>
                    <a:gd name="connsiteX1" fmla="*/ 601076 w 800399"/>
                    <a:gd name="connsiteY1" fmla="*/ 0 h 1275293"/>
                    <a:gd name="connsiteX2" fmla="*/ 800399 w 800399"/>
                    <a:gd name="connsiteY2" fmla="*/ 1275293 h 1275293"/>
                    <a:gd name="connsiteX3" fmla="*/ 403057 w 800399"/>
                    <a:gd name="connsiteY3" fmla="*/ 1256043 h 1275293"/>
                    <a:gd name="connsiteX4" fmla="*/ 0 w 800399"/>
                    <a:gd name="connsiteY4" fmla="*/ 9626 h 1275293"/>
                    <a:gd name="connsiteX0" fmla="*/ 0 w 684896"/>
                    <a:gd name="connsiteY0" fmla="*/ 9626 h 1275293"/>
                    <a:gd name="connsiteX1" fmla="*/ 485573 w 684896"/>
                    <a:gd name="connsiteY1" fmla="*/ 0 h 1275293"/>
                    <a:gd name="connsiteX2" fmla="*/ 684896 w 684896"/>
                    <a:gd name="connsiteY2" fmla="*/ 1275293 h 1275293"/>
                    <a:gd name="connsiteX3" fmla="*/ 287554 w 684896"/>
                    <a:gd name="connsiteY3" fmla="*/ 1256043 h 1275293"/>
                    <a:gd name="connsiteX4" fmla="*/ 0 w 684896"/>
                    <a:gd name="connsiteY4" fmla="*/ 9626 h 1275293"/>
                    <a:gd name="connsiteX0" fmla="*/ 0 w 684896"/>
                    <a:gd name="connsiteY0" fmla="*/ 9626 h 1275294"/>
                    <a:gd name="connsiteX1" fmla="*/ 485573 w 684896"/>
                    <a:gd name="connsiteY1" fmla="*/ 0 h 1275294"/>
                    <a:gd name="connsiteX2" fmla="*/ 684896 w 684896"/>
                    <a:gd name="connsiteY2" fmla="*/ 1275293 h 1275294"/>
                    <a:gd name="connsiteX3" fmla="*/ 172050 w 684896"/>
                    <a:gd name="connsiteY3" fmla="*/ 1275294 h 1275294"/>
                    <a:gd name="connsiteX4" fmla="*/ 0 w 684896"/>
                    <a:gd name="connsiteY4" fmla="*/ 9626 h 1275294"/>
                    <a:gd name="connsiteX0" fmla="*/ 0 w 684896"/>
                    <a:gd name="connsiteY0" fmla="*/ 9626 h 1275294"/>
                    <a:gd name="connsiteX1" fmla="*/ 485573 w 684896"/>
                    <a:gd name="connsiteY1" fmla="*/ 0 h 1275294"/>
                    <a:gd name="connsiteX2" fmla="*/ 684896 w 684896"/>
                    <a:gd name="connsiteY2" fmla="*/ 1275293 h 1275294"/>
                    <a:gd name="connsiteX3" fmla="*/ 200926 w 684896"/>
                    <a:gd name="connsiteY3" fmla="*/ 1275294 h 1275294"/>
                    <a:gd name="connsiteX4" fmla="*/ 0 w 684896"/>
                    <a:gd name="connsiteY4" fmla="*/ 9626 h 127529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684896" h="1275294">
                      <a:moveTo>
                        <a:pt x="0" y="9626"/>
                      </a:moveTo>
                      <a:lnTo>
                        <a:pt x="485573" y="0"/>
                      </a:lnTo>
                      <a:lnTo>
                        <a:pt x="684896" y="1275293"/>
                      </a:lnTo>
                      <a:lnTo>
                        <a:pt x="200926" y="1275294"/>
                      </a:lnTo>
                      <a:lnTo>
                        <a:pt x="0" y="9626"/>
                      </a:lnTo>
                      <a:close/>
                    </a:path>
                  </a:pathLst>
                </a:custGeom>
                <a:solidFill>
                  <a:srgbClr val="E7E6E6"/>
                </a:solidFill>
                <a:ln w="1270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ko-KR" altLang="en-US" sz="1200" b="0" i="0" u="none" strike="noStrike" kern="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8" name="직사각형 121"/>
                <p:cNvSpPr/>
                <p:nvPr/>
              </p:nvSpPr>
              <p:spPr>
                <a:xfrm flipH="1">
                  <a:off x="1703978" y="2982135"/>
                  <a:ext cx="301469" cy="941411"/>
                </a:xfrm>
                <a:custGeom>
                  <a:avLst/>
                  <a:gdLst>
                    <a:gd name="connsiteX0" fmla="*/ 0 w 620327"/>
                    <a:gd name="connsiteY0" fmla="*/ 0 h 1275293"/>
                    <a:gd name="connsiteX1" fmla="*/ 620327 w 620327"/>
                    <a:gd name="connsiteY1" fmla="*/ 0 h 1275293"/>
                    <a:gd name="connsiteX2" fmla="*/ 620327 w 620327"/>
                    <a:gd name="connsiteY2" fmla="*/ 1275293 h 1275293"/>
                    <a:gd name="connsiteX3" fmla="*/ 0 w 620327"/>
                    <a:gd name="connsiteY3" fmla="*/ 1275293 h 1275293"/>
                    <a:gd name="connsiteX4" fmla="*/ 0 w 620327"/>
                    <a:gd name="connsiteY4" fmla="*/ 0 h 1275293"/>
                    <a:gd name="connsiteX0" fmla="*/ 0 w 1435667"/>
                    <a:gd name="connsiteY0" fmla="*/ 0 h 1275293"/>
                    <a:gd name="connsiteX1" fmla="*/ 620327 w 1435667"/>
                    <a:gd name="connsiteY1" fmla="*/ 0 h 1275293"/>
                    <a:gd name="connsiteX2" fmla="*/ 1435667 w 1435667"/>
                    <a:gd name="connsiteY2" fmla="*/ 1275293 h 1275293"/>
                    <a:gd name="connsiteX3" fmla="*/ 0 w 1435667"/>
                    <a:gd name="connsiteY3" fmla="*/ 1275293 h 1275293"/>
                    <a:gd name="connsiteX4" fmla="*/ 0 w 1435667"/>
                    <a:gd name="connsiteY4" fmla="*/ 0 h 1275293"/>
                    <a:gd name="connsiteX0" fmla="*/ 0 w 1435667"/>
                    <a:gd name="connsiteY0" fmla="*/ 0 h 1275293"/>
                    <a:gd name="connsiteX1" fmla="*/ 620327 w 1435667"/>
                    <a:gd name="connsiteY1" fmla="*/ 0 h 1275293"/>
                    <a:gd name="connsiteX2" fmla="*/ 1435667 w 1435667"/>
                    <a:gd name="connsiteY2" fmla="*/ 1275293 h 1275293"/>
                    <a:gd name="connsiteX3" fmla="*/ 845820 w 1435667"/>
                    <a:gd name="connsiteY3" fmla="*/ 1275293 h 1275293"/>
                    <a:gd name="connsiteX4" fmla="*/ 0 w 1435667"/>
                    <a:gd name="connsiteY4" fmla="*/ 0 h 1275293"/>
                    <a:gd name="connsiteX0" fmla="*/ 0 w 1435667"/>
                    <a:gd name="connsiteY0" fmla="*/ 0 h 1275293"/>
                    <a:gd name="connsiteX1" fmla="*/ 1053464 w 1435667"/>
                    <a:gd name="connsiteY1" fmla="*/ 0 h 1275293"/>
                    <a:gd name="connsiteX2" fmla="*/ 1435667 w 1435667"/>
                    <a:gd name="connsiteY2" fmla="*/ 1275293 h 1275293"/>
                    <a:gd name="connsiteX3" fmla="*/ 845820 w 1435667"/>
                    <a:gd name="connsiteY3" fmla="*/ 1275293 h 1275293"/>
                    <a:gd name="connsiteX4" fmla="*/ 0 w 1435667"/>
                    <a:gd name="connsiteY4" fmla="*/ 0 h 1275293"/>
                    <a:gd name="connsiteX0" fmla="*/ 0 w 838901"/>
                    <a:gd name="connsiteY0" fmla="*/ 9626 h 1275293"/>
                    <a:gd name="connsiteX1" fmla="*/ 456698 w 838901"/>
                    <a:gd name="connsiteY1" fmla="*/ 0 h 1275293"/>
                    <a:gd name="connsiteX2" fmla="*/ 838901 w 838901"/>
                    <a:gd name="connsiteY2" fmla="*/ 1275293 h 1275293"/>
                    <a:gd name="connsiteX3" fmla="*/ 249054 w 838901"/>
                    <a:gd name="connsiteY3" fmla="*/ 1275293 h 1275293"/>
                    <a:gd name="connsiteX4" fmla="*/ 0 w 838901"/>
                    <a:gd name="connsiteY4" fmla="*/ 9626 h 1275293"/>
                    <a:gd name="connsiteX0" fmla="*/ 0 w 838901"/>
                    <a:gd name="connsiteY0" fmla="*/ 9626 h 1275293"/>
                    <a:gd name="connsiteX1" fmla="*/ 456698 w 838901"/>
                    <a:gd name="connsiteY1" fmla="*/ 0 h 1275293"/>
                    <a:gd name="connsiteX2" fmla="*/ 838901 w 838901"/>
                    <a:gd name="connsiteY2" fmla="*/ 1275293 h 1275293"/>
                    <a:gd name="connsiteX3" fmla="*/ 374182 w 838901"/>
                    <a:gd name="connsiteY3" fmla="*/ 1265668 h 1275293"/>
                    <a:gd name="connsiteX4" fmla="*/ 0 w 838901"/>
                    <a:gd name="connsiteY4" fmla="*/ 9626 h 1275293"/>
                    <a:gd name="connsiteX0" fmla="*/ 0 w 838901"/>
                    <a:gd name="connsiteY0" fmla="*/ 9626 h 1275293"/>
                    <a:gd name="connsiteX1" fmla="*/ 456698 w 838901"/>
                    <a:gd name="connsiteY1" fmla="*/ 0 h 1275293"/>
                    <a:gd name="connsiteX2" fmla="*/ 838901 w 838901"/>
                    <a:gd name="connsiteY2" fmla="*/ 1275293 h 1275293"/>
                    <a:gd name="connsiteX3" fmla="*/ 441559 w 838901"/>
                    <a:gd name="connsiteY3" fmla="*/ 1256043 h 1275293"/>
                    <a:gd name="connsiteX4" fmla="*/ 0 w 838901"/>
                    <a:gd name="connsiteY4" fmla="*/ 9626 h 1275293"/>
                    <a:gd name="connsiteX0" fmla="*/ 0 w 800399"/>
                    <a:gd name="connsiteY0" fmla="*/ 9626 h 1275293"/>
                    <a:gd name="connsiteX1" fmla="*/ 418196 w 800399"/>
                    <a:gd name="connsiteY1" fmla="*/ 0 h 1275293"/>
                    <a:gd name="connsiteX2" fmla="*/ 800399 w 800399"/>
                    <a:gd name="connsiteY2" fmla="*/ 1275293 h 1275293"/>
                    <a:gd name="connsiteX3" fmla="*/ 403057 w 800399"/>
                    <a:gd name="connsiteY3" fmla="*/ 1256043 h 1275293"/>
                    <a:gd name="connsiteX4" fmla="*/ 0 w 800399"/>
                    <a:gd name="connsiteY4" fmla="*/ 9626 h 1275293"/>
                    <a:gd name="connsiteX0" fmla="*/ 0 w 800399"/>
                    <a:gd name="connsiteY0" fmla="*/ 9626 h 1275293"/>
                    <a:gd name="connsiteX1" fmla="*/ 524074 w 800399"/>
                    <a:gd name="connsiteY1" fmla="*/ 0 h 1275293"/>
                    <a:gd name="connsiteX2" fmla="*/ 800399 w 800399"/>
                    <a:gd name="connsiteY2" fmla="*/ 1275293 h 1275293"/>
                    <a:gd name="connsiteX3" fmla="*/ 403057 w 800399"/>
                    <a:gd name="connsiteY3" fmla="*/ 1256043 h 1275293"/>
                    <a:gd name="connsiteX4" fmla="*/ 0 w 800399"/>
                    <a:gd name="connsiteY4" fmla="*/ 9626 h 1275293"/>
                    <a:gd name="connsiteX0" fmla="*/ 0 w 444264"/>
                    <a:gd name="connsiteY0" fmla="*/ 19252 h 1275293"/>
                    <a:gd name="connsiteX1" fmla="*/ 167939 w 444264"/>
                    <a:gd name="connsiteY1" fmla="*/ 0 h 1275293"/>
                    <a:gd name="connsiteX2" fmla="*/ 444264 w 444264"/>
                    <a:gd name="connsiteY2" fmla="*/ 1275293 h 1275293"/>
                    <a:gd name="connsiteX3" fmla="*/ 46922 w 444264"/>
                    <a:gd name="connsiteY3" fmla="*/ 1256043 h 1275293"/>
                    <a:gd name="connsiteX4" fmla="*/ 0 w 444264"/>
                    <a:gd name="connsiteY4" fmla="*/ 19252 h 1275293"/>
                    <a:gd name="connsiteX0" fmla="*/ 0 w 444264"/>
                    <a:gd name="connsiteY0" fmla="*/ 19252 h 1275293"/>
                    <a:gd name="connsiteX1" fmla="*/ 167939 w 444264"/>
                    <a:gd name="connsiteY1" fmla="*/ 0 h 1275293"/>
                    <a:gd name="connsiteX2" fmla="*/ 444264 w 444264"/>
                    <a:gd name="connsiteY2" fmla="*/ 1275293 h 1275293"/>
                    <a:gd name="connsiteX3" fmla="*/ 268303 w 444264"/>
                    <a:gd name="connsiteY3" fmla="*/ 1265669 h 1275293"/>
                    <a:gd name="connsiteX4" fmla="*/ 0 w 444264"/>
                    <a:gd name="connsiteY4" fmla="*/ 19252 h 12752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444264" h="1275293">
                      <a:moveTo>
                        <a:pt x="0" y="19252"/>
                      </a:moveTo>
                      <a:lnTo>
                        <a:pt x="167939" y="0"/>
                      </a:lnTo>
                      <a:lnTo>
                        <a:pt x="444264" y="1275293"/>
                      </a:lnTo>
                      <a:lnTo>
                        <a:pt x="268303" y="1265669"/>
                      </a:lnTo>
                      <a:lnTo>
                        <a:pt x="0" y="19252"/>
                      </a:lnTo>
                      <a:close/>
                    </a:path>
                  </a:pathLst>
                </a:custGeom>
                <a:solidFill>
                  <a:srgbClr val="E7E6E6"/>
                </a:solidFill>
                <a:ln w="1270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ko-KR" altLang="en-US" sz="1200" b="0" i="0" u="none" strike="noStrike" kern="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9" name="직사각형 121"/>
                <p:cNvSpPr/>
                <p:nvPr/>
              </p:nvSpPr>
              <p:spPr>
                <a:xfrm flipH="1">
                  <a:off x="1286609" y="2982136"/>
                  <a:ext cx="543135" cy="941411"/>
                </a:xfrm>
                <a:custGeom>
                  <a:avLst/>
                  <a:gdLst>
                    <a:gd name="connsiteX0" fmla="*/ 0 w 620327"/>
                    <a:gd name="connsiteY0" fmla="*/ 0 h 1275293"/>
                    <a:gd name="connsiteX1" fmla="*/ 620327 w 620327"/>
                    <a:gd name="connsiteY1" fmla="*/ 0 h 1275293"/>
                    <a:gd name="connsiteX2" fmla="*/ 620327 w 620327"/>
                    <a:gd name="connsiteY2" fmla="*/ 1275293 h 1275293"/>
                    <a:gd name="connsiteX3" fmla="*/ 0 w 620327"/>
                    <a:gd name="connsiteY3" fmla="*/ 1275293 h 1275293"/>
                    <a:gd name="connsiteX4" fmla="*/ 0 w 620327"/>
                    <a:gd name="connsiteY4" fmla="*/ 0 h 1275293"/>
                    <a:gd name="connsiteX0" fmla="*/ 0 w 1435667"/>
                    <a:gd name="connsiteY0" fmla="*/ 0 h 1275293"/>
                    <a:gd name="connsiteX1" fmla="*/ 620327 w 1435667"/>
                    <a:gd name="connsiteY1" fmla="*/ 0 h 1275293"/>
                    <a:gd name="connsiteX2" fmla="*/ 1435667 w 1435667"/>
                    <a:gd name="connsiteY2" fmla="*/ 1275293 h 1275293"/>
                    <a:gd name="connsiteX3" fmla="*/ 0 w 1435667"/>
                    <a:gd name="connsiteY3" fmla="*/ 1275293 h 1275293"/>
                    <a:gd name="connsiteX4" fmla="*/ 0 w 1435667"/>
                    <a:gd name="connsiteY4" fmla="*/ 0 h 1275293"/>
                    <a:gd name="connsiteX0" fmla="*/ 0 w 1435667"/>
                    <a:gd name="connsiteY0" fmla="*/ 0 h 1275293"/>
                    <a:gd name="connsiteX1" fmla="*/ 620327 w 1435667"/>
                    <a:gd name="connsiteY1" fmla="*/ 0 h 1275293"/>
                    <a:gd name="connsiteX2" fmla="*/ 1435667 w 1435667"/>
                    <a:gd name="connsiteY2" fmla="*/ 1275293 h 1275293"/>
                    <a:gd name="connsiteX3" fmla="*/ 845820 w 1435667"/>
                    <a:gd name="connsiteY3" fmla="*/ 1275293 h 1275293"/>
                    <a:gd name="connsiteX4" fmla="*/ 0 w 1435667"/>
                    <a:gd name="connsiteY4" fmla="*/ 0 h 1275293"/>
                    <a:gd name="connsiteX0" fmla="*/ 0 w 1435667"/>
                    <a:gd name="connsiteY0" fmla="*/ 0 h 1275293"/>
                    <a:gd name="connsiteX1" fmla="*/ 1053464 w 1435667"/>
                    <a:gd name="connsiteY1" fmla="*/ 0 h 1275293"/>
                    <a:gd name="connsiteX2" fmla="*/ 1435667 w 1435667"/>
                    <a:gd name="connsiteY2" fmla="*/ 1275293 h 1275293"/>
                    <a:gd name="connsiteX3" fmla="*/ 845820 w 1435667"/>
                    <a:gd name="connsiteY3" fmla="*/ 1275293 h 1275293"/>
                    <a:gd name="connsiteX4" fmla="*/ 0 w 1435667"/>
                    <a:gd name="connsiteY4" fmla="*/ 0 h 1275293"/>
                    <a:gd name="connsiteX0" fmla="*/ 0 w 838901"/>
                    <a:gd name="connsiteY0" fmla="*/ 9626 h 1275293"/>
                    <a:gd name="connsiteX1" fmla="*/ 456698 w 838901"/>
                    <a:gd name="connsiteY1" fmla="*/ 0 h 1275293"/>
                    <a:gd name="connsiteX2" fmla="*/ 838901 w 838901"/>
                    <a:gd name="connsiteY2" fmla="*/ 1275293 h 1275293"/>
                    <a:gd name="connsiteX3" fmla="*/ 249054 w 838901"/>
                    <a:gd name="connsiteY3" fmla="*/ 1275293 h 1275293"/>
                    <a:gd name="connsiteX4" fmla="*/ 0 w 838901"/>
                    <a:gd name="connsiteY4" fmla="*/ 9626 h 1275293"/>
                    <a:gd name="connsiteX0" fmla="*/ 0 w 838901"/>
                    <a:gd name="connsiteY0" fmla="*/ 9626 h 1275293"/>
                    <a:gd name="connsiteX1" fmla="*/ 456698 w 838901"/>
                    <a:gd name="connsiteY1" fmla="*/ 0 h 1275293"/>
                    <a:gd name="connsiteX2" fmla="*/ 838901 w 838901"/>
                    <a:gd name="connsiteY2" fmla="*/ 1275293 h 1275293"/>
                    <a:gd name="connsiteX3" fmla="*/ 374182 w 838901"/>
                    <a:gd name="connsiteY3" fmla="*/ 1265668 h 1275293"/>
                    <a:gd name="connsiteX4" fmla="*/ 0 w 838901"/>
                    <a:gd name="connsiteY4" fmla="*/ 9626 h 1275293"/>
                    <a:gd name="connsiteX0" fmla="*/ 0 w 838901"/>
                    <a:gd name="connsiteY0" fmla="*/ 9626 h 1275293"/>
                    <a:gd name="connsiteX1" fmla="*/ 456698 w 838901"/>
                    <a:gd name="connsiteY1" fmla="*/ 0 h 1275293"/>
                    <a:gd name="connsiteX2" fmla="*/ 838901 w 838901"/>
                    <a:gd name="connsiteY2" fmla="*/ 1275293 h 1275293"/>
                    <a:gd name="connsiteX3" fmla="*/ 441559 w 838901"/>
                    <a:gd name="connsiteY3" fmla="*/ 1256043 h 1275293"/>
                    <a:gd name="connsiteX4" fmla="*/ 0 w 838901"/>
                    <a:gd name="connsiteY4" fmla="*/ 9626 h 1275293"/>
                    <a:gd name="connsiteX0" fmla="*/ 0 w 800399"/>
                    <a:gd name="connsiteY0" fmla="*/ 9626 h 1275293"/>
                    <a:gd name="connsiteX1" fmla="*/ 418196 w 800399"/>
                    <a:gd name="connsiteY1" fmla="*/ 0 h 1275293"/>
                    <a:gd name="connsiteX2" fmla="*/ 800399 w 800399"/>
                    <a:gd name="connsiteY2" fmla="*/ 1275293 h 1275293"/>
                    <a:gd name="connsiteX3" fmla="*/ 403057 w 800399"/>
                    <a:gd name="connsiteY3" fmla="*/ 1256043 h 1275293"/>
                    <a:gd name="connsiteX4" fmla="*/ 0 w 800399"/>
                    <a:gd name="connsiteY4" fmla="*/ 9626 h 12752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800399" h="1275293">
                      <a:moveTo>
                        <a:pt x="0" y="9626"/>
                      </a:moveTo>
                      <a:lnTo>
                        <a:pt x="418196" y="0"/>
                      </a:lnTo>
                      <a:lnTo>
                        <a:pt x="800399" y="1275293"/>
                      </a:lnTo>
                      <a:lnTo>
                        <a:pt x="403057" y="1256043"/>
                      </a:lnTo>
                      <a:lnTo>
                        <a:pt x="0" y="9626"/>
                      </a:lnTo>
                      <a:close/>
                    </a:path>
                  </a:pathLst>
                </a:custGeom>
                <a:solidFill>
                  <a:srgbClr val="E7E6E6"/>
                </a:solidFill>
                <a:ln w="1270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ko-KR" altLang="en-US" sz="1200" b="0" i="0" u="none" strike="noStrike" kern="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0" name="TextBox 119"/>
                <p:cNvSpPr txBox="1"/>
                <p:nvPr/>
              </p:nvSpPr>
              <p:spPr>
                <a:xfrm>
                  <a:off x="1333240" y="3359883"/>
                  <a:ext cx="407471" cy="21596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10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99%</a:t>
                  </a:r>
                  <a:endParaRPr kumimoji="0" lang="ko-KR" altLang="en-US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21" name="그룹 120"/>
                <p:cNvGrpSpPr/>
                <p:nvPr/>
              </p:nvGrpSpPr>
              <p:grpSpPr>
                <a:xfrm>
                  <a:off x="1384688" y="2480900"/>
                  <a:ext cx="4131354" cy="688641"/>
                  <a:chOff x="1728057" y="1156381"/>
                  <a:chExt cx="6088233" cy="932875"/>
                </a:xfrm>
              </p:grpSpPr>
              <p:sp>
                <p:nvSpPr>
                  <p:cNvPr id="168" name="TextBox 167"/>
                  <p:cNvSpPr txBox="1"/>
                  <p:nvPr/>
                </p:nvSpPr>
                <p:spPr>
                  <a:xfrm>
                    <a:off x="1728057" y="1313754"/>
                    <a:ext cx="567626" cy="25598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8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182</a:t>
                    </a:r>
                    <a:endParaRPr kumimoji="0" lang="ko-KR" altLang="en-US" sz="8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69" name="TextBox 168"/>
                  <p:cNvSpPr txBox="1"/>
                  <p:nvPr/>
                </p:nvSpPr>
                <p:spPr>
                  <a:xfrm>
                    <a:off x="2592274" y="1156381"/>
                    <a:ext cx="567626" cy="25598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8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185</a:t>
                    </a:r>
                    <a:endParaRPr kumimoji="0" lang="ko-KR" altLang="en-US" sz="8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70" name="TextBox 169"/>
                  <p:cNvSpPr txBox="1"/>
                  <p:nvPr/>
                </p:nvSpPr>
                <p:spPr>
                  <a:xfrm>
                    <a:off x="4114527" y="1156381"/>
                    <a:ext cx="567626" cy="25598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8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189</a:t>
                    </a:r>
                    <a:endParaRPr kumimoji="0" lang="ko-KR" altLang="en-US" sz="8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grpSp>
                <p:nvGrpSpPr>
                  <p:cNvPr id="171" name="그룹 170"/>
                  <p:cNvGrpSpPr/>
                  <p:nvPr/>
                </p:nvGrpSpPr>
                <p:grpSpPr>
                  <a:xfrm>
                    <a:off x="1872229" y="1599982"/>
                    <a:ext cx="5940000" cy="489274"/>
                    <a:chOff x="1872229" y="1599982"/>
                    <a:chExt cx="5940000" cy="489274"/>
                  </a:xfrm>
                </p:grpSpPr>
                <p:cxnSp>
                  <p:nvCxnSpPr>
                    <p:cNvPr id="186" name="직선 연결선 185"/>
                    <p:cNvCxnSpPr/>
                    <p:nvPr/>
                  </p:nvCxnSpPr>
                  <p:spPr>
                    <a:xfrm>
                      <a:off x="1872229" y="1843955"/>
                      <a:ext cx="5940000" cy="0"/>
                    </a:xfrm>
                    <a:prstGeom prst="line">
                      <a:avLst/>
                    </a:prstGeom>
                    <a:noFill/>
                    <a:ln w="190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</p:cxnSp>
                <p:sp>
                  <p:nvSpPr>
                    <p:cNvPr id="187" name="오른쪽 화살표 186"/>
                    <p:cNvSpPr/>
                    <p:nvPr/>
                  </p:nvSpPr>
                  <p:spPr>
                    <a:xfrm>
                      <a:off x="2359141" y="1603324"/>
                      <a:ext cx="97283" cy="481263"/>
                    </a:xfrm>
                    <a:prstGeom prst="rightArrow">
                      <a:avLst/>
                    </a:prstGeom>
                    <a:solidFill>
                      <a:sysClr val="window" lastClr="FFFFFF"/>
                    </a:solidFill>
                    <a:ln w="190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12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‘</a:t>
                      </a:r>
                      <a:endParaRPr kumimoji="0" lang="ko-KR" altLang="en-US" sz="12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88" name="오른쪽 화살표 187"/>
                    <p:cNvSpPr/>
                    <p:nvPr/>
                  </p:nvSpPr>
                  <p:spPr>
                    <a:xfrm>
                      <a:off x="1967339" y="1603324"/>
                      <a:ext cx="450000" cy="481263"/>
                    </a:xfrm>
                    <a:prstGeom prst="rightArrow">
                      <a:avLst/>
                    </a:prstGeom>
                    <a:solidFill>
                      <a:sysClr val="window" lastClr="FFFFFF"/>
                    </a:solidFill>
                    <a:ln w="190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12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‘</a:t>
                      </a:r>
                      <a:endParaRPr kumimoji="0" lang="ko-KR" altLang="en-US" sz="12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89" name="오른쪽 화살표 188"/>
                    <p:cNvSpPr/>
                    <p:nvPr/>
                  </p:nvSpPr>
                  <p:spPr>
                    <a:xfrm>
                      <a:off x="3208672" y="1603324"/>
                      <a:ext cx="378114" cy="481263"/>
                    </a:xfrm>
                    <a:prstGeom prst="rightArrow">
                      <a:avLst/>
                    </a:prstGeom>
                    <a:solidFill>
                      <a:srgbClr val="FFC000"/>
                    </a:solidFill>
                    <a:ln w="190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ko-KR" altLang="en-US" sz="12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90" name="오른쪽 화살표 189"/>
                    <p:cNvSpPr/>
                    <p:nvPr/>
                  </p:nvSpPr>
                  <p:spPr>
                    <a:xfrm>
                      <a:off x="2659789" y="1603324"/>
                      <a:ext cx="544676" cy="481263"/>
                    </a:xfrm>
                    <a:prstGeom prst="rightArrow">
                      <a:avLst/>
                    </a:prstGeom>
                    <a:solidFill>
                      <a:sysClr val="window" lastClr="FFFFFF"/>
                    </a:solidFill>
                    <a:ln w="190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12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‘</a:t>
                      </a:r>
                      <a:endParaRPr kumimoji="0" lang="ko-KR" altLang="en-US" sz="12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91" name="오른쪽 화살표 190"/>
                    <p:cNvSpPr/>
                    <p:nvPr/>
                  </p:nvSpPr>
                  <p:spPr>
                    <a:xfrm>
                      <a:off x="2477577" y="1603324"/>
                      <a:ext cx="178307" cy="481263"/>
                    </a:xfrm>
                    <a:prstGeom prst="rightArrow">
                      <a:avLst/>
                    </a:prstGeom>
                    <a:solidFill>
                      <a:sysClr val="window" lastClr="FFFFFF"/>
                    </a:solidFill>
                    <a:ln w="190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12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‘</a:t>
                      </a:r>
                      <a:endParaRPr kumimoji="0" lang="ko-KR" altLang="en-US" sz="12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92" name="오른쪽 화살표 191"/>
                    <p:cNvSpPr/>
                    <p:nvPr/>
                  </p:nvSpPr>
                  <p:spPr>
                    <a:xfrm>
                      <a:off x="3604125" y="1603324"/>
                      <a:ext cx="288000" cy="481263"/>
                    </a:xfrm>
                    <a:prstGeom prst="rightArrow">
                      <a:avLst/>
                    </a:prstGeom>
                    <a:solidFill>
                      <a:srgbClr val="FFC000"/>
                    </a:solidFill>
                    <a:ln w="190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ko-KR" altLang="en-US" sz="12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93" name="오른쪽 화살표 192"/>
                    <p:cNvSpPr/>
                    <p:nvPr/>
                  </p:nvSpPr>
                  <p:spPr>
                    <a:xfrm>
                      <a:off x="3900081" y="1603324"/>
                      <a:ext cx="360000" cy="481263"/>
                    </a:xfrm>
                    <a:prstGeom prst="rightArrow">
                      <a:avLst/>
                    </a:prstGeom>
                    <a:solidFill>
                      <a:srgbClr val="FFC000"/>
                    </a:solidFill>
                    <a:ln w="190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ko-KR" altLang="en-US" sz="12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94" name="오른쪽 화살표 193"/>
                    <p:cNvSpPr/>
                    <p:nvPr/>
                  </p:nvSpPr>
                  <p:spPr>
                    <a:xfrm>
                      <a:off x="4271286" y="1603324"/>
                      <a:ext cx="360000" cy="481263"/>
                    </a:xfrm>
                    <a:prstGeom prst="rightArrow">
                      <a:avLst/>
                    </a:prstGeom>
                    <a:solidFill>
                      <a:srgbClr val="FFC000"/>
                    </a:solidFill>
                    <a:ln w="190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ko-KR" altLang="en-US" sz="12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95" name="오른쪽 화살표 194"/>
                    <p:cNvSpPr/>
                    <p:nvPr/>
                  </p:nvSpPr>
                  <p:spPr>
                    <a:xfrm>
                      <a:off x="4632908" y="1603324"/>
                      <a:ext cx="360000" cy="481263"/>
                    </a:xfrm>
                    <a:prstGeom prst="rightArrow">
                      <a:avLst/>
                    </a:prstGeom>
                    <a:solidFill>
                      <a:srgbClr val="FFC000"/>
                    </a:solidFill>
                    <a:ln w="190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ko-KR" altLang="en-US" sz="12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96" name="오른쪽 화살표 195"/>
                    <p:cNvSpPr/>
                    <p:nvPr/>
                  </p:nvSpPr>
                  <p:spPr>
                    <a:xfrm>
                      <a:off x="5006547" y="1603324"/>
                      <a:ext cx="125329" cy="481263"/>
                    </a:xfrm>
                    <a:prstGeom prst="rightArrow">
                      <a:avLst/>
                    </a:prstGeom>
                    <a:solidFill>
                      <a:srgbClr val="FFC000"/>
                    </a:solidFill>
                    <a:ln w="190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ko-KR" altLang="en-US" sz="12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97" name="오른쪽 화살표 196"/>
                    <p:cNvSpPr/>
                    <p:nvPr/>
                  </p:nvSpPr>
                  <p:spPr>
                    <a:xfrm>
                      <a:off x="5155965" y="1603324"/>
                      <a:ext cx="288000" cy="481263"/>
                    </a:xfrm>
                    <a:prstGeom prst="rightArrow">
                      <a:avLst/>
                    </a:prstGeom>
                    <a:solidFill>
                      <a:srgbClr val="FFC000"/>
                    </a:solidFill>
                    <a:ln w="190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ko-KR" altLang="en-US" sz="12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98" name="오른쪽 화살표 197"/>
                    <p:cNvSpPr/>
                    <p:nvPr/>
                  </p:nvSpPr>
                  <p:spPr>
                    <a:xfrm>
                      <a:off x="5454277" y="1603324"/>
                      <a:ext cx="194273" cy="481263"/>
                    </a:xfrm>
                    <a:prstGeom prst="rightArrow">
                      <a:avLst/>
                    </a:prstGeom>
                    <a:solidFill>
                      <a:srgbClr val="FFC000"/>
                    </a:solidFill>
                    <a:ln w="190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ko-KR" altLang="en-US" sz="12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99" name="오른쪽 화살표 198"/>
                    <p:cNvSpPr/>
                    <p:nvPr/>
                  </p:nvSpPr>
                  <p:spPr>
                    <a:xfrm>
                      <a:off x="5634350" y="1603324"/>
                      <a:ext cx="432000" cy="481263"/>
                    </a:xfrm>
                    <a:prstGeom prst="rightArrow">
                      <a:avLst/>
                    </a:prstGeom>
                    <a:solidFill>
                      <a:srgbClr val="FFC000"/>
                    </a:solidFill>
                    <a:ln w="190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ko-KR" altLang="en-US" sz="12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00" name="오른쪽 화살표 199"/>
                    <p:cNvSpPr/>
                    <p:nvPr/>
                  </p:nvSpPr>
                  <p:spPr>
                    <a:xfrm flipH="1">
                      <a:off x="6933610" y="1603324"/>
                      <a:ext cx="387129" cy="481263"/>
                    </a:xfrm>
                    <a:prstGeom prst="rightArrow">
                      <a:avLst/>
                    </a:prstGeom>
                    <a:solidFill>
                      <a:srgbClr val="FFC000"/>
                    </a:solidFill>
                    <a:ln w="190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ko-KR" altLang="en-US" sz="12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01" name="오른쪽 화살표 200"/>
                    <p:cNvSpPr/>
                    <p:nvPr/>
                  </p:nvSpPr>
                  <p:spPr>
                    <a:xfrm>
                      <a:off x="7343370" y="1603324"/>
                      <a:ext cx="378114" cy="481263"/>
                    </a:xfrm>
                    <a:prstGeom prst="rightArrow">
                      <a:avLst/>
                    </a:prstGeom>
                    <a:solidFill>
                      <a:sysClr val="window" lastClr="FFFFFF"/>
                    </a:solidFill>
                    <a:ln w="190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12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‘</a:t>
                      </a:r>
                      <a:endParaRPr kumimoji="0" lang="ko-KR" altLang="en-US" sz="12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02" name="오른쪽 화살표 201"/>
                    <p:cNvSpPr/>
                    <p:nvPr/>
                  </p:nvSpPr>
                  <p:spPr>
                    <a:xfrm>
                      <a:off x="6057353" y="1599982"/>
                      <a:ext cx="432000" cy="481263"/>
                    </a:xfrm>
                    <a:prstGeom prst="rightArrow">
                      <a:avLst/>
                    </a:prstGeom>
                    <a:solidFill>
                      <a:srgbClr val="FFC000"/>
                    </a:solidFill>
                    <a:ln w="190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ko-KR" altLang="en-US" sz="12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03" name="오른쪽 화살표 202"/>
                    <p:cNvSpPr/>
                    <p:nvPr/>
                  </p:nvSpPr>
                  <p:spPr>
                    <a:xfrm>
                      <a:off x="6488860" y="1607993"/>
                      <a:ext cx="432000" cy="481263"/>
                    </a:xfrm>
                    <a:prstGeom prst="rightArrow">
                      <a:avLst/>
                    </a:prstGeom>
                    <a:solidFill>
                      <a:srgbClr val="FFC000"/>
                    </a:solidFill>
                    <a:ln w="190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ko-KR" altLang="en-US" sz="12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172" name="TextBox 171"/>
                  <p:cNvSpPr txBox="1"/>
                  <p:nvPr/>
                </p:nvSpPr>
                <p:spPr>
                  <a:xfrm>
                    <a:off x="2028485" y="1156381"/>
                    <a:ext cx="567626" cy="25598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8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183</a:t>
                    </a:r>
                    <a:endParaRPr kumimoji="0" lang="ko-KR" altLang="en-US" sz="8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73" name="TextBox 172"/>
                  <p:cNvSpPr txBox="1"/>
                  <p:nvPr/>
                </p:nvSpPr>
                <p:spPr>
                  <a:xfrm>
                    <a:off x="2248262" y="1313754"/>
                    <a:ext cx="567626" cy="25598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8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184</a:t>
                    </a:r>
                    <a:endParaRPr kumimoji="0" lang="ko-KR" altLang="en-US" sz="8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74" name="TextBox 173"/>
                  <p:cNvSpPr txBox="1"/>
                  <p:nvPr/>
                </p:nvSpPr>
                <p:spPr>
                  <a:xfrm>
                    <a:off x="3054289" y="1313754"/>
                    <a:ext cx="567626" cy="25598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8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186</a:t>
                    </a:r>
                    <a:endParaRPr kumimoji="0" lang="ko-KR" altLang="en-US" sz="8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75" name="TextBox 174"/>
                  <p:cNvSpPr txBox="1"/>
                  <p:nvPr/>
                </p:nvSpPr>
                <p:spPr>
                  <a:xfrm>
                    <a:off x="3419917" y="1156381"/>
                    <a:ext cx="567626" cy="25598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8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187</a:t>
                    </a:r>
                    <a:endParaRPr kumimoji="0" lang="ko-KR" altLang="en-US" sz="8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76" name="TextBox 175"/>
                  <p:cNvSpPr txBox="1"/>
                  <p:nvPr/>
                </p:nvSpPr>
                <p:spPr>
                  <a:xfrm>
                    <a:off x="3773927" y="1313754"/>
                    <a:ext cx="567626" cy="25598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8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188</a:t>
                    </a:r>
                    <a:endParaRPr kumimoji="0" lang="ko-KR" altLang="en-US" sz="8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77" name="TextBox 176"/>
                  <p:cNvSpPr txBox="1"/>
                  <p:nvPr/>
                </p:nvSpPr>
                <p:spPr>
                  <a:xfrm>
                    <a:off x="4477628" y="1313754"/>
                    <a:ext cx="567626" cy="25598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8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190</a:t>
                    </a:r>
                    <a:endParaRPr kumimoji="0" lang="ko-KR" altLang="en-US" sz="8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78" name="TextBox 177"/>
                  <p:cNvSpPr txBox="1"/>
                  <p:nvPr/>
                </p:nvSpPr>
                <p:spPr>
                  <a:xfrm>
                    <a:off x="4725716" y="1156381"/>
                    <a:ext cx="567626" cy="25598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8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191</a:t>
                    </a:r>
                    <a:endParaRPr kumimoji="0" lang="ko-KR" altLang="en-US" sz="8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79" name="TextBox 178"/>
                  <p:cNvSpPr txBox="1"/>
                  <p:nvPr/>
                </p:nvSpPr>
                <p:spPr>
                  <a:xfrm>
                    <a:off x="4974984" y="1313754"/>
                    <a:ext cx="567626" cy="25598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8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192</a:t>
                    </a:r>
                    <a:endParaRPr kumimoji="0" lang="ko-KR" altLang="en-US" sz="8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80" name="TextBox 179"/>
                  <p:cNvSpPr txBox="1"/>
                  <p:nvPr/>
                </p:nvSpPr>
                <p:spPr>
                  <a:xfrm>
                    <a:off x="5223070" y="1156381"/>
                    <a:ext cx="567626" cy="25598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8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193</a:t>
                    </a:r>
                    <a:endParaRPr kumimoji="0" lang="ko-KR" altLang="en-US" sz="8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81" name="TextBox 180"/>
                  <p:cNvSpPr txBox="1"/>
                  <p:nvPr/>
                </p:nvSpPr>
                <p:spPr>
                  <a:xfrm>
                    <a:off x="5481158" y="1313754"/>
                    <a:ext cx="567626" cy="25598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8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194</a:t>
                    </a:r>
                    <a:endParaRPr kumimoji="0" lang="ko-KR" altLang="en-US" sz="8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82" name="TextBox 181"/>
                  <p:cNvSpPr txBox="1"/>
                  <p:nvPr/>
                </p:nvSpPr>
                <p:spPr>
                  <a:xfrm>
                    <a:off x="5921147" y="1313754"/>
                    <a:ext cx="567626" cy="25598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8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195</a:t>
                    </a:r>
                    <a:endParaRPr kumimoji="0" lang="ko-KR" altLang="en-US" sz="8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83" name="TextBox 182"/>
                  <p:cNvSpPr txBox="1"/>
                  <p:nvPr/>
                </p:nvSpPr>
                <p:spPr>
                  <a:xfrm>
                    <a:off x="6372248" y="1313754"/>
                    <a:ext cx="567626" cy="25598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8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196</a:t>
                    </a:r>
                    <a:endParaRPr kumimoji="0" lang="ko-KR" altLang="en-US" sz="8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84" name="TextBox 183"/>
                  <p:cNvSpPr txBox="1"/>
                  <p:nvPr/>
                </p:nvSpPr>
                <p:spPr>
                  <a:xfrm>
                    <a:off x="6856350" y="1313754"/>
                    <a:ext cx="567626" cy="25598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8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197</a:t>
                    </a:r>
                    <a:endParaRPr kumimoji="0" lang="ko-KR" altLang="en-US" sz="8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85" name="TextBox 184"/>
                  <p:cNvSpPr txBox="1"/>
                  <p:nvPr/>
                </p:nvSpPr>
                <p:spPr>
                  <a:xfrm>
                    <a:off x="7248664" y="1313754"/>
                    <a:ext cx="567626" cy="25598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8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198</a:t>
                    </a:r>
                    <a:endParaRPr kumimoji="0" lang="ko-KR" altLang="en-US" sz="8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cxnSp>
              <p:nvCxnSpPr>
                <p:cNvPr id="122" name="직선 연결선 121"/>
                <p:cNvCxnSpPr/>
                <p:nvPr/>
              </p:nvCxnSpPr>
              <p:spPr>
                <a:xfrm>
                  <a:off x="1235931" y="3899262"/>
                  <a:ext cx="4568202" cy="0"/>
                </a:xfrm>
                <a:prstGeom prst="line">
                  <a:avLst/>
                </a:prstGeom>
                <a:noFill/>
                <a:ln w="190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  <p:sp>
              <p:nvSpPr>
                <p:cNvPr id="123" name="오른쪽 화살표 122"/>
                <p:cNvSpPr/>
                <p:nvPr/>
              </p:nvSpPr>
              <p:spPr>
                <a:xfrm>
                  <a:off x="1566340" y="3722428"/>
                  <a:ext cx="66014" cy="355264"/>
                </a:xfrm>
                <a:prstGeom prst="rightArrow">
                  <a:avLst/>
                </a:prstGeom>
                <a:solidFill>
                  <a:sysClr val="window" lastClr="FFFFFF"/>
                </a:solidFill>
                <a:ln w="190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12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rPr>
                    <a:t>‘</a:t>
                  </a:r>
                  <a:endParaRPr kumimoji="0" lang="ko-KR" altLang="en-US" sz="12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4" name="오른쪽 화살표 123"/>
                <p:cNvSpPr/>
                <p:nvPr/>
              </p:nvSpPr>
              <p:spPr>
                <a:xfrm>
                  <a:off x="1300471" y="3722428"/>
                  <a:ext cx="305361" cy="355264"/>
                </a:xfrm>
                <a:prstGeom prst="rightArrow">
                  <a:avLst/>
                </a:prstGeom>
                <a:solidFill>
                  <a:sysClr val="window" lastClr="FFFFFF"/>
                </a:solidFill>
                <a:ln w="190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12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rPr>
                    <a:t>‘</a:t>
                  </a:r>
                  <a:endParaRPr kumimoji="0" lang="ko-KR" altLang="en-US" sz="12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5" name="TextBox 124"/>
                <p:cNvSpPr txBox="1"/>
                <p:nvPr/>
              </p:nvSpPr>
              <p:spPr>
                <a:xfrm>
                  <a:off x="1158766" y="4132240"/>
                  <a:ext cx="438677" cy="1889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8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2782</a:t>
                  </a:r>
                  <a:endParaRPr kumimoji="0" lang="ko-KR" alt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6" name="오른쪽 화살표 125"/>
                <p:cNvSpPr/>
                <p:nvPr/>
              </p:nvSpPr>
              <p:spPr>
                <a:xfrm>
                  <a:off x="2240784" y="3722428"/>
                  <a:ext cx="256580" cy="355264"/>
                </a:xfrm>
                <a:prstGeom prst="rightArrow">
                  <a:avLst/>
                </a:prstGeom>
                <a:solidFill>
                  <a:sysClr val="window" lastClr="FFFFFF"/>
                </a:solidFill>
                <a:ln w="190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12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rPr>
                    <a:t>‘</a:t>
                  </a:r>
                  <a:endParaRPr kumimoji="0" lang="ko-KR" altLang="en-US" sz="12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7" name="오른쪽 화살표 126"/>
                <p:cNvSpPr/>
                <p:nvPr/>
              </p:nvSpPr>
              <p:spPr>
                <a:xfrm>
                  <a:off x="1868327" y="3722428"/>
                  <a:ext cx="369606" cy="355264"/>
                </a:xfrm>
                <a:prstGeom prst="rightArrow">
                  <a:avLst/>
                </a:prstGeom>
                <a:solidFill>
                  <a:sysClr val="window" lastClr="FFFFFF"/>
                </a:solidFill>
                <a:ln w="190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12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rPr>
                    <a:t>‘</a:t>
                  </a:r>
                  <a:endParaRPr kumimoji="0" lang="ko-KR" altLang="en-US" sz="12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8" name="오른쪽 화살표 127"/>
                <p:cNvSpPr/>
                <p:nvPr/>
              </p:nvSpPr>
              <p:spPr>
                <a:xfrm flipH="1">
                  <a:off x="1627213" y="3722428"/>
                  <a:ext cx="75693" cy="355264"/>
                </a:xfrm>
                <a:prstGeom prst="rightArrow">
                  <a:avLst/>
                </a:prstGeom>
                <a:solidFill>
                  <a:sysClr val="window" lastClr="FFFFFF"/>
                </a:solidFill>
                <a:ln w="190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12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rPr>
                    <a:t>‘</a:t>
                  </a:r>
                  <a:endParaRPr kumimoji="0" lang="ko-KR" altLang="en-US" sz="12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9" name="오른쪽 화살표 128"/>
                <p:cNvSpPr/>
                <p:nvPr/>
              </p:nvSpPr>
              <p:spPr>
                <a:xfrm>
                  <a:off x="1698960" y="3722428"/>
                  <a:ext cx="120996" cy="355264"/>
                </a:xfrm>
                <a:prstGeom prst="rightArrow">
                  <a:avLst/>
                </a:prstGeom>
                <a:solidFill>
                  <a:sysClr val="window" lastClr="FFFFFF"/>
                </a:solidFill>
                <a:ln w="190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12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rPr>
                    <a:t>‘</a:t>
                  </a:r>
                  <a:endParaRPr kumimoji="0" lang="ko-KR" altLang="en-US" sz="12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0" name="오른쪽 화살표 129"/>
                <p:cNvSpPr/>
                <p:nvPr/>
              </p:nvSpPr>
              <p:spPr>
                <a:xfrm flipH="1">
                  <a:off x="1828146" y="3722428"/>
                  <a:ext cx="39928" cy="355264"/>
                </a:xfrm>
                <a:prstGeom prst="rightArrow">
                  <a:avLst/>
                </a:prstGeom>
                <a:solidFill>
                  <a:sysClr val="window" lastClr="FFFFFF"/>
                </a:solidFill>
                <a:ln w="190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12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rPr>
                    <a:t>‘</a:t>
                  </a:r>
                  <a:endParaRPr kumimoji="0" lang="ko-KR" altLang="en-US" sz="12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1" name="오른쪽 화살표 130"/>
                <p:cNvSpPr/>
                <p:nvPr/>
              </p:nvSpPr>
              <p:spPr>
                <a:xfrm>
                  <a:off x="2496070" y="3722428"/>
                  <a:ext cx="195431" cy="355264"/>
                </a:xfrm>
                <a:prstGeom prst="rightArrow">
                  <a:avLst/>
                </a:prstGeom>
                <a:solidFill>
                  <a:sysClr val="window" lastClr="FFFFFF"/>
                </a:solidFill>
                <a:ln w="190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12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rPr>
                    <a:t>‘</a:t>
                  </a:r>
                  <a:endParaRPr kumimoji="0" lang="ko-KR" altLang="en-US" sz="12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2" name="오른쪽 화살표 131"/>
                <p:cNvSpPr/>
                <p:nvPr/>
              </p:nvSpPr>
              <p:spPr>
                <a:xfrm>
                  <a:off x="2696901" y="3722428"/>
                  <a:ext cx="244289" cy="355264"/>
                </a:xfrm>
                <a:prstGeom prst="rightArrow">
                  <a:avLst/>
                </a:prstGeom>
                <a:solidFill>
                  <a:sysClr val="window" lastClr="FFFFFF"/>
                </a:solidFill>
                <a:ln w="190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12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rPr>
                    <a:t>‘</a:t>
                  </a:r>
                  <a:endParaRPr kumimoji="0" lang="ko-KR" altLang="en-US" sz="12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3" name="오른쪽 화살표 132"/>
                <p:cNvSpPr/>
                <p:nvPr/>
              </p:nvSpPr>
              <p:spPr>
                <a:xfrm>
                  <a:off x="2942261" y="3722428"/>
                  <a:ext cx="244289" cy="355264"/>
                </a:xfrm>
                <a:prstGeom prst="rightArrow">
                  <a:avLst/>
                </a:prstGeom>
                <a:solidFill>
                  <a:sysClr val="window" lastClr="FFFFFF"/>
                </a:solidFill>
                <a:ln w="190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12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rPr>
                    <a:t>‘</a:t>
                  </a:r>
                  <a:endParaRPr kumimoji="0" lang="ko-KR" altLang="en-US" sz="12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4" name="오른쪽 화살표 133"/>
                <p:cNvSpPr/>
                <p:nvPr/>
              </p:nvSpPr>
              <p:spPr>
                <a:xfrm>
                  <a:off x="3181120" y="3722428"/>
                  <a:ext cx="244289" cy="355264"/>
                </a:xfrm>
                <a:prstGeom prst="rightArrow">
                  <a:avLst/>
                </a:prstGeom>
                <a:solidFill>
                  <a:sysClr val="window" lastClr="FFFFFF"/>
                </a:solidFill>
                <a:ln w="190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12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rPr>
                    <a:t>‘</a:t>
                  </a:r>
                  <a:endParaRPr kumimoji="0" lang="ko-KR" altLang="en-US" sz="12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5" name="오른쪽 화살표 134"/>
                <p:cNvSpPr/>
                <p:nvPr/>
              </p:nvSpPr>
              <p:spPr>
                <a:xfrm>
                  <a:off x="3428133" y="3722428"/>
                  <a:ext cx="195431" cy="355264"/>
                </a:xfrm>
                <a:prstGeom prst="rightArrow">
                  <a:avLst/>
                </a:prstGeom>
                <a:solidFill>
                  <a:sysClr val="window" lastClr="FFFFFF"/>
                </a:solidFill>
                <a:ln w="190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12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rPr>
                    <a:t>‘</a:t>
                  </a:r>
                  <a:endParaRPr kumimoji="0" lang="ko-KR" altLang="en-US" sz="12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6" name="오른쪽 화살표 135"/>
                <p:cNvSpPr/>
                <p:nvPr/>
              </p:nvSpPr>
              <p:spPr>
                <a:xfrm>
                  <a:off x="3627495" y="3722428"/>
                  <a:ext cx="195431" cy="355264"/>
                </a:xfrm>
                <a:prstGeom prst="rightArrow">
                  <a:avLst/>
                </a:prstGeom>
                <a:solidFill>
                  <a:sysClr val="window" lastClr="FFFFFF"/>
                </a:solidFill>
                <a:ln w="190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12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rPr>
                    <a:t>‘</a:t>
                  </a:r>
                  <a:endParaRPr kumimoji="0" lang="ko-KR" altLang="en-US" sz="12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7" name="오른쪽 화살표 136"/>
                <p:cNvSpPr/>
                <p:nvPr/>
              </p:nvSpPr>
              <p:spPr>
                <a:xfrm>
                  <a:off x="3822831" y="3722428"/>
                  <a:ext cx="195431" cy="355264"/>
                </a:xfrm>
                <a:prstGeom prst="rightArrow">
                  <a:avLst/>
                </a:prstGeom>
                <a:solidFill>
                  <a:sysClr val="window" lastClr="FFFFFF"/>
                </a:solidFill>
                <a:ln w="190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12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rPr>
                    <a:t>‘</a:t>
                  </a:r>
                  <a:endParaRPr kumimoji="0" lang="ko-KR" altLang="en-US" sz="12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8" name="오른쪽 화살표 137"/>
                <p:cNvSpPr/>
                <p:nvPr/>
              </p:nvSpPr>
              <p:spPr>
                <a:xfrm>
                  <a:off x="4030025" y="3722428"/>
                  <a:ext cx="195431" cy="355264"/>
                </a:xfrm>
                <a:prstGeom prst="rightArrow">
                  <a:avLst/>
                </a:prstGeom>
                <a:solidFill>
                  <a:sysClr val="window" lastClr="FFFFFF"/>
                </a:solidFill>
                <a:ln w="190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12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rPr>
                    <a:t>‘</a:t>
                  </a:r>
                  <a:endParaRPr kumimoji="0" lang="ko-KR" altLang="en-US" sz="12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9" name="오른쪽 화살표 138"/>
                <p:cNvSpPr/>
                <p:nvPr/>
              </p:nvSpPr>
              <p:spPr>
                <a:xfrm>
                  <a:off x="4225245" y="3722428"/>
                  <a:ext cx="195431" cy="355264"/>
                </a:xfrm>
                <a:prstGeom prst="rightArrow">
                  <a:avLst/>
                </a:prstGeom>
                <a:solidFill>
                  <a:sysClr val="window" lastClr="FFFFFF"/>
                </a:solidFill>
                <a:ln w="190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12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rPr>
                    <a:t>‘</a:t>
                  </a:r>
                  <a:endParaRPr kumimoji="0" lang="ko-KR" altLang="en-US" sz="12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0" name="오른쪽 화살표 139"/>
                <p:cNvSpPr/>
                <p:nvPr/>
              </p:nvSpPr>
              <p:spPr>
                <a:xfrm>
                  <a:off x="4425641" y="3722428"/>
                  <a:ext cx="195431" cy="355264"/>
                </a:xfrm>
                <a:prstGeom prst="rightArrow">
                  <a:avLst/>
                </a:prstGeom>
                <a:solidFill>
                  <a:sysClr val="window" lastClr="FFFFFF"/>
                </a:solidFill>
                <a:ln w="190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12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rPr>
                    <a:t>‘</a:t>
                  </a:r>
                  <a:endParaRPr kumimoji="0" lang="ko-KR" altLang="en-US" sz="12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1" name="오른쪽 화살표 140"/>
                <p:cNvSpPr/>
                <p:nvPr/>
              </p:nvSpPr>
              <p:spPr>
                <a:xfrm>
                  <a:off x="4626671" y="3722428"/>
                  <a:ext cx="195431" cy="355264"/>
                </a:xfrm>
                <a:prstGeom prst="rightArrow">
                  <a:avLst/>
                </a:prstGeom>
                <a:solidFill>
                  <a:sysClr val="window" lastClr="FFFFFF"/>
                </a:solidFill>
                <a:ln w="190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12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rPr>
                    <a:t>‘</a:t>
                  </a:r>
                  <a:endParaRPr kumimoji="0" lang="ko-KR" altLang="en-US" sz="12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2" name="오른쪽 화살표 141"/>
                <p:cNvSpPr/>
                <p:nvPr/>
              </p:nvSpPr>
              <p:spPr>
                <a:xfrm>
                  <a:off x="4814642" y="3722428"/>
                  <a:ext cx="387683" cy="355264"/>
                </a:xfrm>
                <a:prstGeom prst="rightArrow">
                  <a:avLst/>
                </a:prstGeom>
                <a:solidFill>
                  <a:sysClr val="window" lastClr="FFFFFF"/>
                </a:solidFill>
                <a:ln w="190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12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rPr>
                    <a:t>‘</a:t>
                  </a:r>
                  <a:endParaRPr kumimoji="0" lang="ko-KR" altLang="en-US" sz="12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3" name="오른쪽 화살표 142"/>
                <p:cNvSpPr/>
                <p:nvPr/>
              </p:nvSpPr>
              <p:spPr>
                <a:xfrm>
                  <a:off x="5217342" y="3722428"/>
                  <a:ext cx="256580" cy="355264"/>
                </a:xfrm>
                <a:prstGeom prst="rightArrow">
                  <a:avLst/>
                </a:prstGeom>
                <a:solidFill>
                  <a:sysClr val="window" lastClr="FFFFFF"/>
                </a:solidFill>
                <a:ln w="190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12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rPr>
                    <a:t>‘</a:t>
                  </a:r>
                  <a:endParaRPr kumimoji="0" lang="ko-KR" altLang="en-US" sz="12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4" name="오른쪽 화살표 143"/>
                <p:cNvSpPr/>
                <p:nvPr/>
              </p:nvSpPr>
              <p:spPr>
                <a:xfrm>
                  <a:off x="5497345" y="3721629"/>
                  <a:ext cx="256580" cy="355264"/>
                </a:xfrm>
                <a:prstGeom prst="rightArrow">
                  <a:avLst/>
                </a:prstGeom>
                <a:solidFill>
                  <a:sysClr val="window" lastClr="FFFFFF"/>
                </a:solidFill>
                <a:ln w="190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12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rPr>
                    <a:t>‘</a:t>
                  </a:r>
                  <a:endParaRPr kumimoji="0" lang="ko-KR" altLang="en-US" sz="12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5" name="TextBox 144"/>
                <p:cNvSpPr txBox="1"/>
                <p:nvPr/>
              </p:nvSpPr>
              <p:spPr>
                <a:xfrm>
                  <a:off x="1536420" y="4132240"/>
                  <a:ext cx="438677" cy="1889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8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2779</a:t>
                  </a:r>
                  <a:endParaRPr kumimoji="0" lang="ko-KR" alt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6" name="TextBox 145"/>
                <p:cNvSpPr txBox="1"/>
                <p:nvPr/>
              </p:nvSpPr>
              <p:spPr>
                <a:xfrm>
                  <a:off x="1836961" y="4237923"/>
                  <a:ext cx="438677" cy="1889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8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2778</a:t>
                  </a:r>
                  <a:endParaRPr kumimoji="0" lang="ko-KR" alt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7" name="TextBox 146"/>
                <p:cNvSpPr txBox="1"/>
                <p:nvPr/>
              </p:nvSpPr>
              <p:spPr>
                <a:xfrm>
                  <a:off x="2128865" y="4132241"/>
                  <a:ext cx="438677" cy="1889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8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2777</a:t>
                  </a:r>
                  <a:endParaRPr kumimoji="0" lang="ko-KR" alt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8" name="TextBox 147"/>
                <p:cNvSpPr txBox="1"/>
                <p:nvPr/>
              </p:nvSpPr>
              <p:spPr>
                <a:xfrm>
                  <a:off x="2368726" y="4247946"/>
                  <a:ext cx="438677" cy="1889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8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2776</a:t>
                  </a:r>
                  <a:endParaRPr kumimoji="0" lang="ko-KR" alt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9" name="TextBox 148"/>
                <p:cNvSpPr txBox="1"/>
                <p:nvPr/>
              </p:nvSpPr>
              <p:spPr>
                <a:xfrm>
                  <a:off x="2573582" y="4132241"/>
                  <a:ext cx="438677" cy="1889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8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2775</a:t>
                  </a:r>
                  <a:endParaRPr kumimoji="0" lang="ko-KR" alt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0" name="TextBox 149"/>
                <p:cNvSpPr txBox="1"/>
                <p:nvPr/>
              </p:nvSpPr>
              <p:spPr>
                <a:xfrm>
                  <a:off x="2852404" y="4247943"/>
                  <a:ext cx="438677" cy="1889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8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2774</a:t>
                  </a:r>
                  <a:endParaRPr kumimoji="0" lang="ko-KR" alt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1" name="TextBox 150"/>
                <p:cNvSpPr txBox="1"/>
                <p:nvPr/>
              </p:nvSpPr>
              <p:spPr>
                <a:xfrm>
                  <a:off x="3079713" y="4132241"/>
                  <a:ext cx="438677" cy="1889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8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2773</a:t>
                  </a:r>
                  <a:endParaRPr kumimoji="0" lang="ko-KR" alt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2" name="TextBox 151"/>
                <p:cNvSpPr txBox="1"/>
                <p:nvPr/>
              </p:nvSpPr>
              <p:spPr>
                <a:xfrm>
                  <a:off x="3292611" y="4247943"/>
                  <a:ext cx="438677" cy="1889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8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2772</a:t>
                  </a:r>
                  <a:endParaRPr kumimoji="0" lang="ko-KR" alt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3" name="TextBox 152"/>
                <p:cNvSpPr txBox="1"/>
                <p:nvPr/>
              </p:nvSpPr>
              <p:spPr>
                <a:xfrm>
                  <a:off x="3500314" y="4132241"/>
                  <a:ext cx="438677" cy="1889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8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2771</a:t>
                  </a:r>
                  <a:endParaRPr kumimoji="0" lang="ko-KR" alt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4" name="TextBox 153"/>
                <p:cNvSpPr txBox="1"/>
                <p:nvPr/>
              </p:nvSpPr>
              <p:spPr>
                <a:xfrm>
                  <a:off x="3701207" y="4247943"/>
                  <a:ext cx="438677" cy="1889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8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2770</a:t>
                  </a:r>
                  <a:endParaRPr kumimoji="0" lang="ko-KR" alt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5" name="TextBox 154"/>
                <p:cNvSpPr txBox="1"/>
                <p:nvPr/>
              </p:nvSpPr>
              <p:spPr>
                <a:xfrm>
                  <a:off x="3908403" y="4132241"/>
                  <a:ext cx="438677" cy="1889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8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2769</a:t>
                  </a:r>
                  <a:endParaRPr kumimoji="0" lang="ko-KR" alt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6" name="TextBox 155"/>
                <p:cNvSpPr txBox="1"/>
                <p:nvPr/>
              </p:nvSpPr>
              <p:spPr>
                <a:xfrm>
                  <a:off x="4079834" y="4247943"/>
                  <a:ext cx="438677" cy="1889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8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2768</a:t>
                  </a:r>
                  <a:endParaRPr kumimoji="0" lang="ko-KR" alt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7" name="TextBox 156"/>
                <p:cNvSpPr txBox="1"/>
                <p:nvPr/>
              </p:nvSpPr>
              <p:spPr>
                <a:xfrm>
                  <a:off x="4287030" y="4132241"/>
                  <a:ext cx="438677" cy="1889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8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2767</a:t>
                  </a:r>
                  <a:endParaRPr kumimoji="0" lang="ko-KR" alt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8" name="TextBox 157"/>
                <p:cNvSpPr txBox="1"/>
                <p:nvPr/>
              </p:nvSpPr>
              <p:spPr>
                <a:xfrm>
                  <a:off x="4505047" y="4247943"/>
                  <a:ext cx="438677" cy="1889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8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2766</a:t>
                  </a:r>
                  <a:endParaRPr kumimoji="0" lang="ko-KR" alt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9" name="TextBox 158"/>
                <p:cNvSpPr txBox="1"/>
                <p:nvPr/>
              </p:nvSpPr>
              <p:spPr>
                <a:xfrm>
                  <a:off x="4789146" y="4132241"/>
                  <a:ext cx="438677" cy="1889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8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2765</a:t>
                  </a:r>
                  <a:endParaRPr kumimoji="0" lang="ko-KR" alt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0" name="TextBox 159"/>
                <p:cNvSpPr txBox="1"/>
                <p:nvPr/>
              </p:nvSpPr>
              <p:spPr>
                <a:xfrm>
                  <a:off x="5126294" y="4247943"/>
                  <a:ext cx="438677" cy="1889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8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2764</a:t>
                  </a:r>
                  <a:endParaRPr kumimoji="0" lang="ko-KR" alt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1" name="TextBox 160"/>
                <p:cNvSpPr txBox="1"/>
                <p:nvPr/>
              </p:nvSpPr>
              <p:spPr>
                <a:xfrm>
                  <a:off x="5402134" y="4132240"/>
                  <a:ext cx="438677" cy="1889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8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2763</a:t>
                  </a:r>
                  <a:endParaRPr kumimoji="0" lang="ko-KR" alt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2" name="TextBox 161"/>
                <p:cNvSpPr txBox="1"/>
                <p:nvPr/>
              </p:nvSpPr>
              <p:spPr>
                <a:xfrm>
                  <a:off x="1672212" y="3220643"/>
                  <a:ext cx="407472" cy="21596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10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99%</a:t>
                  </a:r>
                  <a:endParaRPr kumimoji="0" lang="ko-KR" altLang="en-US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3" name="TextBox 162"/>
                <p:cNvSpPr txBox="1"/>
                <p:nvPr/>
              </p:nvSpPr>
              <p:spPr>
                <a:xfrm>
                  <a:off x="1909445" y="3359883"/>
                  <a:ext cx="407472" cy="21596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10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97%</a:t>
                  </a:r>
                  <a:endParaRPr kumimoji="0" lang="ko-KR" altLang="en-US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4" name="TextBox 163"/>
                <p:cNvSpPr txBox="1"/>
                <p:nvPr/>
              </p:nvSpPr>
              <p:spPr>
                <a:xfrm>
                  <a:off x="5272391" y="3359883"/>
                  <a:ext cx="407472" cy="21596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10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76%</a:t>
                  </a:r>
                  <a:endParaRPr kumimoji="0" lang="ko-KR" altLang="en-US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65" name="그룹 164"/>
                <p:cNvGrpSpPr/>
                <p:nvPr/>
              </p:nvGrpSpPr>
              <p:grpSpPr>
                <a:xfrm>
                  <a:off x="439679" y="2892400"/>
                  <a:ext cx="770065" cy="1083438"/>
                  <a:chOff x="589352" y="4851528"/>
                  <a:chExt cx="881602" cy="1233487"/>
                </a:xfrm>
              </p:grpSpPr>
              <p:sp>
                <p:nvSpPr>
                  <p:cNvPr id="166" name="TextBox 165"/>
                  <p:cNvSpPr txBox="1"/>
                  <p:nvPr/>
                </p:nvSpPr>
                <p:spPr>
                  <a:xfrm>
                    <a:off x="589352" y="4851528"/>
                    <a:ext cx="881602" cy="24587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10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ORC_016</a:t>
                    </a:r>
                    <a:endParaRPr kumimoji="0" lang="ko-KR" altLang="en-US" sz="10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67" name="TextBox 166"/>
                  <p:cNvSpPr txBox="1"/>
                  <p:nvPr/>
                </p:nvSpPr>
                <p:spPr>
                  <a:xfrm>
                    <a:off x="615724" y="5839145"/>
                    <a:ext cx="828862" cy="24587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10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O6-24/O</a:t>
                    </a:r>
                    <a:endParaRPr kumimoji="0" lang="ko-KR" altLang="en-US" sz="10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106" name="그룹 105"/>
              <p:cNvGrpSpPr/>
              <p:nvPr/>
            </p:nvGrpSpPr>
            <p:grpSpPr>
              <a:xfrm flipV="1">
                <a:off x="804040" y="5159185"/>
                <a:ext cx="717909" cy="71623"/>
                <a:chOff x="924249" y="1626614"/>
                <a:chExt cx="5944210" cy="181440"/>
              </a:xfrm>
            </p:grpSpPr>
            <p:cxnSp>
              <p:nvCxnSpPr>
                <p:cNvPr id="113" name="직선 연결선 112"/>
                <p:cNvCxnSpPr/>
                <p:nvPr/>
              </p:nvCxnSpPr>
              <p:spPr>
                <a:xfrm>
                  <a:off x="928459" y="1638214"/>
                  <a:ext cx="5940000" cy="0"/>
                </a:xfrm>
                <a:prstGeom prst="line">
                  <a:avLst/>
                </a:prstGeom>
                <a:noFill/>
                <a:ln w="190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  <p:cxnSp>
              <p:nvCxnSpPr>
                <p:cNvPr id="114" name="직선 연결선 113"/>
                <p:cNvCxnSpPr/>
                <p:nvPr/>
              </p:nvCxnSpPr>
              <p:spPr>
                <a:xfrm>
                  <a:off x="924249" y="1628054"/>
                  <a:ext cx="0" cy="180000"/>
                </a:xfrm>
                <a:prstGeom prst="line">
                  <a:avLst/>
                </a:prstGeom>
                <a:noFill/>
                <a:ln w="190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  <p:cxnSp>
              <p:nvCxnSpPr>
                <p:cNvPr id="115" name="직선 연결선 114"/>
                <p:cNvCxnSpPr/>
                <p:nvPr/>
              </p:nvCxnSpPr>
              <p:spPr>
                <a:xfrm>
                  <a:off x="6857988" y="1626614"/>
                  <a:ext cx="0" cy="180000"/>
                </a:xfrm>
                <a:prstGeom prst="line">
                  <a:avLst/>
                </a:prstGeom>
                <a:noFill/>
                <a:ln w="190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</p:grpSp>
          <p:sp>
            <p:nvSpPr>
              <p:cNvPr id="107" name="TextBox 106"/>
              <p:cNvSpPr txBox="1"/>
              <p:nvPr/>
            </p:nvSpPr>
            <p:spPr>
              <a:xfrm>
                <a:off x="692274" y="5276312"/>
                <a:ext cx="773983" cy="18228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CPS transport</a:t>
                </a:r>
                <a:endParaRPr kumimoji="0" lang="ko-KR" altLang="en-US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08" name="그룹 107"/>
              <p:cNvGrpSpPr/>
              <p:nvPr/>
            </p:nvGrpSpPr>
            <p:grpSpPr>
              <a:xfrm flipV="1">
                <a:off x="1549251" y="5157626"/>
                <a:ext cx="2716663" cy="72613"/>
                <a:chOff x="924249" y="1626614"/>
                <a:chExt cx="5944210" cy="181440"/>
              </a:xfrm>
            </p:grpSpPr>
            <p:cxnSp>
              <p:nvCxnSpPr>
                <p:cNvPr id="110" name="직선 연결선 109"/>
                <p:cNvCxnSpPr/>
                <p:nvPr/>
              </p:nvCxnSpPr>
              <p:spPr>
                <a:xfrm>
                  <a:off x="928459" y="1638214"/>
                  <a:ext cx="5940000" cy="0"/>
                </a:xfrm>
                <a:prstGeom prst="line">
                  <a:avLst/>
                </a:prstGeom>
                <a:noFill/>
                <a:ln w="190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  <p:cxnSp>
              <p:nvCxnSpPr>
                <p:cNvPr id="111" name="직선 연결선 110"/>
                <p:cNvCxnSpPr/>
                <p:nvPr/>
              </p:nvCxnSpPr>
              <p:spPr>
                <a:xfrm>
                  <a:off x="924249" y="1628054"/>
                  <a:ext cx="0" cy="180000"/>
                </a:xfrm>
                <a:prstGeom prst="line">
                  <a:avLst/>
                </a:prstGeom>
                <a:noFill/>
                <a:ln w="190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  <p:cxnSp>
              <p:nvCxnSpPr>
                <p:cNvPr id="112" name="직선 연결선 111"/>
                <p:cNvCxnSpPr/>
                <p:nvPr/>
              </p:nvCxnSpPr>
              <p:spPr>
                <a:xfrm>
                  <a:off x="6857988" y="1626614"/>
                  <a:ext cx="0" cy="180000"/>
                </a:xfrm>
                <a:prstGeom prst="line">
                  <a:avLst/>
                </a:prstGeom>
                <a:noFill/>
                <a:ln w="190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</p:grpSp>
          <p:sp>
            <p:nvSpPr>
              <p:cNvPr id="109" name="TextBox 108"/>
              <p:cNvSpPr txBox="1"/>
              <p:nvPr/>
            </p:nvSpPr>
            <p:spPr>
              <a:xfrm>
                <a:off x="2519273" y="5276312"/>
                <a:ext cx="792971" cy="18228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CPS synthesis</a:t>
                </a:r>
                <a:endParaRPr kumimoji="0" lang="ko-KR" altLang="en-US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04" name="TextBox 203"/>
            <p:cNvSpPr txBox="1"/>
            <p:nvPr/>
          </p:nvSpPr>
          <p:spPr>
            <a:xfrm>
              <a:off x="128088" y="1654918"/>
              <a:ext cx="37221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5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A)</a:t>
              </a:r>
              <a:endParaRPr lang="ko-KR" altLang="en-US" sz="105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" name="그룹 3"/>
          <p:cNvGrpSpPr/>
          <p:nvPr/>
        </p:nvGrpSpPr>
        <p:grpSpPr>
          <a:xfrm>
            <a:off x="6564372" y="1654918"/>
            <a:ext cx="5316825" cy="2122971"/>
            <a:chOff x="6564372" y="1654918"/>
            <a:chExt cx="5316825" cy="2122971"/>
          </a:xfrm>
        </p:grpSpPr>
        <p:grpSp>
          <p:nvGrpSpPr>
            <p:cNvPr id="240" name="그룹 239"/>
            <p:cNvGrpSpPr>
              <a:grpSpLocks noChangeAspect="1"/>
            </p:cNvGrpSpPr>
            <p:nvPr/>
          </p:nvGrpSpPr>
          <p:grpSpPr>
            <a:xfrm>
              <a:off x="6605579" y="1919644"/>
              <a:ext cx="5275618" cy="1858245"/>
              <a:chOff x="15473" y="4388033"/>
              <a:chExt cx="5344152" cy="1871945"/>
            </a:xfrm>
          </p:grpSpPr>
          <p:grpSp>
            <p:nvGrpSpPr>
              <p:cNvPr id="241" name="그룹 240"/>
              <p:cNvGrpSpPr>
                <a:grpSpLocks noChangeAspect="1"/>
              </p:cNvGrpSpPr>
              <p:nvPr/>
            </p:nvGrpSpPr>
            <p:grpSpPr>
              <a:xfrm>
                <a:off x="1666170" y="4388033"/>
                <a:ext cx="3693455" cy="1871945"/>
                <a:chOff x="1174564" y="2749459"/>
                <a:chExt cx="4516703" cy="2289190"/>
              </a:xfrm>
            </p:grpSpPr>
            <p:sp>
              <p:nvSpPr>
                <p:cNvPr id="245" name="사다리꼴 97"/>
                <p:cNvSpPr/>
                <p:nvPr/>
              </p:nvSpPr>
              <p:spPr>
                <a:xfrm>
                  <a:off x="1634337" y="3241863"/>
                  <a:ext cx="1432831" cy="1267279"/>
                </a:xfrm>
                <a:custGeom>
                  <a:avLst/>
                  <a:gdLst>
                    <a:gd name="connsiteX0" fmla="*/ 0 w 1551071"/>
                    <a:gd name="connsiteY0" fmla="*/ 1247615 h 1247615"/>
                    <a:gd name="connsiteX1" fmla="*/ 75930 w 1551071"/>
                    <a:gd name="connsiteY1" fmla="*/ 0 h 1247615"/>
                    <a:gd name="connsiteX2" fmla="*/ 1475141 w 1551071"/>
                    <a:gd name="connsiteY2" fmla="*/ 0 h 1247615"/>
                    <a:gd name="connsiteX3" fmla="*/ 1551071 w 1551071"/>
                    <a:gd name="connsiteY3" fmla="*/ 1247615 h 1247615"/>
                    <a:gd name="connsiteX4" fmla="*/ 0 w 1551071"/>
                    <a:gd name="connsiteY4" fmla="*/ 1247615 h 1247615"/>
                    <a:gd name="connsiteX0" fmla="*/ 91218 w 1642289"/>
                    <a:gd name="connsiteY0" fmla="*/ 1247615 h 1247615"/>
                    <a:gd name="connsiteX1" fmla="*/ 0 w 1642289"/>
                    <a:gd name="connsiteY1" fmla="*/ 0 h 1247615"/>
                    <a:gd name="connsiteX2" fmla="*/ 1566359 w 1642289"/>
                    <a:gd name="connsiteY2" fmla="*/ 0 h 1247615"/>
                    <a:gd name="connsiteX3" fmla="*/ 1642289 w 1642289"/>
                    <a:gd name="connsiteY3" fmla="*/ 1247615 h 1247615"/>
                    <a:gd name="connsiteX4" fmla="*/ 91218 w 1642289"/>
                    <a:gd name="connsiteY4" fmla="*/ 1247615 h 1247615"/>
                    <a:gd name="connsiteX0" fmla="*/ 91218 w 1642289"/>
                    <a:gd name="connsiteY0" fmla="*/ 1247615 h 1247615"/>
                    <a:gd name="connsiteX1" fmla="*/ 0 w 1642289"/>
                    <a:gd name="connsiteY1" fmla="*/ 0 h 1247615"/>
                    <a:gd name="connsiteX2" fmla="*/ 1556527 w 1642289"/>
                    <a:gd name="connsiteY2" fmla="*/ 0 h 1247615"/>
                    <a:gd name="connsiteX3" fmla="*/ 1642289 w 1642289"/>
                    <a:gd name="connsiteY3" fmla="*/ 1247615 h 1247615"/>
                    <a:gd name="connsiteX4" fmla="*/ 91218 w 1642289"/>
                    <a:gd name="connsiteY4" fmla="*/ 1247615 h 1247615"/>
                    <a:gd name="connsiteX0" fmla="*/ 71207 w 1642289"/>
                    <a:gd name="connsiteY0" fmla="*/ 1247615 h 1247615"/>
                    <a:gd name="connsiteX1" fmla="*/ 0 w 1642289"/>
                    <a:gd name="connsiteY1" fmla="*/ 0 h 1247615"/>
                    <a:gd name="connsiteX2" fmla="*/ 1556527 w 1642289"/>
                    <a:gd name="connsiteY2" fmla="*/ 0 h 1247615"/>
                    <a:gd name="connsiteX3" fmla="*/ 1642289 w 1642289"/>
                    <a:gd name="connsiteY3" fmla="*/ 1247615 h 1247615"/>
                    <a:gd name="connsiteX4" fmla="*/ 71207 w 1642289"/>
                    <a:gd name="connsiteY4" fmla="*/ 1247615 h 1247615"/>
                    <a:gd name="connsiteX0" fmla="*/ 17431 w 1642289"/>
                    <a:gd name="connsiteY0" fmla="*/ 1247615 h 1247615"/>
                    <a:gd name="connsiteX1" fmla="*/ 0 w 1642289"/>
                    <a:gd name="connsiteY1" fmla="*/ 0 h 1247615"/>
                    <a:gd name="connsiteX2" fmla="*/ 1556527 w 1642289"/>
                    <a:gd name="connsiteY2" fmla="*/ 0 h 1247615"/>
                    <a:gd name="connsiteX3" fmla="*/ 1642289 w 1642289"/>
                    <a:gd name="connsiteY3" fmla="*/ 1247615 h 1247615"/>
                    <a:gd name="connsiteX4" fmla="*/ 17431 w 1642289"/>
                    <a:gd name="connsiteY4" fmla="*/ 1247615 h 1247615"/>
                    <a:gd name="connsiteX0" fmla="*/ 17431 w 1588514"/>
                    <a:gd name="connsiteY0" fmla="*/ 1247615 h 1257447"/>
                    <a:gd name="connsiteX1" fmla="*/ 0 w 1588514"/>
                    <a:gd name="connsiteY1" fmla="*/ 0 h 1257447"/>
                    <a:gd name="connsiteX2" fmla="*/ 1556527 w 1588514"/>
                    <a:gd name="connsiteY2" fmla="*/ 0 h 1257447"/>
                    <a:gd name="connsiteX3" fmla="*/ 1588514 w 1588514"/>
                    <a:gd name="connsiteY3" fmla="*/ 1257447 h 1257447"/>
                    <a:gd name="connsiteX4" fmla="*/ 17431 w 1588514"/>
                    <a:gd name="connsiteY4" fmla="*/ 1247615 h 1257447"/>
                    <a:gd name="connsiteX0" fmla="*/ 17431 w 1556527"/>
                    <a:gd name="connsiteY0" fmla="*/ 1247615 h 1257447"/>
                    <a:gd name="connsiteX1" fmla="*/ 0 w 1556527"/>
                    <a:gd name="connsiteY1" fmla="*/ 0 h 1257447"/>
                    <a:gd name="connsiteX2" fmla="*/ 1556527 w 1556527"/>
                    <a:gd name="connsiteY2" fmla="*/ 0 h 1257447"/>
                    <a:gd name="connsiteX3" fmla="*/ 1556249 w 1556527"/>
                    <a:gd name="connsiteY3" fmla="*/ 1257447 h 1257447"/>
                    <a:gd name="connsiteX4" fmla="*/ 17431 w 1556527"/>
                    <a:gd name="connsiteY4" fmla="*/ 1247615 h 1257447"/>
                    <a:gd name="connsiteX0" fmla="*/ 38941 w 1556527"/>
                    <a:gd name="connsiteY0" fmla="*/ 1247615 h 1257447"/>
                    <a:gd name="connsiteX1" fmla="*/ 0 w 1556527"/>
                    <a:gd name="connsiteY1" fmla="*/ 0 h 1257447"/>
                    <a:gd name="connsiteX2" fmla="*/ 1556527 w 1556527"/>
                    <a:gd name="connsiteY2" fmla="*/ 0 h 1257447"/>
                    <a:gd name="connsiteX3" fmla="*/ 1556249 w 1556527"/>
                    <a:gd name="connsiteY3" fmla="*/ 1257447 h 1257447"/>
                    <a:gd name="connsiteX4" fmla="*/ 38941 w 1556527"/>
                    <a:gd name="connsiteY4" fmla="*/ 1247615 h 1257447"/>
                    <a:gd name="connsiteX0" fmla="*/ 38941 w 1567283"/>
                    <a:gd name="connsiteY0" fmla="*/ 1257447 h 1267279"/>
                    <a:gd name="connsiteX1" fmla="*/ 0 w 1567283"/>
                    <a:gd name="connsiteY1" fmla="*/ 9832 h 1267279"/>
                    <a:gd name="connsiteX2" fmla="*/ 1567283 w 1567283"/>
                    <a:gd name="connsiteY2" fmla="*/ 0 h 1267279"/>
                    <a:gd name="connsiteX3" fmla="*/ 1556249 w 1567283"/>
                    <a:gd name="connsiteY3" fmla="*/ 1267279 h 1267279"/>
                    <a:gd name="connsiteX4" fmla="*/ 38941 w 1567283"/>
                    <a:gd name="connsiteY4" fmla="*/ 1257447 h 1267279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567283" h="1267279">
                      <a:moveTo>
                        <a:pt x="38941" y="1257447"/>
                      </a:moveTo>
                      <a:lnTo>
                        <a:pt x="0" y="9832"/>
                      </a:lnTo>
                      <a:lnTo>
                        <a:pt x="1567283" y="0"/>
                      </a:lnTo>
                      <a:cubicBezTo>
                        <a:pt x="1567190" y="419149"/>
                        <a:pt x="1556342" y="848130"/>
                        <a:pt x="1556249" y="1267279"/>
                      </a:cubicBezTo>
                      <a:lnTo>
                        <a:pt x="38941" y="1257447"/>
                      </a:lnTo>
                      <a:close/>
                    </a:path>
                  </a:pathLst>
                </a:custGeom>
                <a:solidFill>
                  <a:srgbClr val="A5A5A5">
                    <a:lumMod val="20000"/>
                    <a:lumOff val="80000"/>
                  </a:srgbClr>
                </a:solidFill>
                <a:ln w="1270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ko-KR" altLang="en-US" sz="1400" b="0" i="0" u="none" strike="noStrike" kern="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6" name="사다리꼴 97"/>
                <p:cNvSpPr/>
                <p:nvPr/>
              </p:nvSpPr>
              <p:spPr>
                <a:xfrm>
                  <a:off x="1254663" y="3251695"/>
                  <a:ext cx="453205" cy="1247615"/>
                </a:xfrm>
                <a:custGeom>
                  <a:avLst/>
                  <a:gdLst>
                    <a:gd name="connsiteX0" fmla="*/ 0 w 1551071"/>
                    <a:gd name="connsiteY0" fmla="*/ 1247615 h 1247615"/>
                    <a:gd name="connsiteX1" fmla="*/ 75930 w 1551071"/>
                    <a:gd name="connsiteY1" fmla="*/ 0 h 1247615"/>
                    <a:gd name="connsiteX2" fmla="*/ 1475141 w 1551071"/>
                    <a:gd name="connsiteY2" fmla="*/ 0 h 1247615"/>
                    <a:gd name="connsiteX3" fmla="*/ 1551071 w 1551071"/>
                    <a:gd name="connsiteY3" fmla="*/ 1247615 h 1247615"/>
                    <a:gd name="connsiteX4" fmla="*/ 0 w 1551071"/>
                    <a:gd name="connsiteY4" fmla="*/ 1247615 h 1247615"/>
                    <a:gd name="connsiteX0" fmla="*/ 91218 w 1642289"/>
                    <a:gd name="connsiteY0" fmla="*/ 1247615 h 1247615"/>
                    <a:gd name="connsiteX1" fmla="*/ 0 w 1642289"/>
                    <a:gd name="connsiteY1" fmla="*/ 0 h 1247615"/>
                    <a:gd name="connsiteX2" fmla="*/ 1566359 w 1642289"/>
                    <a:gd name="connsiteY2" fmla="*/ 0 h 1247615"/>
                    <a:gd name="connsiteX3" fmla="*/ 1642289 w 1642289"/>
                    <a:gd name="connsiteY3" fmla="*/ 1247615 h 1247615"/>
                    <a:gd name="connsiteX4" fmla="*/ 91218 w 1642289"/>
                    <a:gd name="connsiteY4" fmla="*/ 1247615 h 1247615"/>
                    <a:gd name="connsiteX0" fmla="*/ 91218 w 1642289"/>
                    <a:gd name="connsiteY0" fmla="*/ 1247615 h 1247615"/>
                    <a:gd name="connsiteX1" fmla="*/ 0 w 1642289"/>
                    <a:gd name="connsiteY1" fmla="*/ 0 h 1247615"/>
                    <a:gd name="connsiteX2" fmla="*/ 1556527 w 1642289"/>
                    <a:gd name="connsiteY2" fmla="*/ 0 h 1247615"/>
                    <a:gd name="connsiteX3" fmla="*/ 1642289 w 1642289"/>
                    <a:gd name="connsiteY3" fmla="*/ 1247615 h 1247615"/>
                    <a:gd name="connsiteX4" fmla="*/ 91218 w 1642289"/>
                    <a:gd name="connsiteY4" fmla="*/ 1247615 h 1247615"/>
                    <a:gd name="connsiteX0" fmla="*/ 71207 w 1642289"/>
                    <a:gd name="connsiteY0" fmla="*/ 1247615 h 1247615"/>
                    <a:gd name="connsiteX1" fmla="*/ 0 w 1642289"/>
                    <a:gd name="connsiteY1" fmla="*/ 0 h 1247615"/>
                    <a:gd name="connsiteX2" fmla="*/ 1556527 w 1642289"/>
                    <a:gd name="connsiteY2" fmla="*/ 0 h 1247615"/>
                    <a:gd name="connsiteX3" fmla="*/ 1642289 w 1642289"/>
                    <a:gd name="connsiteY3" fmla="*/ 1247615 h 1247615"/>
                    <a:gd name="connsiteX4" fmla="*/ 71207 w 1642289"/>
                    <a:gd name="connsiteY4" fmla="*/ 1247615 h 1247615"/>
                    <a:gd name="connsiteX0" fmla="*/ 17431 w 1642289"/>
                    <a:gd name="connsiteY0" fmla="*/ 1247615 h 1247615"/>
                    <a:gd name="connsiteX1" fmla="*/ 0 w 1642289"/>
                    <a:gd name="connsiteY1" fmla="*/ 0 h 1247615"/>
                    <a:gd name="connsiteX2" fmla="*/ 1556527 w 1642289"/>
                    <a:gd name="connsiteY2" fmla="*/ 0 h 1247615"/>
                    <a:gd name="connsiteX3" fmla="*/ 1642289 w 1642289"/>
                    <a:gd name="connsiteY3" fmla="*/ 1247615 h 1247615"/>
                    <a:gd name="connsiteX4" fmla="*/ 17431 w 1642289"/>
                    <a:gd name="connsiteY4" fmla="*/ 1247615 h 1247615"/>
                    <a:gd name="connsiteX0" fmla="*/ 17431 w 1588514"/>
                    <a:gd name="connsiteY0" fmla="*/ 1247615 h 1257447"/>
                    <a:gd name="connsiteX1" fmla="*/ 0 w 1588514"/>
                    <a:gd name="connsiteY1" fmla="*/ 0 h 1257447"/>
                    <a:gd name="connsiteX2" fmla="*/ 1556527 w 1588514"/>
                    <a:gd name="connsiteY2" fmla="*/ 0 h 1257447"/>
                    <a:gd name="connsiteX3" fmla="*/ 1588514 w 1588514"/>
                    <a:gd name="connsiteY3" fmla="*/ 1257447 h 1257447"/>
                    <a:gd name="connsiteX4" fmla="*/ 17431 w 1588514"/>
                    <a:gd name="connsiteY4" fmla="*/ 1247615 h 1257447"/>
                    <a:gd name="connsiteX0" fmla="*/ 17431 w 1556527"/>
                    <a:gd name="connsiteY0" fmla="*/ 1247615 h 1257447"/>
                    <a:gd name="connsiteX1" fmla="*/ 0 w 1556527"/>
                    <a:gd name="connsiteY1" fmla="*/ 0 h 1257447"/>
                    <a:gd name="connsiteX2" fmla="*/ 1556527 w 1556527"/>
                    <a:gd name="connsiteY2" fmla="*/ 0 h 1257447"/>
                    <a:gd name="connsiteX3" fmla="*/ 1556249 w 1556527"/>
                    <a:gd name="connsiteY3" fmla="*/ 1257447 h 1257447"/>
                    <a:gd name="connsiteX4" fmla="*/ 17431 w 1556527"/>
                    <a:gd name="connsiteY4" fmla="*/ 1247615 h 1257447"/>
                    <a:gd name="connsiteX0" fmla="*/ 38941 w 1556527"/>
                    <a:gd name="connsiteY0" fmla="*/ 1247615 h 1257447"/>
                    <a:gd name="connsiteX1" fmla="*/ 0 w 1556527"/>
                    <a:gd name="connsiteY1" fmla="*/ 0 h 1257447"/>
                    <a:gd name="connsiteX2" fmla="*/ 1556527 w 1556527"/>
                    <a:gd name="connsiteY2" fmla="*/ 0 h 1257447"/>
                    <a:gd name="connsiteX3" fmla="*/ 1556249 w 1556527"/>
                    <a:gd name="connsiteY3" fmla="*/ 1257447 h 1257447"/>
                    <a:gd name="connsiteX4" fmla="*/ 38941 w 1556527"/>
                    <a:gd name="connsiteY4" fmla="*/ 1247615 h 1257447"/>
                    <a:gd name="connsiteX0" fmla="*/ 38941 w 1567283"/>
                    <a:gd name="connsiteY0" fmla="*/ 1257447 h 1267279"/>
                    <a:gd name="connsiteX1" fmla="*/ 0 w 1567283"/>
                    <a:gd name="connsiteY1" fmla="*/ 9832 h 1267279"/>
                    <a:gd name="connsiteX2" fmla="*/ 1567283 w 1567283"/>
                    <a:gd name="connsiteY2" fmla="*/ 0 h 1267279"/>
                    <a:gd name="connsiteX3" fmla="*/ 1556249 w 1567283"/>
                    <a:gd name="connsiteY3" fmla="*/ 1267279 h 1267279"/>
                    <a:gd name="connsiteX4" fmla="*/ 38941 w 1567283"/>
                    <a:gd name="connsiteY4" fmla="*/ 1257447 h 1267279"/>
                    <a:gd name="connsiteX0" fmla="*/ 38941 w 1762710"/>
                    <a:gd name="connsiteY0" fmla="*/ 1257447 h 1257447"/>
                    <a:gd name="connsiteX1" fmla="*/ 0 w 1762710"/>
                    <a:gd name="connsiteY1" fmla="*/ 9832 h 1257447"/>
                    <a:gd name="connsiteX2" fmla="*/ 1567283 w 1762710"/>
                    <a:gd name="connsiteY2" fmla="*/ 0 h 1257447"/>
                    <a:gd name="connsiteX3" fmla="*/ 1762710 w 1762710"/>
                    <a:gd name="connsiteY3" fmla="*/ 1257447 h 1257447"/>
                    <a:gd name="connsiteX4" fmla="*/ 38941 w 1762710"/>
                    <a:gd name="connsiteY4" fmla="*/ 1257447 h 1257447"/>
                    <a:gd name="connsiteX0" fmla="*/ 215904 w 1762710"/>
                    <a:gd name="connsiteY0" fmla="*/ 1257447 h 1257447"/>
                    <a:gd name="connsiteX1" fmla="*/ 0 w 1762710"/>
                    <a:gd name="connsiteY1" fmla="*/ 9832 h 1257447"/>
                    <a:gd name="connsiteX2" fmla="*/ 1567283 w 1762710"/>
                    <a:gd name="connsiteY2" fmla="*/ 0 h 1257447"/>
                    <a:gd name="connsiteX3" fmla="*/ 1762710 w 1762710"/>
                    <a:gd name="connsiteY3" fmla="*/ 1257447 h 1257447"/>
                    <a:gd name="connsiteX4" fmla="*/ 215904 w 1762710"/>
                    <a:gd name="connsiteY4" fmla="*/ 1257447 h 1257447"/>
                    <a:gd name="connsiteX0" fmla="*/ 215904 w 1762710"/>
                    <a:gd name="connsiteY0" fmla="*/ 1247615 h 1247615"/>
                    <a:gd name="connsiteX1" fmla="*/ 0 w 1762710"/>
                    <a:gd name="connsiteY1" fmla="*/ 0 h 1247615"/>
                    <a:gd name="connsiteX2" fmla="*/ 1626270 w 1762710"/>
                    <a:gd name="connsiteY2" fmla="*/ 1 h 1247615"/>
                    <a:gd name="connsiteX3" fmla="*/ 1762710 w 1762710"/>
                    <a:gd name="connsiteY3" fmla="*/ 1247615 h 1247615"/>
                    <a:gd name="connsiteX4" fmla="*/ 215904 w 1762710"/>
                    <a:gd name="connsiteY4" fmla="*/ 1247615 h 1247615"/>
                    <a:gd name="connsiteX0" fmla="*/ 113228 w 1762710"/>
                    <a:gd name="connsiteY0" fmla="*/ 1247615 h 1247615"/>
                    <a:gd name="connsiteX1" fmla="*/ 0 w 1762710"/>
                    <a:gd name="connsiteY1" fmla="*/ 0 h 1247615"/>
                    <a:gd name="connsiteX2" fmla="*/ 1626270 w 1762710"/>
                    <a:gd name="connsiteY2" fmla="*/ 1 h 1247615"/>
                    <a:gd name="connsiteX3" fmla="*/ 1762710 w 1762710"/>
                    <a:gd name="connsiteY3" fmla="*/ 1247615 h 1247615"/>
                    <a:gd name="connsiteX4" fmla="*/ 113228 w 1762710"/>
                    <a:gd name="connsiteY4" fmla="*/ 1247615 h 124761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762710" h="1247615">
                      <a:moveTo>
                        <a:pt x="113228" y="1247615"/>
                      </a:moveTo>
                      <a:lnTo>
                        <a:pt x="0" y="0"/>
                      </a:lnTo>
                      <a:lnTo>
                        <a:pt x="1626270" y="1"/>
                      </a:lnTo>
                      <a:cubicBezTo>
                        <a:pt x="1626177" y="419150"/>
                        <a:pt x="1762803" y="828466"/>
                        <a:pt x="1762710" y="1247615"/>
                      </a:cubicBezTo>
                      <a:lnTo>
                        <a:pt x="113228" y="1247615"/>
                      </a:lnTo>
                      <a:close/>
                    </a:path>
                  </a:pathLst>
                </a:custGeom>
                <a:solidFill>
                  <a:srgbClr val="A5A5A5">
                    <a:lumMod val="20000"/>
                    <a:lumOff val="80000"/>
                  </a:srgbClr>
                </a:solidFill>
                <a:ln w="1270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ko-KR" altLang="en-US" sz="1400" b="0" i="0" u="none" strike="noStrike" kern="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7" name="사다리꼴 97"/>
                <p:cNvSpPr/>
                <p:nvPr/>
              </p:nvSpPr>
              <p:spPr>
                <a:xfrm>
                  <a:off x="4965020" y="3251695"/>
                  <a:ext cx="587620" cy="1247615"/>
                </a:xfrm>
                <a:custGeom>
                  <a:avLst/>
                  <a:gdLst>
                    <a:gd name="connsiteX0" fmla="*/ 0 w 1551071"/>
                    <a:gd name="connsiteY0" fmla="*/ 1247615 h 1247615"/>
                    <a:gd name="connsiteX1" fmla="*/ 75930 w 1551071"/>
                    <a:gd name="connsiteY1" fmla="*/ 0 h 1247615"/>
                    <a:gd name="connsiteX2" fmla="*/ 1475141 w 1551071"/>
                    <a:gd name="connsiteY2" fmla="*/ 0 h 1247615"/>
                    <a:gd name="connsiteX3" fmla="*/ 1551071 w 1551071"/>
                    <a:gd name="connsiteY3" fmla="*/ 1247615 h 1247615"/>
                    <a:gd name="connsiteX4" fmla="*/ 0 w 1551071"/>
                    <a:gd name="connsiteY4" fmla="*/ 1247615 h 1247615"/>
                    <a:gd name="connsiteX0" fmla="*/ 91218 w 1642289"/>
                    <a:gd name="connsiteY0" fmla="*/ 1247615 h 1247615"/>
                    <a:gd name="connsiteX1" fmla="*/ 0 w 1642289"/>
                    <a:gd name="connsiteY1" fmla="*/ 0 h 1247615"/>
                    <a:gd name="connsiteX2" fmla="*/ 1566359 w 1642289"/>
                    <a:gd name="connsiteY2" fmla="*/ 0 h 1247615"/>
                    <a:gd name="connsiteX3" fmla="*/ 1642289 w 1642289"/>
                    <a:gd name="connsiteY3" fmla="*/ 1247615 h 1247615"/>
                    <a:gd name="connsiteX4" fmla="*/ 91218 w 1642289"/>
                    <a:gd name="connsiteY4" fmla="*/ 1247615 h 1247615"/>
                    <a:gd name="connsiteX0" fmla="*/ 91218 w 1642289"/>
                    <a:gd name="connsiteY0" fmla="*/ 1247615 h 1247615"/>
                    <a:gd name="connsiteX1" fmla="*/ 0 w 1642289"/>
                    <a:gd name="connsiteY1" fmla="*/ 0 h 1247615"/>
                    <a:gd name="connsiteX2" fmla="*/ 1556527 w 1642289"/>
                    <a:gd name="connsiteY2" fmla="*/ 0 h 1247615"/>
                    <a:gd name="connsiteX3" fmla="*/ 1642289 w 1642289"/>
                    <a:gd name="connsiteY3" fmla="*/ 1247615 h 1247615"/>
                    <a:gd name="connsiteX4" fmla="*/ 91218 w 1642289"/>
                    <a:gd name="connsiteY4" fmla="*/ 1247615 h 1247615"/>
                    <a:gd name="connsiteX0" fmla="*/ 71207 w 1642289"/>
                    <a:gd name="connsiteY0" fmla="*/ 1247615 h 1247615"/>
                    <a:gd name="connsiteX1" fmla="*/ 0 w 1642289"/>
                    <a:gd name="connsiteY1" fmla="*/ 0 h 1247615"/>
                    <a:gd name="connsiteX2" fmla="*/ 1556527 w 1642289"/>
                    <a:gd name="connsiteY2" fmla="*/ 0 h 1247615"/>
                    <a:gd name="connsiteX3" fmla="*/ 1642289 w 1642289"/>
                    <a:gd name="connsiteY3" fmla="*/ 1247615 h 1247615"/>
                    <a:gd name="connsiteX4" fmla="*/ 71207 w 1642289"/>
                    <a:gd name="connsiteY4" fmla="*/ 1247615 h 1247615"/>
                    <a:gd name="connsiteX0" fmla="*/ 17431 w 1642289"/>
                    <a:gd name="connsiteY0" fmla="*/ 1247615 h 1247615"/>
                    <a:gd name="connsiteX1" fmla="*/ 0 w 1642289"/>
                    <a:gd name="connsiteY1" fmla="*/ 0 h 1247615"/>
                    <a:gd name="connsiteX2" fmla="*/ 1556527 w 1642289"/>
                    <a:gd name="connsiteY2" fmla="*/ 0 h 1247615"/>
                    <a:gd name="connsiteX3" fmla="*/ 1642289 w 1642289"/>
                    <a:gd name="connsiteY3" fmla="*/ 1247615 h 1247615"/>
                    <a:gd name="connsiteX4" fmla="*/ 17431 w 1642289"/>
                    <a:gd name="connsiteY4" fmla="*/ 1247615 h 1247615"/>
                    <a:gd name="connsiteX0" fmla="*/ 17431 w 1588514"/>
                    <a:gd name="connsiteY0" fmla="*/ 1247615 h 1257447"/>
                    <a:gd name="connsiteX1" fmla="*/ 0 w 1588514"/>
                    <a:gd name="connsiteY1" fmla="*/ 0 h 1257447"/>
                    <a:gd name="connsiteX2" fmla="*/ 1556527 w 1588514"/>
                    <a:gd name="connsiteY2" fmla="*/ 0 h 1257447"/>
                    <a:gd name="connsiteX3" fmla="*/ 1588514 w 1588514"/>
                    <a:gd name="connsiteY3" fmla="*/ 1257447 h 1257447"/>
                    <a:gd name="connsiteX4" fmla="*/ 17431 w 1588514"/>
                    <a:gd name="connsiteY4" fmla="*/ 1247615 h 1257447"/>
                    <a:gd name="connsiteX0" fmla="*/ 17431 w 1556527"/>
                    <a:gd name="connsiteY0" fmla="*/ 1247615 h 1257447"/>
                    <a:gd name="connsiteX1" fmla="*/ 0 w 1556527"/>
                    <a:gd name="connsiteY1" fmla="*/ 0 h 1257447"/>
                    <a:gd name="connsiteX2" fmla="*/ 1556527 w 1556527"/>
                    <a:gd name="connsiteY2" fmla="*/ 0 h 1257447"/>
                    <a:gd name="connsiteX3" fmla="*/ 1556249 w 1556527"/>
                    <a:gd name="connsiteY3" fmla="*/ 1257447 h 1257447"/>
                    <a:gd name="connsiteX4" fmla="*/ 17431 w 1556527"/>
                    <a:gd name="connsiteY4" fmla="*/ 1247615 h 1257447"/>
                    <a:gd name="connsiteX0" fmla="*/ 38941 w 1556527"/>
                    <a:gd name="connsiteY0" fmla="*/ 1247615 h 1257447"/>
                    <a:gd name="connsiteX1" fmla="*/ 0 w 1556527"/>
                    <a:gd name="connsiteY1" fmla="*/ 0 h 1257447"/>
                    <a:gd name="connsiteX2" fmla="*/ 1556527 w 1556527"/>
                    <a:gd name="connsiteY2" fmla="*/ 0 h 1257447"/>
                    <a:gd name="connsiteX3" fmla="*/ 1556249 w 1556527"/>
                    <a:gd name="connsiteY3" fmla="*/ 1257447 h 1257447"/>
                    <a:gd name="connsiteX4" fmla="*/ 38941 w 1556527"/>
                    <a:gd name="connsiteY4" fmla="*/ 1247615 h 1257447"/>
                    <a:gd name="connsiteX0" fmla="*/ 38941 w 1567283"/>
                    <a:gd name="connsiteY0" fmla="*/ 1257447 h 1267279"/>
                    <a:gd name="connsiteX1" fmla="*/ 0 w 1567283"/>
                    <a:gd name="connsiteY1" fmla="*/ 9832 h 1267279"/>
                    <a:gd name="connsiteX2" fmla="*/ 1567283 w 1567283"/>
                    <a:gd name="connsiteY2" fmla="*/ 0 h 1267279"/>
                    <a:gd name="connsiteX3" fmla="*/ 1556249 w 1567283"/>
                    <a:gd name="connsiteY3" fmla="*/ 1267279 h 1267279"/>
                    <a:gd name="connsiteX4" fmla="*/ 38941 w 1567283"/>
                    <a:gd name="connsiteY4" fmla="*/ 1257447 h 1267279"/>
                    <a:gd name="connsiteX0" fmla="*/ 38941 w 1762710"/>
                    <a:gd name="connsiteY0" fmla="*/ 1257447 h 1257447"/>
                    <a:gd name="connsiteX1" fmla="*/ 0 w 1762710"/>
                    <a:gd name="connsiteY1" fmla="*/ 9832 h 1257447"/>
                    <a:gd name="connsiteX2" fmla="*/ 1567283 w 1762710"/>
                    <a:gd name="connsiteY2" fmla="*/ 0 h 1257447"/>
                    <a:gd name="connsiteX3" fmla="*/ 1762710 w 1762710"/>
                    <a:gd name="connsiteY3" fmla="*/ 1257447 h 1257447"/>
                    <a:gd name="connsiteX4" fmla="*/ 38941 w 1762710"/>
                    <a:gd name="connsiteY4" fmla="*/ 1257447 h 1257447"/>
                    <a:gd name="connsiteX0" fmla="*/ 215904 w 1762710"/>
                    <a:gd name="connsiteY0" fmla="*/ 1257447 h 1257447"/>
                    <a:gd name="connsiteX1" fmla="*/ 0 w 1762710"/>
                    <a:gd name="connsiteY1" fmla="*/ 9832 h 1257447"/>
                    <a:gd name="connsiteX2" fmla="*/ 1567283 w 1762710"/>
                    <a:gd name="connsiteY2" fmla="*/ 0 h 1257447"/>
                    <a:gd name="connsiteX3" fmla="*/ 1762710 w 1762710"/>
                    <a:gd name="connsiteY3" fmla="*/ 1257447 h 1257447"/>
                    <a:gd name="connsiteX4" fmla="*/ 215904 w 1762710"/>
                    <a:gd name="connsiteY4" fmla="*/ 1257447 h 1257447"/>
                    <a:gd name="connsiteX0" fmla="*/ 215904 w 1762710"/>
                    <a:gd name="connsiteY0" fmla="*/ 1247615 h 1247615"/>
                    <a:gd name="connsiteX1" fmla="*/ 0 w 1762710"/>
                    <a:gd name="connsiteY1" fmla="*/ 0 h 1247615"/>
                    <a:gd name="connsiteX2" fmla="*/ 1626270 w 1762710"/>
                    <a:gd name="connsiteY2" fmla="*/ 1 h 1247615"/>
                    <a:gd name="connsiteX3" fmla="*/ 1762710 w 1762710"/>
                    <a:gd name="connsiteY3" fmla="*/ 1247615 h 1247615"/>
                    <a:gd name="connsiteX4" fmla="*/ 215904 w 1762710"/>
                    <a:gd name="connsiteY4" fmla="*/ 1247615 h 124761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762710" h="1247615">
                      <a:moveTo>
                        <a:pt x="215904" y="1247615"/>
                      </a:moveTo>
                      <a:lnTo>
                        <a:pt x="0" y="0"/>
                      </a:lnTo>
                      <a:lnTo>
                        <a:pt x="1626270" y="1"/>
                      </a:lnTo>
                      <a:cubicBezTo>
                        <a:pt x="1626177" y="419150"/>
                        <a:pt x="1762803" y="828466"/>
                        <a:pt x="1762710" y="1247615"/>
                      </a:cubicBezTo>
                      <a:lnTo>
                        <a:pt x="215904" y="1247615"/>
                      </a:lnTo>
                      <a:close/>
                    </a:path>
                  </a:pathLst>
                </a:custGeom>
                <a:solidFill>
                  <a:srgbClr val="A5A5A5">
                    <a:lumMod val="20000"/>
                    <a:lumOff val="80000"/>
                  </a:srgbClr>
                </a:solidFill>
                <a:ln w="1270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ko-KR" altLang="en-US" sz="1400" b="0" i="0" u="none" strike="noStrike" kern="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8" name="사다리꼴 97"/>
                <p:cNvSpPr/>
                <p:nvPr/>
              </p:nvSpPr>
              <p:spPr>
                <a:xfrm>
                  <a:off x="3281377" y="3251695"/>
                  <a:ext cx="1613875" cy="1247615"/>
                </a:xfrm>
                <a:custGeom>
                  <a:avLst/>
                  <a:gdLst>
                    <a:gd name="connsiteX0" fmla="*/ 0 w 1551071"/>
                    <a:gd name="connsiteY0" fmla="*/ 1247615 h 1247615"/>
                    <a:gd name="connsiteX1" fmla="*/ 75930 w 1551071"/>
                    <a:gd name="connsiteY1" fmla="*/ 0 h 1247615"/>
                    <a:gd name="connsiteX2" fmla="*/ 1475141 w 1551071"/>
                    <a:gd name="connsiteY2" fmla="*/ 0 h 1247615"/>
                    <a:gd name="connsiteX3" fmla="*/ 1551071 w 1551071"/>
                    <a:gd name="connsiteY3" fmla="*/ 1247615 h 1247615"/>
                    <a:gd name="connsiteX4" fmla="*/ 0 w 1551071"/>
                    <a:gd name="connsiteY4" fmla="*/ 1247615 h 1247615"/>
                    <a:gd name="connsiteX0" fmla="*/ 91218 w 1642289"/>
                    <a:gd name="connsiteY0" fmla="*/ 1247615 h 1247615"/>
                    <a:gd name="connsiteX1" fmla="*/ 0 w 1642289"/>
                    <a:gd name="connsiteY1" fmla="*/ 0 h 1247615"/>
                    <a:gd name="connsiteX2" fmla="*/ 1566359 w 1642289"/>
                    <a:gd name="connsiteY2" fmla="*/ 0 h 1247615"/>
                    <a:gd name="connsiteX3" fmla="*/ 1642289 w 1642289"/>
                    <a:gd name="connsiteY3" fmla="*/ 1247615 h 1247615"/>
                    <a:gd name="connsiteX4" fmla="*/ 91218 w 1642289"/>
                    <a:gd name="connsiteY4" fmla="*/ 1247615 h 1247615"/>
                    <a:gd name="connsiteX0" fmla="*/ 91218 w 1642289"/>
                    <a:gd name="connsiteY0" fmla="*/ 1247615 h 1247615"/>
                    <a:gd name="connsiteX1" fmla="*/ 0 w 1642289"/>
                    <a:gd name="connsiteY1" fmla="*/ 0 h 1247615"/>
                    <a:gd name="connsiteX2" fmla="*/ 1556527 w 1642289"/>
                    <a:gd name="connsiteY2" fmla="*/ 0 h 1247615"/>
                    <a:gd name="connsiteX3" fmla="*/ 1642289 w 1642289"/>
                    <a:gd name="connsiteY3" fmla="*/ 1247615 h 1247615"/>
                    <a:gd name="connsiteX4" fmla="*/ 91218 w 1642289"/>
                    <a:gd name="connsiteY4" fmla="*/ 1247615 h 1247615"/>
                    <a:gd name="connsiteX0" fmla="*/ 71207 w 1642289"/>
                    <a:gd name="connsiteY0" fmla="*/ 1247615 h 1247615"/>
                    <a:gd name="connsiteX1" fmla="*/ 0 w 1642289"/>
                    <a:gd name="connsiteY1" fmla="*/ 0 h 1247615"/>
                    <a:gd name="connsiteX2" fmla="*/ 1556527 w 1642289"/>
                    <a:gd name="connsiteY2" fmla="*/ 0 h 1247615"/>
                    <a:gd name="connsiteX3" fmla="*/ 1642289 w 1642289"/>
                    <a:gd name="connsiteY3" fmla="*/ 1247615 h 1247615"/>
                    <a:gd name="connsiteX4" fmla="*/ 71207 w 1642289"/>
                    <a:gd name="connsiteY4" fmla="*/ 1247615 h 124761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642289" h="1247615">
                      <a:moveTo>
                        <a:pt x="71207" y="1247615"/>
                      </a:moveTo>
                      <a:lnTo>
                        <a:pt x="0" y="0"/>
                      </a:lnTo>
                      <a:lnTo>
                        <a:pt x="1556527" y="0"/>
                      </a:lnTo>
                      <a:lnTo>
                        <a:pt x="1642289" y="1247615"/>
                      </a:lnTo>
                      <a:lnTo>
                        <a:pt x="71207" y="1247615"/>
                      </a:lnTo>
                      <a:close/>
                    </a:path>
                  </a:pathLst>
                </a:custGeom>
                <a:solidFill>
                  <a:srgbClr val="70AD47">
                    <a:lumMod val="20000"/>
                    <a:lumOff val="80000"/>
                  </a:srgbClr>
                </a:solidFill>
                <a:ln w="1270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ko-KR" altLang="en-US" sz="1400" b="0" i="0" u="none" strike="noStrike" kern="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249" name="그룹 248"/>
                <p:cNvGrpSpPr/>
                <p:nvPr/>
              </p:nvGrpSpPr>
              <p:grpSpPr>
                <a:xfrm>
                  <a:off x="1174564" y="2749459"/>
                  <a:ext cx="4417293" cy="756937"/>
                  <a:chOff x="5689233" y="953936"/>
                  <a:chExt cx="4417293" cy="756937"/>
                </a:xfrm>
              </p:grpSpPr>
              <p:cxnSp>
                <p:nvCxnSpPr>
                  <p:cNvPr id="265" name="직선 연결선 264"/>
                  <p:cNvCxnSpPr/>
                  <p:nvPr/>
                </p:nvCxnSpPr>
                <p:spPr>
                  <a:xfrm>
                    <a:off x="5689358" y="1469161"/>
                    <a:ext cx="4417168" cy="2160"/>
                  </a:xfrm>
                  <a:prstGeom prst="line">
                    <a:avLst/>
                  </a:prstGeom>
                  <a:noFill/>
                  <a:ln w="190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  <p:sp>
                <p:nvSpPr>
                  <p:cNvPr id="266" name="오른쪽 화살표 265"/>
                  <p:cNvSpPr/>
                  <p:nvPr/>
                </p:nvSpPr>
                <p:spPr>
                  <a:xfrm>
                    <a:off x="9477030" y="1229610"/>
                    <a:ext cx="540000" cy="481263"/>
                  </a:xfrm>
                  <a:prstGeom prst="rightArrow">
                    <a:avLst/>
                  </a:prstGeom>
                  <a:solidFill>
                    <a:sysClr val="window" lastClr="FFFFFF"/>
                  </a:solidFill>
                  <a:ln w="190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0" lang="ko-KR" altLang="en-US" sz="1400" b="0" i="0" u="none" strike="noStrike" kern="0" cap="none" spc="0" normalizeH="0" baseline="0" noProof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67" name="오른쪽 화살표 266"/>
                  <p:cNvSpPr/>
                  <p:nvPr/>
                </p:nvSpPr>
                <p:spPr>
                  <a:xfrm flipH="1">
                    <a:off x="7796046" y="1229610"/>
                    <a:ext cx="1530000" cy="481263"/>
                  </a:xfrm>
                  <a:prstGeom prst="rightArrow">
                    <a:avLst/>
                  </a:prstGeom>
                  <a:solidFill>
                    <a:srgbClr val="FFC000"/>
                  </a:solidFill>
                  <a:ln w="190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0" lang="ko-KR" altLang="en-US" sz="1400" b="0" i="0" u="none" strike="noStrike" kern="0" cap="none" spc="0" normalizeH="0" baseline="0" noProof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68" name="오른쪽 화살표 267"/>
                  <p:cNvSpPr/>
                  <p:nvPr/>
                </p:nvSpPr>
                <p:spPr>
                  <a:xfrm>
                    <a:off x="6155743" y="1229610"/>
                    <a:ext cx="1440000" cy="481263"/>
                  </a:xfrm>
                  <a:prstGeom prst="rightArrow">
                    <a:avLst/>
                  </a:prstGeom>
                  <a:solidFill>
                    <a:sysClr val="window" lastClr="FFFFFF"/>
                  </a:solidFill>
                  <a:ln w="190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14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rPr>
                      <a:t>‘</a:t>
                    </a:r>
                    <a:endParaRPr kumimoji="0" lang="ko-KR" altLang="en-US" sz="14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69" name="오른쪽 화살표 268"/>
                  <p:cNvSpPr/>
                  <p:nvPr/>
                </p:nvSpPr>
                <p:spPr>
                  <a:xfrm>
                    <a:off x="5784468" y="1229610"/>
                    <a:ext cx="450000" cy="481263"/>
                  </a:xfrm>
                  <a:prstGeom prst="rightArrow">
                    <a:avLst/>
                  </a:prstGeom>
                  <a:solidFill>
                    <a:sysClr val="window" lastClr="FFFFFF"/>
                  </a:solidFill>
                  <a:ln w="190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14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rPr>
                      <a:t>‘</a:t>
                    </a:r>
                    <a:endParaRPr kumimoji="0" lang="ko-KR" altLang="en-US" sz="14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70" name="TextBox 269"/>
                  <p:cNvSpPr txBox="1"/>
                  <p:nvPr/>
                </p:nvSpPr>
                <p:spPr>
                  <a:xfrm>
                    <a:off x="5689233" y="953936"/>
                    <a:ext cx="514711" cy="26540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8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703</a:t>
                    </a:r>
                    <a:endParaRPr kumimoji="0" lang="ko-KR" altLang="en-US" sz="8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71" name="TextBox 270"/>
                  <p:cNvSpPr txBox="1"/>
                  <p:nvPr/>
                </p:nvSpPr>
                <p:spPr>
                  <a:xfrm>
                    <a:off x="6522936" y="953936"/>
                    <a:ext cx="514711" cy="26540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8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704</a:t>
                    </a:r>
                    <a:endParaRPr kumimoji="0" lang="ko-KR" altLang="en-US" sz="8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72" name="TextBox 271"/>
                  <p:cNvSpPr txBox="1"/>
                  <p:nvPr/>
                </p:nvSpPr>
                <p:spPr>
                  <a:xfrm>
                    <a:off x="8407568" y="953936"/>
                    <a:ext cx="514711" cy="26540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8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705</a:t>
                    </a:r>
                    <a:endParaRPr kumimoji="0" lang="ko-KR" altLang="en-US" sz="8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73" name="TextBox 272"/>
                  <p:cNvSpPr txBox="1"/>
                  <p:nvPr/>
                </p:nvSpPr>
                <p:spPr>
                  <a:xfrm>
                    <a:off x="9386043" y="953936"/>
                    <a:ext cx="514711" cy="26540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8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706</a:t>
                    </a:r>
                    <a:endParaRPr kumimoji="0" lang="ko-KR" altLang="en-US" sz="8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74" name="TextBox 273"/>
                  <p:cNvSpPr txBox="1"/>
                  <p:nvPr/>
                </p:nvSpPr>
                <p:spPr>
                  <a:xfrm>
                    <a:off x="8341347" y="1324905"/>
                    <a:ext cx="552441" cy="26540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800" b="1" i="1" u="none" strike="noStrike" kern="0" cap="none" spc="0" normalizeH="0" baseline="0" noProof="0" dirty="0" err="1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upA</a:t>
                    </a:r>
                    <a:endParaRPr kumimoji="0" lang="ko-KR" altLang="en-US" sz="800" b="1" i="1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250" name="그룹 249"/>
                <p:cNvGrpSpPr/>
                <p:nvPr/>
              </p:nvGrpSpPr>
              <p:grpSpPr>
                <a:xfrm>
                  <a:off x="1175065" y="4273671"/>
                  <a:ext cx="4516202" cy="764978"/>
                  <a:chOff x="5673156" y="1229610"/>
                  <a:chExt cx="4516202" cy="764978"/>
                </a:xfrm>
              </p:grpSpPr>
              <p:cxnSp>
                <p:nvCxnSpPr>
                  <p:cNvPr id="255" name="직선 연결선 254"/>
                  <p:cNvCxnSpPr/>
                  <p:nvPr/>
                </p:nvCxnSpPr>
                <p:spPr>
                  <a:xfrm>
                    <a:off x="5689358" y="1469161"/>
                    <a:ext cx="4500000" cy="2160"/>
                  </a:xfrm>
                  <a:prstGeom prst="line">
                    <a:avLst/>
                  </a:prstGeom>
                  <a:noFill/>
                  <a:ln w="190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  <p:sp>
                <p:nvSpPr>
                  <p:cNvPr id="256" name="오른쪽 화살표 255"/>
                  <p:cNvSpPr/>
                  <p:nvPr/>
                </p:nvSpPr>
                <p:spPr>
                  <a:xfrm>
                    <a:off x="9554032" y="1229610"/>
                    <a:ext cx="540000" cy="481263"/>
                  </a:xfrm>
                  <a:prstGeom prst="rightArrow">
                    <a:avLst/>
                  </a:prstGeom>
                  <a:solidFill>
                    <a:sysClr val="window" lastClr="FFFFFF"/>
                  </a:solidFill>
                  <a:ln w="190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0" lang="ko-KR" altLang="en-US" sz="1400" b="0" i="0" u="none" strike="noStrike" kern="0" cap="none" spc="0" normalizeH="0" baseline="0" noProof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57" name="오른쪽 화살표 256"/>
                  <p:cNvSpPr/>
                  <p:nvPr/>
                </p:nvSpPr>
                <p:spPr>
                  <a:xfrm flipH="1">
                    <a:off x="7853798" y="1229610"/>
                    <a:ext cx="1548000" cy="481263"/>
                  </a:xfrm>
                  <a:prstGeom prst="rightArrow">
                    <a:avLst/>
                  </a:prstGeom>
                  <a:solidFill>
                    <a:sysClr val="window" lastClr="FFFFFF"/>
                  </a:solidFill>
                  <a:ln w="190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0" lang="ko-KR" altLang="en-US" sz="1400" b="0" i="0" u="none" strike="noStrike" kern="0" cap="none" spc="0" normalizeH="0" baseline="0" noProof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58" name="오른쪽 화살표 257"/>
                  <p:cNvSpPr/>
                  <p:nvPr/>
                </p:nvSpPr>
                <p:spPr>
                  <a:xfrm>
                    <a:off x="6165368" y="1229610"/>
                    <a:ext cx="1404000" cy="481263"/>
                  </a:xfrm>
                  <a:prstGeom prst="rightArrow">
                    <a:avLst/>
                  </a:prstGeom>
                  <a:solidFill>
                    <a:sysClr val="window" lastClr="FFFFFF"/>
                  </a:solidFill>
                  <a:ln w="190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14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rPr>
                      <a:t>‘</a:t>
                    </a:r>
                    <a:endParaRPr kumimoji="0" lang="ko-KR" altLang="en-US" sz="14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59" name="오른쪽 화살표 258"/>
                  <p:cNvSpPr/>
                  <p:nvPr/>
                </p:nvSpPr>
                <p:spPr>
                  <a:xfrm>
                    <a:off x="5784468" y="1229610"/>
                    <a:ext cx="450000" cy="481263"/>
                  </a:xfrm>
                  <a:prstGeom prst="rightArrow">
                    <a:avLst/>
                  </a:prstGeom>
                  <a:solidFill>
                    <a:sysClr val="window" lastClr="FFFFFF"/>
                  </a:solidFill>
                  <a:ln w="190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14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rPr>
                      <a:t>‘</a:t>
                    </a:r>
                    <a:endParaRPr kumimoji="0" lang="ko-KR" altLang="en-US" sz="14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60" name="TextBox 259"/>
                  <p:cNvSpPr txBox="1"/>
                  <p:nvPr/>
                </p:nvSpPr>
                <p:spPr>
                  <a:xfrm>
                    <a:off x="5673156" y="1729180"/>
                    <a:ext cx="586198" cy="26540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8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3766</a:t>
                    </a:r>
                    <a:endParaRPr kumimoji="0" lang="ko-KR" altLang="en-US" sz="8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61" name="TextBox 260"/>
                  <p:cNvSpPr txBox="1"/>
                  <p:nvPr/>
                </p:nvSpPr>
                <p:spPr>
                  <a:xfrm>
                    <a:off x="6487190" y="1729180"/>
                    <a:ext cx="586198" cy="26540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8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3767</a:t>
                    </a:r>
                    <a:endParaRPr kumimoji="0" lang="ko-KR" altLang="en-US" sz="8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62" name="TextBox 261"/>
                  <p:cNvSpPr txBox="1"/>
                  <p:nvPr/>
                </p:nvSpPr>
                <p:spPr>
                  <a:xfrm>
                    <a:off x="8351333" y="1729180"/>
                    <a:ext cx="586198" cy="26540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8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3768</a:t>
                    </a:r>
                    <a:endParaRPr kumimoji="0" lang="ko-KR" altLang="en-US" sz="8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63" name="TextBox 262"/>
                  <p:cNvSpPr txBox="1"/>
                  <p:nvPr/>
                </p:nvSpPr>
                <p:spPr>
                  <a:xfrm>
                    <a:off x="9427302" y="1729180"/>
                    <a:ext cx="586198" cy="26540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8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3769</a:t>
                    </a:r>
                    <a:endParaRPr kumimoji="0" lang="ko-KR" altLang="en-US" sz="8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64" name="TextBox 263"/>
                  <p:cNvSpPr txBox="1"/>
                  <p:nvPr/>
                </p:nvSpPr>
                <p:spPr>
                  <a:xfrm>
                    <a:off x="8399101" y="1328683"/>
                    <a:ext cx="552441" cy="26540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ko-KR" sz="800" b="1" i="1" u="none" strike="noStrike" kern="0" cap="none" spc="0" normalizeH="0" baseline="0" noProof="0" dirty="0" err="1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upA</a:t>
                    </a:r>
                    <a:endParaRPr kumimoji="0" lang="ko-KR" altLang="en-US" sz="800" b="1" i="1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251" name="TextBox 250"/>
                <p:cNvSpPr txBox="1"/>
                <p:nvPr/>
              </p:nvSpPr>
              <p:spPr>
                <a:xfrm>
                  <a:off x="3837921" y="3668570"/>
                  <a:ext cx="544498" cy="3033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10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36%</a:t>
                  </a:r>
                  <a:endParaRPr kumimoji="0" lang="ko-KR" altLang="en-US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2" name="TextBox 251"/>
                <p:cNvSpPr txBox="1"/>
                <p:nvPr/>
              </p:nvSpPr>
              <p:spPr>
                <a:xfrm>
                  <a:off x="1229793" y="3668570"/>
                  <a:ext cx="544498" cy="3033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10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94%</a:t>
                  </a:r>
                  <a:endParaRPr kumimoji="0" lang="ko-KR" altLang="en-US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3" name="TextBox 252"/>
                <p:cNvSpPr txBox="1"/>
                <p:nvPr/>
              </p:nvSpPr>
              <p:spPr>
                <a:xfrm>
                  <a:off x="2079213" y="3668570"/>
                  <a:ext cx="544498" cy="3033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10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99%</a:t>
                  </a:r>
                  <a:endParaRPr kumimoji="0" lang="ko-KR" altLang="en-US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4" name="TextBox 253"/>
                <p:cNvSpPr txBox="1"/>
                <p:nvPr/>
              </p:nvSpPr>
              <p:spPr>
                <a:xfrm>
                  <a:off x="4952120" y="3668570"/>
                  <a:ext cx="631872" cy="3033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10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100%</a:t>
                  </a:r>
                  <a:endParaRPr kumimoji="0" lang="ko-KR" altLang="en-US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42" name="그룹 241"/>
              <p:cNvGrpSpPr/>
              <p:nvPr/>
            </p:nvGrpSpPr>
            <p:grpSpPr>
              <a:xfrm>
                <a:off x="15473" y="4699128"/>
                <a:ext cx="841467" cy="1235653"/>
                <a:chOff x="3606183" y="599395"/>
                <a:chExt cx="841467" cy="1235653"/>
              </a:xfrm>
            </p:grpSpPr>
            <p:sp>
              <p:nvSpPr>
                <p:cNvPr id="243" name="TextBox 242"/>
                <p:cNvSpPr txBox="1"/>
                <p:nvPr/>
              </p:nvSpPr>
              <p:spPr>
                <a:xfrm>
                  <a:off x="3606183" y="599395"/>
                  <a:ext cx="841467" cy="24803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10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FORC_016</a:t>
                  </a:r>
                  <a:endParaRPr kumimoji="0" lang="ko-KR" altLang="en-US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4" name="TextBox 243"/>
                <p:cNvSpPr txBox="1"/>
                <p:nvPr/>
              </p:nvSpPr>
              <p:spPr>
                <a:xfrm>
                  <a:off x="3631352" y="1587012"/>
                  <a:ext cx="791129" cy="24803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10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MO6-24/O</a:t>
                  </a:r>
                  <a:endParaRPr kumimoji="0" lang="ko-KR" altLang="en-US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275" name="TextBox 274"/>
            <p:cNvSpPr txBox="1"/>
            <p:nvPr/>
          </p:nvSpPr>
          <p:spPr>
            <a:xfrm>
              <a:off x="6564372" y="1654918"/>
              <a:ext cx="37221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5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C)</a:t>
              </a:r>
              <a:endParaRPr lang="ko-KR" altLang="en-US" sz="105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" name="그룹 4"/>
          <p:cNvGrpSpPr/>
          <p:nvPr/>
        </p:nvGrpSpPr>
        <p:grpSpPr>
          <a:xfrm>
            <a:off x="-21071" y="4483016"/>
            <a:ext cx="5830855" cy="2310724"/>
            <a:chOff x="394427" y="4479903"/>
            <a:chExt cx="5830855" cy="2310724"/>
          </a:xfrm>
        </p:grpSpPr>
        <p:sp>
          <p:nvSpPr>
            <p:cNvPr id="276" name="TextBox 275"/>
            <p:cNvSpPr txBox="1"/>
            <p:nvPr/>
          </p:nvSpPr>
          <p:spPr>
            <a:xfrm>
              <a:off x="546831" y="4479903"/>
              <a:ext cx="37221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5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B)</a:t>
              </a:r>
              <a:endParaRPr lang="ko-KR" altLang="en-US" sz="105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34" name="그룹 333"/>
            <p:cNvGrpSpPr>
              <a:grpSpLocks noChangeAspect="1"/>
            </p:cNvGrpSpPr>
            <p:nvPr/>
          </p:nvGrpSpPr>
          <p:grpSpPr>
            <a:xfrm>
              <a:off x="394427" y="4687876"/>
              <a:ext cx="5830855" cy="2102751"/>
              <a:chOff x="6541291" y="4397448"/>
              <a:chExt cx="5784160" cy="2074342"/>
            </a:xfrm>
          </p:grpSpPr>
          <p:grpSp>
            <p:nvGrpSpPr>
              <p:cNvPr id="335" name="그룹 334"/>
              <p:cNvGrpSpPr>
                <a:grpSpLocks noChangeAspect="1"/>
              </p:cNvGrpSpPr>
              <p:nvPr/>
            </p:nvGrpSpPr>
            <p:grpSpPr>
              <a:xfrm>
                <a:off x="7650248" y="4397448"/>
                <a:ext cx="4675203" cy="2074342"/>
                <a:chOff x="6308910" y="291030"/>
                <a:chExt cx="5894994" cy="2615552"/>
              </a:xfrm>
            </p:grpSpPr>
            <p:sp>
              <p:nvSpPr>
                <p:cNvPr id="339" name="직사각형 123"/>
                <p:cNvSpPr/>
                <p:nvPr/>
              </p:nvSpPr>
              <p:spPr>
                <a:xfrm flipH="1">
                  <a:off x="9870257" y="808755"/>
                  <a:ext cx="1862580" cy="1275293"/>
                </a:xfrm>
                <a:custGeom>
                  <a:avLst/>
                  <a:gdLst>
                    <a:gd name="connsiteX0" fmla="*/ 0 w 270000"/>
                    <a:gd name="connsiteY0" fmla="*/ 0 h 1275293"/>
                    <a:gd name="connsiteX1" fmla="*/ 270000 w 270000"/>
                    <a:gd name="connsiteY1" fmla="*/ 0 h 1275293"/>
                    <a:gd name="connsiteX2" fmla="*/ 270000 w 270000"/>
                    <a:gd name="connsiteY2" fmla="*/ 1275293 h 1275293"/>
                    <a:gd name="connsiteX3" fmla="*/ 0 w 270000"/>
                    <a:gd name="connsiteY3" fmla="*/ 1275293 h 1275293"/>
                    <a:gd name="connsiteX4" fmla="*/ 0 w 270000"/>
                    <a:gd name="connsiteY4" fmla="*/ 0 h 1275293"/>
                    <a:gd name="connsiteX0" fmla="*/ 0 w 1062480"/>
                    <a:gd name="connsiteY0" fmla="*/ 0 h 1275293"/>
                    <a:gd name="connsiteX1" fmla="*/ 270000 w 1062480"/>
                    <a:gd name="connsiteY1" fmla="*/ 0 h 1275293"/>
                    <a:gd name="connsiteX2" fmla="*/ 1062480 w 1062480"/>
                    <a:gd name="connsiteY2" fmla="*/ 1267673 h 1275293"/>
                    <a:gd name="connsiteX3" fmla="*/ 0 w 1062480"/>
                    <a:gd name="connsiteY3" fmla="*/ 1275293 h 1275293"/>
                    <a:gd name="connsiteX4" fmla="*/ 0 w 1062480"/>
                    <a:gd name="connsiteY4" fmla="*/ 0 h 1275293"/>
                    <a:gd name="connsiteX0" fmla="*/ 0 w 1062480"/>
                    <a:gd name="connsiteY0" fmla="*/ 0 h 1275293"/>
                    <a:gd name="connsiteX1" fmla="*/ 270000 w 1062480"/>
                    <a:gd name="connsiteY1" fmla="*/ 0 h 1275293"/>
                    <a:gd name="connsiteX2" fmla="*/ 1062480 w 1062480"/>
                    <a:gd name="connsiteY2" fmla="*/ 1267673 h 1275293"/>
                    <a:gd name="connsiteX3" fmla="*/ 777240 w 1062480"/>
                    <a:gd name="connsiteY3" fmla="*/ 1275293 h 1275293"/>
                    <a:gd name="connsiteX4" fmla="*/ 0 w 1062480"/>
                    <a:gd name="connsiteY4" fmla="*/ 0 h 1275293"/>
                    <a:gd name="connsiteX0" fmla="*/ 0 w 1839720"/>
                    <a:gd name="connsiteY0" fmla="*/ 0 h 1282913"/>
                    <a:gd name="connsiteX1" fmla="*/ 1047240 w 1839720"/>
                    <a:gd name="connsiteY1" fmla="*/ 7620 h 1282913"/>
                    <a:gd name="connsiteX2" fmla="*/ 1839720 w 1839720"/>
                    <a:gd name="connsiteY2" fmla="*/ 1275293 h 1282913"/>
                    <a:gd name="connsiteX3" fmla="*/ 1554480 w 1839720"/>
                    <a:gd name="connsiteY3" fmla="*/ 1282913 h 1282913"/>
                    <a:gd name="connsiteX4" fmla="*/ 0 w 1839720"/>
                    <a:gd name="connsiteY4" fmla="*/ 0 h 1282913"/>
                    <a:gd name="connsiteX0" fmla="*/ 0 w 1862580"/>
                    <a:gd name="connsiteY0" fmla="*/ 0 h 1275293"/>
                    <a:gd name="connsiteX1" fmla="*/ 1070100 w 1862580"/>
                    <a:gd name="connsiteY1" fmla="*/ 0 h 1275293"/>
                    <a:gd name="connsiteX2" fmla="*/ 1862580 w 1862580"/>
                    <a:gd name="connsiteY2" fmla="*/ 1267673 h 1275293"/>
                    <a:gd name="connsiteX3" fmla="*/ 1577340 w 1862580"/>
                    <a:gd name="connsiteY3" fmla="*/ 1275293 h 1275293"/>
                    <a:gd name="connsiteX4" fmla="*/ 0 w 1862580"/>
                    <a:gd name="connsiteY4" fmla="*/ 0 h 1275293"/>
                    <a:gd name="connsiteX0" fmla="*/ 0 w 1862580"/>
                    <a:gd name="connsiteY0" fmla="*/ 0 h 1275293"/>
                    <a:gd name="connsiteX1" fmla="*/ 1070100 w 1862580"/>
                    <a:gd name="connsiteY1" fmla="*/ 0 h 1275293"/>
                    <a:gd name="connsiteX2" fmla="*/ 1862580 w 1862580"/>
                    <a:gd name="connsiteY2" fmla="*/ 1267673 h 1275293"/>
                    <a:gd name="connsiteX3" fmla="*/ 1668780 w 1862580"/>
                    <a:gd name="connsiteY3" fmla="*/ 1275293 h 1275293"/>
                    <a:gd name="connsiteX4" fmla="*/ 0 w 1862580"/>
                    <a:gd name="connsiteY4" fmla="*/ 0 h 1275293"/>
                    <a:gd name="connsiteX0" fmla="*/ 0 w 1862580"/>
                    <a:gd name="connsiteY0" fmla="*/ 0 h 1275293"/>
                    <a:gd name="connsiteX1" fmla="*/ 209040 w 1862580"/>
                    <a:gd name="connsiteY1" fmla="*/ 0 h 1275293"/>
                    <a:gd name="connsiteX2" fmla="*/ 1862580 w 1862580"/>
                    <a:gd name="connsiteY2" fmla="*/ 1267673 h 1275293"/>
                    <a:gd name="connsiteX3" fmla="*/ 1668780 w 1862580"/>
                    <a:gd name="connsiteY3" fmla="*/ 1275293 h 1275293"/>
                    <a:gd name="connsiteX4" fmla="*/ 0 w 1862580"/>
                    <a:gd name="connsiteY4" fmla="*/ 0 h 1275293"/>
                    <a:gd name="connsiteX0" fmla="*/ 0 w 1862580"/>
                    <a:gd name="connsiteY0" fmla="*/ 0 h 1275293"/>
                    <a:gd name="connsiteX1" fmla="*/ 186180 w 1862580"/>
                    <a:gd name="connsiteY1" fmla="*/ 0 h 1275293"/>
                    <a:gd name="connsiteX2" fmla="*/ 1862580 w 1862580"/>
                    <a:gd name="connsiteY2" fmla="*/ 1267673 h 1275293"/>
                    <a:gd name="connsiteX3" fmla="*/ 1668780 w 1862580"/>
                    <a:gd name="connsiteY3" fmla="*/ 1275293 h 1275293"/>
                    <a:gd name="connsiteX4" fmla="*/ 0 w 1862580"/>
                    <a:gd name="connsiteY4" fmla="*/ 0 h 12752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62580" h="1275293">
                      <a:moveTo>
                        <a:pt x="0" y="0"/>
                      </a:moveTo>
                      <a:lnTo>
                        <a:pt x="186180" y="0"/>
                      </a:lnTo>
                      <a:lnTo>
                        <a:pt x="1862580" y="1267673"/>
                      </a:lnTo>
                      <a:lnTo>
                        <a:pt x="1668780" y="1275293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chemeClr val="bg2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400">
                    <a:latin typeface="Trebuchet MS" panose="020B0603020202020204" pitchFamily="34" charset="0"/>
                  </a:endParaRPr>
                </a:p>
              </p:txBody>
            </p:sp>
            <p:sp>
              <p:nvSpPr>
                <p:cNvPr id="340" name="직사각형 123"/>
                <p:cNvSpPr/>
                <p:nvPr/>
              </p:nvSpPr>
              <p:spPr>
                <a:xfrm flipH="1">
                  <a:off x="9565845" y="816391"/>
                  <a:ext cx="1847340" cy="1275293"/>
                </a:xfrm>
                <a:custGeom>
                  <a:avLst/>
                  <a:gdLst>
                    <a:gd name="connsiteX0" fmla="*/ 0 w 270000"/>
                    <a:gd name="connsiteY0" fmla="*/ 0 h 1275293"/>
                    <a:gd name="connsiteX1" fmla="*/ 270000 w 270000"/>
                    <a:gd name="connsiteY1" fmla="*/ 0 h 1275293"/>
                    <a:gd name="connsiteX2" fmla="*/ 270000 w 270000"/>
                    <a:gd name="connsiteY2" fmla="*/ 1275293 h 1275293"/>
                    <a:gd name="connsiteX3" fmla="*/ 0 w 270000"/>
                    <a:gd name="connsiteY3" fmla="*/ 1275293 h 1275293"/>
                    <a:gd name="connsiteX4" fmla="*/ 0 w 270000"/>
                    <a:gd name="connsiteY4" fmla="*/ 0 h 1275293"/>
                    <a:gd name="connsiteX0" fmla="*/ 0 w 1062480"/>
                    <a:gd name="connsiteY0" fmla="*/ 0 h 1275293"/>
                    <a:gd name="connsiteX1" fmla="*/ 270000 w 1062480"/>
                    <a:gd name="connsiteY1" fmla="*/ 0 h 1275293"/>
                    <a:gd name="connsiteX2" fmla="*/ 1062480 w 1062480"/>
                    <a:gd name="connsiteY2" fmla="*/ 1267673 h 1275293"/>
                    <a:gd name="connsiteX3" fmla="*/ 0 w 1062480"/>
                    <a:gd name="connsiteY3" fmla="*/ 1275293 h 1275293"/>
                    <a:gd name="connsiteX4" fmla="*/ 0 w 1062480"/>
                    <a:gd name="connsiteY4" fmla="*/ 0 h 1275293"/>
                    <a:gd name="connsiteX0" fmla="*/ 0 w 1062480"/>
                    <a:gd name="connsiteY0" fmla="*/ 0 h 1275293"/>
                    <a:gd name="connsiteX1" fmla="*/ 270000 w 1062480"/>
                    <a:gd name="connsiteY1" fmla="*/ 0 h 1275293"/>
                    <a:gd name="connsiteX2" fmla="*/ 1062480 w 1062480"/>
                    <a:gd name="connsiteY2" fmla="*/ 1267673 h 1275293"/>
                    <a:gd name="connsiteX3" fmla="*/ 777240 w 1062480"/>
                    <a:gd name="connsiteY3" fmla="*/ 1275293 h 1275293"/>
                    <a:gd name="connsiteX4" fmla="*/ 0 w 1062480"/>
                    <a:gd name="connsiteY4" fmla="*/ 0 h 1275293"/>
                    <a:gd name="connsiteX0" fmla="*/ 0 w 1839720"/>
                    <a:gd name="connsiteY0" fmla="*/ 0 h 1282913"/>
                    <a:gd name="connsiteX1" fmla="*/ 1047240 w 1839720"/>
                    <a:gd name="connsiteY1" fmla="*/ 7620 h 1282913"/>
                    <a:gd name="connsiteX2" fmla="*/ 1839720 w 1839720"/>
                    <a:gd name="connsiteY2" fmla="*/ 1275293 h 1282913"/>
                    <a:gd name="connsiteX3" fmla="*/ 1554480 w 1839720"/>
                    <a:gd name="connsiteY3" fmla="*/ 1282913 h 1282913"/>
                    <a:gd name="connsiteX4" fmla="*/ 0 w 1839720"/>
                    <a:gd name="connsiteY4" fmla="*/ 0 h 1282913"/>
                    <a:gd name="connsiteX0" fmla="*/ 0 w 1862580"/>
                    <a:gd name="connsiteY0" fmla="*/ 0 h 1275293"/>
                    <a:gd name="connsiteX1" fmla="*/ 1070100 w 1862580"/>
                    <a:gd name="connsiteY1" fmla="*/ 0 h 1275293"/>
                    <a:gd name="connsiteX2" fmla="*/ 1862580 w 1862580"/>
                    <a:gd name="connsiteY2" fmla="*/ 1267673 h 1275293"/>
                    <a:gd name="connsiteX3" fmla="*/ 1577340 w 1862580"/>
                    <a:gd name="connsiteY3" fmla="*/ 1275293 h 1275293"/>
                    <a:gd name="connsiteX4" fmla="*/ 0 w 1862580"/>
                    <a:gd name="connsiteY4" fmla="*/ 0 h 1275293"/>
                    <a:gd name="connsiteX0" fmla="*/ 0 w 1862580"/>
                    <a:gd name="connsiteY0" fmla="*/ 0 h 1275293"/>
                    <a:gd name="connsiteX1" fmla="*/ 1070100 w 1862580"/>
                    <a:gd name="connsiteY1" fmla="*/ 0 h 1275293"/>
                    <a:gd name="connsiteX2" fmla="*/ 1862580 w 1862580"/>
                    <a:gd name="connsiteY2" fmla="*/ 1267673 h 1275293"/>
                    <a:gd name="connsiteX3" fmla="*/ 1668780 w 1862580"/>
                    <a:gd name="connsiteY3" fmla="*/ 1275293 h 1275293"/>
                    <a:gd name="connsiteX4" fmla="*/ 0 w 1862580"/>
                    <a:gd name="connsiteY4" fmla="*/ 0 h 1275293"/>
                    <a:gd name="connsiteX0" fmla="*/ 0 w 1862580"/>
                    <a:gd name="connsiteY0" fmla="*/ 0 h 1275293"/>
                    <a:gd name="connsiteX1" fmla="*/ 209040 w 1862580"/>
                    <a:gd name="connsiteY1" fmla="*/ 0 h 1275293"/>
                    <a:gd name="connsiteX2" fmla="*/ 1862580 w 1862580"/>
                    <a:gd name="connsiteY2" fmla="*/ 1267673 h 1275293"/>
                    <a:gd name="connsiteX3" fmla="*/ 1668780 w 1862580"/>
                    <a:gd name="connsiteY3" fmla="*/ 1275293 h 1275293"/>
                    <a:gd name="connsiteX4" fmla="*/ 0 w 1862580"/>
                    <a:gd name="connsiteY4" fmla="*/ 0 h 1275293"/>
                    <a:gd name="connsiteX0" fmla="*/ 0 w 1862580"/>
                    <a:gd name="connsiteY0" fmla="*/ 0 h 1275293"/>
                    <a:gd name="connsiteX1" fmla="*/ 186180 w 1862580"/>
                    <a:gd name="connsiteY1" fmla="*/ 0 h 1275293"/>
                    <a:gd name="connsiteX2" fmla="*/ 1862580 w 1862580"/>
                    <a:gd name="connsiteY2" fmla="*/ 1267673 h 1275293"/>
                    <a:gd name="connsiteX3" fmla="*/ 1668780 w 1862580"/>
                    <a:gd name="connsiteY3" fmla="*/ 1275293 h 1275293"/>
                    <a:gd name="connsiteX4" fmla="*/ 0 w 1862580"/>
                    <a:gd name="connsiteY4" fmla="*/ 0 h 1275293"/>
                    <a:gd name="connsiteX0" fmla="*/ 0 w 1847340"/>
                    <a:gd name="connsiteY0" fmla="*/ 0 h 1275293"/>
                    <a:gd name="connsiteX1" fmla="*/ 170940 w 1847340"/>
                    <a:gd name="connsiteY1" fmla="*/ 0 h 1275293"/>
                    <a:gd name="connsiteX2" fmla="*/ 1847340 w 1847340"/>
                    <a:gd name="connsiteY2" fmla="*/ 1267673 h 1275293"/>
                    <a:gd name="connsiteX3" fmla="*/ 1653540 w 1847340"/>
                    <a:gd name="connsiteY3" fmla="*/ 1275293 h 1275293"/>
                    <a:gd name="connsiteX4" fmla="*/ 0 w 1847340"/>
                    <a:gd name="connsiteY4" fmla="*/ 0 h 12752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47340" h="1275293">
                      <a:moveTo>
                        <a:pt x="0" y="0"/>
                      </a:moveTo>
                      <a:lnTo>
                        <a:pt x="170940" y="0"/>
                      </a:lnTo>
                      <a:lnTo>
                        <a:pt x="1847340" y="1267673"/>
                      </a:lnTo>
                      <a:lnTo>
                        <a:pt x="1653540" y="1275293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chemeClr val="bg2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400">
                    <a:latin typeface="Trebuchet MS" panose="020B0603020202020204" pitchFamily="34" charset="0"/>
                  </a:endParaRPr>
                </a:p>
              </p:txBody>
            </p:sp>
            <p:sp>
              <p:nvSpPr>
                <p:cNvPr id="341" name="직사각형 123"/>
                <p:cNvSpPr/>
                <p:nvPr/>
              </p:nvSpPr>
              <p:spPr>
                <a:xfrm>
                  <a:off x="8300514" y="808755"/>
                  <a:ext cx="1062480" cy="1275293"/>
                </a:xfrm>
                <a:custGeom>
                  <a:avLst/>
                  <a:gdLst>
                    <a:gd name="connsiteX0" fmla="*/ 0 w 270000"/>
                    <a:gd name="connsiteY0" fmla="*/ 0 h 1275293"/>
                    <a:gd name="connsiteX1" fmla="*/ 270000 w 270000"/>
                    <a:gd name="connsiteY1" fmla="*/ 0 h 1275293"/>
                    <a:gd name="connsiteX2" fmla="*/ 270000 w 270000"/>
                    <a:gd name="connsiteY2" fmla="*/ 1275293 h 1275293"/>
                    <a:gd name="connsiteX3" fmla="*/ 0 w 270000"/>
                    <a:gd name="connsiteY3" fmla="*/ 1275293 h 1275293"/>
                    <a:gd name="connsiteX4" fmla="*/ 0 w 270000"/>
                    <a:gd name="connsiteY4" fmla="*/ 0 h 1275293"/>
                    <a:gd name="connsiteX0" fmla="*/ 0 w 1062480"/>
                    <a:gd name="connsiteY0" fmla="*/ 0 h 1275293"/>
                    <a:gd name="connsiteX1" fmla="*/ 270000 w 1062480"/>
                    <a:gd name="connsiteY1" fmla="*/ 0 h 1275293"/>
                    <a:gd name="connsiteX2" fmla="*/ 1062480 w 1062480"/>
                    <a:gd name="connsiteY2" fmla="*/ 1267673 h 1275293"/>
                    <a:gd name="connsiteX3" fmla="*/ 0 w 1062480"/>
                    <a:gd name="connsiteY3" fmla="*/ 1275293 h 1275293"/>
                    <a:gd name="connsiteX4" fmla="*/ 0 w 1062480"/>
                    <a:gd name="connsiteY4" fmla="*/ 0 h 1275293"/>
                    <a:gd name="connsiteX0" fmla="*/ 0 w 1062480"/>
                    <a:gd name="connsiteY0" fmla="*/ 0 h 1275293"/>
                    <a:gd name="connsiteX1" fmla="*/ 270000 w 1062480"/>
                    <a:gd name="connsiteY1" fmla="*/ 0 h 1275293"/>
                    <a:gd name="connsiteX2" fmla="*/ 1062480 w 1062480"/>
                    <a:gd name="connsiteY2" fmla="*/ 1267673 h 1275293"/>
                    <a:gd name="connsiteX3" fmla="*/ 777240 w 1062480"/>
                    <a:gd name="connsiteY3" fmla="*/ 1275293 h 1275293"/>
                    <a:gd name="connsiteX4" fmla="*/ 0 w 1062480"/>
                    <a:gd name="connsiteY4" fmla="*/ 0 h 12752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062480" h="1275293">
                      <a:moveTo>
                        <a:pt x="0" y="0"/>
                      </a:moveTo>
                      <a:lnTo>
                        <a:pt x="270000" y="0"/>
                      </a:lnTo>
                      <a:lnTo>
                        <a:pt x="1062480" y="1267673"/>
                      </a:lnTo>
                      <a:lnTo>
                        <a:pt x="777240" y="1275293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chemeClr val="bg2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400">
                    <a:latin typeface="Trebuchet MS" panose="020B0603020202020204" pitchFamily="34" charset="0"/>
                  </a:endParaRPr>
                </a:p>
              </p:txBody>
            </p:sp>
            <p:sp>
              <p:nvSpPr>
                <p:cNvPr id="342" name="직사각형 122"/>
                <p:cNvSpPr/>
                <p:nvPr/>
              </p:nvSpPr>
              <p:spPr>
                <a:xfrm>
                  <a:off x="7687752" y="808756"/>
                  <a:ext cx="1320479" cy="1275293"/>
                </a:xfrm>
                <a:custGeom>
                  <a:avLst/>
                  <a:gdLst>
                    <a:gd name="connsiteX0" fmla="*/ 0 w 512759"/>
                    <a:gd name="connsiteY0" fmla="*/ 0 h 1275293"/>
                    <a:gd name="connsiteX1" fmla="*/ 512759 w 512759"/>
                    <a:gd name="connsiteY1" fmla="*/ 0 h 1275293"/>
                    <a:gd name="connsiteX2" fmla="*/ 512759 w 512759"/>
                    <a:gd name="connsiteY2" fmla="*/ 1275293 h 1275293"/>
                    <a:gd name="connsiteX3" fmla="*/ 0 w 512759"/>
                    <a:gd name="connsiteY3" fmla="*/ 1275293 h 1275293"/>
                    <a:gd name="connsiteX4" fmla="*/ 0 w 512759"/>
                    <a:gd name="connsiteY4" fmla="*/ 0 h 1275293"/>
                    <a:gd name="connsiteX0" fmla="*/ 0 w 1320479"/>
                    <a:gd name="connsiteY0" fmla="*/ 0 h 1275293"/>
                    <a:gd name="connsiteX1" fmla="*/ 512759 w 1320479"/>
                    <a:gd name="connsiteY1" fmla="*/ 0 h 1275293"/>
                    <a:gd name="connsiteX2" fmla="*/ 1320479 w 1320479"/>
                    <a:gd name="connsiteY2" fmla="*/ 1275293 h 1275293"/>
                    <a:gd name="connsiteX3" fmla="*/ 0 w 1320479"/>
                    <a:gd name="connsiteY3" fmla="*/ 1275293 h 1275293"/>
                    <a:gd name="connsiteX4" fmla="*/ 0 w 1320479"/>
                    <a:gd name="connsiteY4" fmla="*/ 0 h 1275293"/>
                    <a:gd name="connsiteX0" fmla="*/ 0 w 1320479"/>
                    <a:gd name="connsiteY0" fmla="*/ 0 h 1275293"/>
                    <a:gd name="connsiteX1" fmla="*/ 512759 w 1320479"/>
                    <a:gd name="connsiteY1" fmla="*/ 0 h 1275293"/>
                    <a:gd name="connsiteX2" fmla="*/ 1320479 w 1320479"/>
                    <a:gd name="connsiteY2" fmla="*/ 1275293 h 1275293"/>
                    <a:gd name="connsiteX3" fmla="*/ 807720 w 1320479"/>
                    <a:gd name="connsiteY3" fmla="*/ 1275293 h 1275293"/>
                    <a:gd name="connsiteX4" fmla="*/ 0 w 1320479"/>
                    <a:gd name="connsiteY4" fmla="*/ 0 h 12752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320479" h="1275293">
                      <a:moveTo>
                        <a:pt x="0" y="0"/>
                      </a:moveTo>
                      <a:lnTo>
                        <a:pt x="512759" y="0"/>
                      </a:lnTo>
                      <a:lnTo>
                        <a:pt x="1320479" y="1275293"/>
                      </a:lnTo>
                      <a:lnTo>
                        <a:pt x="807720" y="1275293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chemeClr val="bg2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400">
                    <a:latin typeface="Trebuchet MS" panose="020B0603020202020204" pitchFamily="34" charset="0"/>
                  </a:endParaRPr>
                </a:p>
              </p:txBody>
            </p:sp>
            <p:sp>
              <p:nvSpPr>
                <p:cNvPr id="343" name="직사각형 120"/>
                <p:cNvSpPr/>
                <p:nvPr/>
              </p:nvSpPr>
              <p:spPr>
                <a:xfrm>
                  <a:off x="6448825" y="801119"/>
                  <a:ext cx="1452812" cy="1275293"/>
                </a:xfrm>
                <a:custGeom>
                  <a:avLst/>
                  <a:gdLst>
                    <a:gd name="connsiteX0" fmla="*/ 0 w 620327"/>
                    <a:gd name="connsiteY0" fmla="*/ 0 h 1275293"/>
                    <a:gd name="connsiteX1" fmla="*/ 620327 w 620327"/>
                    <a:gd name="connsiteY1" fmla="*/ 0 h 1275293"/>
                    <a:gd name="connsiteX2" fmla="*/ 620327 w 620327"/>
                    <a:gd name="connsiteY2" fmla="*/ 1275293 h 1275293"/>
                    <a:gd name="connsiteX3" fmla="*/ 0 w 620327"/>
                    <a:gd name="connsiteY3" fmla="*/ 1275293 h 1275293"/>
                    <a:gd name="connsiteX4" fmla="*/ 0 w 620327"/>
                    <a:gd name="connsiteY4" fmla="*/ 0 h 1275293"/>
                    <a:gd name="connsiteX0" fmla="*/ 0 w 1443287"/>
                    <a:gd name="connsiteY0" fmla="*/ 0 h 1275293"/>
                    <a:gd name="connsiteX1" fmla="*/ 620327 w 1443287"/>
                    <a:gd name="connsiteY1" fmla="*/ 0 h 1275293"/>
                    <a:gd name="connsiteX2" fmla="*/ 1443287 w 1443287"/>
                    <a:gd name="connsiteY2" fmla="*/ 1275293 h 1275293"/>
                    <a:gd name="connsiteX3" fmla="*/ 0 w 1443287"/>
                    <a:gd name="connsiteY3" fmla="*/ 1275293 h 1275293"/>
                    <a:gd name="connsiteX4" fmla="*/ 0 w 1443287"/>
                    <a:gd name="connsiteY4" fmla="*/ 0 h 1275293"/>
                    <a:gd name="connsiteX0" fmla="*/ 0 w 1443287"/>
                    <a:gd name="connsiteY0" fmla="*/ 0 h 1275293"/>
                    <a:gd name="connsiteX1" fmla="*/ 620327 w 1443287"/>
                    <a:gd name="connsiteY1" fmla="*/ 0 h 1275293"/>
                    <a:gd name="connsiteX2" fmla="*/ 1443287 w 1443287"/>
                    <a:gd name="connsiteY2" fmla="*/ 1275293 h 1275293"/>
                    <a:gd name="connsiteX3" fmla="*/ 784860 w 1443287"/>
                    <a:gd name="connsiteY3" fmla="*/ 1267673 h 1275293"/>
                    <a:gd name="connsiteX4" fmla="*/ 0 w 1443287"/>
                    <a:gd name="connsiteY4" fmla="*/ 0 h 1275293"/>
                    <a:gd name="connsiteX0" fmla="*/ 0 w 1462337"/>
                    <a:gd name="connsiteY0" fmla="*/ 133350 h 1275293"/>
                    <a:gd name="connsiteX1" fmla="*/ 639377 w 1462337"/>
                    <a:gd name="connsiteY1" fmla="*/ 0 h 1275293"/>
                    <a:gd name="connsiteX2" fmla="*/ 1462337 w 1462337"/>
                    <a:gd name="connsiteY2" fmla="*/ 1275293 h 1275293"/>
                    <a:gd name="connsiteX3" fmla="*/ 803910 w 1462337"/>
                    <a:gd name="connsiteY3" fmla="*/ 1267673 h 1275293"/>
                    <a:gd name="connsiteX4" fmla="*/ 0 w 1462337"/>
                    <a:gd name="connsiteY4" fmla="*/ 133350 h 1275293"/>
                    <a:gd name="connsiteX0" fmla="*/ 0 w 1462337"/>
                    <a:gd name="connsiteY0" fmla="*/ 133350 h 1275293"/>
                    <a:gd name="connsiteX1" fmla="*/ 658427 w 1462337"/>
                    <a:gd name="connsiteY1" fmla="*/ 0 h 1275293"/>
                    <a:gd name="connsiteX2" fmla="*/ 1462337 w 1462337"/>
                    <a:gd name="connsiteY2" fmla="*/ 1275293 h 1275293"/>
                    <a:gd name="connsiteX3" fmla="*/ 803910 w 1462337"/>
                    <a:gd name="connsiteY3" fmla="*/ 1267673 h 1275293"/>
                    <a:gd name="connsiteX4" fmla="*/ 0 w 1462337"/>
                    <a:gd name="connsiteY4" fmla="*/ 133350 h 1275293"/>
                    <a:gd name="connsiteX0" fmla="*/ 0 w 1452812"/>
                    <a:gd name="connsiteY0" fmla="*/ 133350 h 1275293"/>
                    <a:gd name="connsiteX1" fmla="*/ 648902 w 1452812"/>
                    <a:gd name="connsiteY1" fmla="*/ 0 h 1275293"/>
                    <a:gd name="connsiteX2" fmla="*/ 1452812 w 1452812"/>
                    <a:gd name="connsiteY2" fmla="*/ 1275293 h 1275293"/>
                    <a:gd name="connsiteX3" fmla="*/ 794385 w 1452812"/>
                    <a:gd name="connsiteY3" fmla="*/ 1267673 h 1275293"/>
                    <a:gd name="connsiteX4" fmla="*/ 0 w 1452812"/>
                    <a:gd name="connsiteY4" fmla="*/ 133350 h 12752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452812" h="1275293">
                      <a:moveTo>
                        <a:pt x="0" y="133350"/>
                      </a:moveTo>
                      <a:lnTo>
                        <a:pt x="648902" y="0"/>
                      </a:lnTo>
                      <a:lnTo>
                        <a:pt x="1452812" y="1275293"/>
                      </a:lnTo>
                      <a:lnTo>
                        <a:pt x="794385" y="1267673"/>
                      </a:lnTo>
                      <a:lnTo>
                        <a:pt x="0" y="133350"/>
                      </a:lnTo>
                      <a:close/>
                    </a:path>
                  </a:pathLst>
                </a:custGeom>
                <a:solidFill>
                  <a:schemeClr val="bg2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400">
                    <a:latin typeface="Trebuchet MS" panose="020B0603020202020204" pitchFamily="34" charset="0"/>
                  </a:endParaRPr>
                </a:p>
              </p:txBody>
            </p:sp>
            <p:sp>
              <p:nvSpPr>
                <p:cNvPr id="344" name="직사각형 121"/>
                <p:cNvSpPr/>
                <p:nvPr/>
              </p:nvSpPr>
              <p:spPr>
                <a:xfrm>
                  <a:off x="7023973" y="801118"/>
                  <a:ext cx="1435667" cy="1275293"/>
                </a:xfrm>
                <a:custGeom>
                  <a:avLst/>
                  <a:gdLst>
                    <a:gd name="connsiteX0" fmla="*/ 0 w 620327"/>
                    <a:gd name="connsiteY0" fmla="*/ 0 h 1275293"/>
                    <a:gd name="connsiteX1" fmla="*/ 620327 w 620327"/>
                    <a:gd name="connsiteY1" fmla="*/ 0 h 1275293"/>
                    <a:gd name="connsiteX2" fmla="*/ 620327 w 620327"/>
                    <a:gd name="connsiteY2" fmla="*/ 1275293 h 1275293"/>
                    <a:gd name="connsiteX3" fmla="*/ 0 w 620327"/>
                    <a:gd name="connsiteY3" fmla="*/ 1275293 h 1275293"/>
                    <a:gd name="connsiteX4" fmla="*/ 0 w 620327"/>
                    <a:gd name="connsiteY4" fmla="*/ 0 h 1275293"/>
                    <a:gd name="connsiteX0" fmla="*/ 0 w 1435667"/>
                    <a:gd name="connsiteY0" fmla="*/ 0 h 1275293"/>
                    <a:gd name="connsiteX1" fmla="*/ 620327 w 1435667"/>
                    <a:gd name="connsiteY1" fmla="*/ 0 h 1275293"/>
                    <a:gd name="connsiteX2" fmla="*/ 1435667 w 1435667"/>
                    <a:gd name="connsiteY2" fmla="*/ 1275293 h 1275293"/>
                    <a:gd name="connsiteX3" fmla="*/ 0 w 1435667"/>
                    <a:gd name="connsiteY3" fmla="*/ 1275293 h 1275293"/>
                    <a:gd name="connsiteX4" fmla="*/ 0 w 1435667"/>
                    <a:gd name="connsiteY4" fmla="*/ 0 h 1275293"/>
                    <a:gd name="connsiteX0" fmla="*/ 0 w 1435667"/>
                    <a:gd name="connsiteY0" fmla="*/ 0 h 1275293"/>
                    <a:gd name="connsiteX1" fmla="*/ 620327 w 1435667"/>
                    <a:gd name="connsiteY1" fmla="*/ 0 h 1275293"/>
                    <a:gd name="connsiteX2" fmla="*/ 1435667 w 1435667"/>
                    <a:gd name="connsiteY2" fmla="*/ 1275293 h 1275293"/>
                    <a:gd name="connsiteX3" fmla="*/ 845820 w 1435667"/>
                    <a:gd name="connsiteY3" fmla="*/ 1275293 h 1275293"/>
                    <a:gd name="connsiteX4" fmla="*/ 0 w 1435667"/>
                    <a:gd name="connsiteY4" fmla="*/ 0 h 12752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435667" h="1275293">
                      <a:moveTo>
                        <a:pt x="0" y="0"/>
                      </a:moveTo>
                      <a:lnTo>
                        <a:pt x="620327" y="0"/>
                      </a:lnTo>
                      <a:lnTo>
                        <a:pt x="1435667" y="1275293"/>
                      </a:lnTo>
                      <a:lnTo>
                        <a:pt x="845820" y="1275293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chemeClr val="bg2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400">
                    <a:latin typeface="Trebuchet MS" panose="020B0603020202020204" pitchFamily="34" charset="0"/>
                  </a:endParaRPr>
                </a:p>
              </p:txBody>
            </p:sp>
            <p:cxnSp>
              <p:nvCxnSpPr>
                <p:cNvPr id="345" name="직선 연결선 344"/>
                <p:cNvCxnSpPr/>
                <p:nvPr/>
              </p:nvCxnSpPr>
              <p:spPr>
                <a:xfrm>
                  <a:off x="6362299" y="816391"/>
                  <a:ext cx="539077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46" name="오른쪽 화살표 345"/>
                <p:cNvSpPr/>
                <p:nvPr/>
              </p:nvSpPr>
              <p:spPr>
                <a:xfrm>
                  <a:off x="9403514" y="575760"/>
                  <a:ext cx="1529189" cy="481263"/>
                </a:xfrm>
                <a:prstGeom prst="rightArrow">
                  <a:avLst/>
                </a:prstGeom>
                <a:solidFill>
                  <a:srgbClr val="FFC000"/>
                </a:solidFill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400" dirty="0">
                    <a:latin typeface="Trebuchet MS" panose="020B0603020202020204" pitchFamily="34" charset="0"/>
                  </a:endParaRPr>
                </a:p>
              </p:txBody>
            </p:sp>
            <p:sp>
              <p:nvSpPr>
                <p:cNvPr id="347" name="오른쪽 화살표 346"/>
                <p:cNvSpPr/>
                <p:nvPr/>
              </p:nvSpPr>
              <p:spPr>
                <a:xfrm>
                  <a:off x="10986569" y="575760"/>
                  <a:ext cx="210263" cy="481263"/>
                </a:xfrm>
                <a:prstGeom prst="rightArrow">
                  <a:avLst/>
                </a:prstGeom>
                <a:solidFill>
                  <a:schemeClr val="bg1"/>
                </a:solidFill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400">
                    <a:latin typeface="Trebuchet MS" panose="020B0603020202020204" pitchFamily="34" charset="0"/>
                  </a:endParaRPr>
                </a:p>
              </p:txBody>
            </p:sp>
            <p:sp>
              <p:nvSpPr>
                <p:cNvPr id="348" name="오른쪽 화살표 347"/>
                <p:cNvSpPr/>
                <p:nvPr/>
              </p:nvSpPr>
              <p:spPr>
                <a:xfrm flipH="1">
                  <a:off x="8613962" y="575760"/>
                  <a:ext cx="700878" cy="481263"/>
                </a:xfrm>
                <a:prstGeom prst="rightArrow">
                  <a:avLst/>
                </a:prstGeom>
                <a:solidFill>
                  <a:schemeClr val="bg1"/>
                </a:solidFill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400">
                    <a:latin typeface="Trebuchet MS" panose="020B0603020202020204" pitchFamily="34" charset="0"/>
                  </a:endParaRPr>
                </a:p>
              </p:txBody>
            </p:sp>
            <p:sp>
              <p:nvSpPr>
                <p:cNvPr id="349" name="오른쪽 화살표 348"/>
                <p:cNvSpPr/>
                <p:nvPr/>
              </p:nvSpPr>
              <p:spPr>
                <a:xfrm flipH="1">
                  <a:off x="8308297" y="575760"/>
                  <a:ext cx="254864" cy="481263"/>
                </a:xfrm>
                <a:prstGeom prst="rightArrow">
                  <a:avLst/>
                </a:prstGeom>
                <a:solidFill>
                  <a:schemeClr val="bg1"/>
                </a:solidFill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400">
                    <a:latin typeface="Trebuchet MS" panose="020B0603020202020204" pitchFamily="34" charset="0"/>
                  </a:endParaRPr>
                </a:p>
              </p:txBody>
            </p:sp>
            <p:sp>
              <p:nvSpPr>
                <p:cNvPr id="350" name="오른쪽 화살표 349"/>
                <p:cNvSpPr/>
                <p:nvPr/>
              </p:nvSpPr>
              <p:spPr>
                <a:xfrm>
                  <a:off x="7697689" y="575760"/>
                  <a:ext cx="509730" cy="481263"/>
                </a:xfrm>
                <a:prstGeom prst="rightArrow">
                  <a:avLst/>
                </a:prstGeom>
                <a:solidFill>
                  <a:schemeClr val="bg1"/>
                </a:solidFill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ko-KR" sz="1400" dirty="0">
                      <a:latin typeface="Trebuchet MS" panose="020B0603020202020204" pitchFamily="34" charset="0"/>
                    </a:rPr>
                    <a:t>‘</a:t>
                  </a:r>
                  <a:endParaRPr lang="ko-KR" altLang="en-US" sz="1400" dirty="0">
                    <a:latin typeface="Trebuchet MS" panose="020B0603020202020204" pitchFamily="34" charset="0"/>
                  </a:endParaRPr>
                </a:p>
              </p:txBody>
            </p:sp>
            <p:sp>
              <p:nvSpPr>
                <p:cNvPr id="351" name="오른쪽 화살표 350"/>
                <p:cNvSpPr/>
                <p:nvPr/>
              </p:nvSpPr>
              <p:spPr>
                <a:xfrm>
                  <a:off x="7031145" y="575760"/>
                  <a:ext cx="637162" cy="481263"/>
                </a:xfrm>
                <a:prstGeom prst="rightArrow">
                  <a:avLst/>
                </a:prstGeom>
                <a:solidFill>
                  <a:schemeClr val="bg1"/>
                </a:solidFill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ko-KR" sz="1400" dirty="0">
                      <a:latin typeface="Trebuchet MS" panose="020B0603020202020204" pitchFamily="34" charset="0"/>
                    </a:rPr>
                    <a:t>‘</a:t>
                  </a:r>
                  <a:endParaRPr lang="ko-KR" altLang="en-US" sz="1400" dirty="0">
                    <a:latin typeface="Trebuchet MS" panose="020B0603020202020204" pitchFamily="34" charset="0"/>
                  </a:endParaRPr>
                </a:p>
              </p:txBody>
            </p:sp>
            <p:sp>
              <p:nvSpPr>
                <p:cNvPr id="352" name="오른쪽 화살표 351"/>
                <p:cNvSpPr/>
                <p:nvPr/>
              </p:nvSpPr>
              <p:spPr>
                <a:xfrm>
                  <a:off x="6457409" y="575760"/>
                  <a:ext cx="637162" cy="481263"/>
                </a:xfrm>
                <a:prstGeom prst="rightArrow">
                  <a:avLst/>
                </a:prstGeom>
                <a:solidFill>
                  <a:schemeClr val="bg1"/>
                </a:solidFill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ko-KR" sz="1400" dirty="0">
                      <a:latin typeface="Trebuchet MS" panose="020B0603020202020204" pitchFamily="34" charset="0"/>
                    </a:rPr>
                    <a:t>‘</a:t>
                  </a:r>
                  <a:endParaRPr lang="ko-KR" altLang="en-US" sz="1400" dirty="0">
                    <a:latin typeface="Trebuchet MS" panose="020B0603020202020204" pitchFamily="34" charset="0"/>
                  </a:endParaRPr>
                </a:p>
              </p:txBody>
            </p:sp>
            <p:sp>
              <p:nvSpPr>
                <p:cNvPr id="353" name="TextBox 352"/>
                <p:cNvSpPr txBox="1"/>
                <p:nvPr/>
              </p:nvSpPr>
              <p:spPr>
                <a:xfrm>
                  <a:off x="6308910" y="293038"/>
                  <a:ext cx="757975" cy="3791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ko-KR" sz="800" b="1" dirty="0">
                      <a:latin typeface="Trebuchet MS" panose="020B0603020202020204" pitchFamily="34" charset="0"/>
                      <a:cs typeface="Times New Roman" panose="02020603050405020304" pitchFamily="18" charset="0"/>
                    </a:rPr>
                    <a:t>3491</a:t>
                  </a:r>
                  <a:endParaRPr lang="ko-KR" altLang="en-US" sz="800" b="1" dirty="0">
                    <a:latin typeface="Trebuchet MS" panose="020B060302020202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54" name="TextBox 353"/>
                <p:cNvSpPr txBox="1"/>
                <p:nvPr/>
              </p:nvSpPr>
              <p:spPr>
                <a:xfrm>
                  <a:off x="6891362" y="293040"/>
                  <a:ext cx="757975" cy="3791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ko-KR" sz="800" b="1" dirty="0">
                      <a:latin typeface="Trebuchet MS" panose="020B0603020202020204" pitchFamily="34" charset="0"/>
                      <a:cs typeface="Times New Roman" panose="02020603050405020304" pitchFamily="18" charset="0"/>
                    </a:rPr>
                    <a:t>3492</a:t>
                  </a:r>
                  <a:endParaRPr lang="ko-KR" altLang="en-US" sz="800" b="1" dirty="0">
                    <a:latin typeface="Trebuchet MS" panose="020B060302020202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55" name="TextBox 354"/>
                <p:cNvSpPr txBox="1"/>
                <p:nvPr/>
              </p:nvSpPr>
              <p:spPr>
                <a:xfrm>
                  <a:off x="7543015" y="293040"/>
                  <a:ext cx="757975" cy="3791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ko-KR" sz="800" b="1" dirty="0">
                      <a:latin typeface="Trebuchet MS" panose="020B0603020202020204" pitchFamily="34" charset="0"/>
                      <a:cs typeface="Times New Roman" panose="02020603050405020304" pitchFamily="18" charset="0"/>
                    </a:rPr>
                    <a:t>3493</a:t>
                  </a:r>
                  <a:endParaRPr lang="ko-KR" altLang="en-US" sz="800" b="1" dirty="0">
                    <a:latin typeface="Trebuchet MS" panose="020B060302020202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56" name="TextBox 355"/>
                <p:cNvSpPr txBox="1"/>
                <p:nvPr/>
              </p:nvSpPr>
              <p:spPr>
                <a:xfrm>
                  <a:off x="8108524" y="293040"/>
                  <a:ext cx="757975" cy="3791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ko-KR" sz="800" b="1" dirty="0">
                      <a:latin typeface="Trebuchet MS" panose="020B0603020202020204" pitchFamily="34" charset="0"/>
                      <a:cs typeface="Times New Roman" panose="02020603050405020304" pitchFamily="18" charset="0"/>
                    </a:rPr>
                    <a:t>3494</a:t>
                  </a:r>
                  <a:endParaRPr lang="ko-KR" altLang="en-US" sz="800" b="1" dirty="0">
                    <a:latin typeface="Trebuchet MS" panose="020B060302020202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57" name="TextBox 356"/>
                <p:cNvSpPr txBox="1"/>
                <p:nvPr/>
              </p:nvSpPr>
              <p:spPr>
                <a:xfrm>
                  <a:off x="8641244" y="293040"/>
                  <a:ext cx="757975" cy="3791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ko-KR" sz="800" b="1" dirty="0">
                      <a:latin typeface="Trebuchet MS" panose="020B0603020202020204" pitchFamily="34" charset="0"/>
                      <a:cs typeface="Times New Roman" panose="02020603050405020304" pitchFamily="18" charset="0"/>
                    </a:rPr>
                    <a:t>3495</a:t>
                  </a:r>
                  <a:endParaRPr lang="ko-KR" altLang="en-US" sz="800" b="1" dirty="0">
                    <a:latin typeface="Trebuchet MS" panose="020B060302020202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58" name="TextBox 357"/>
                <p:cNvSpPr txBox="1"/>
                <p:nvPr/>
              </p:nvSpPr>
              <p:spPr>
                <a:xfrm>
                  <a:off x="9687094" y="293040"/>
                  <a:ext cx="757975" cy="3791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ko-KR" sz="800" b="1" dirty="0">
                      <a:latin typeface="Trebuchet MS" panose="020B0603020202020204" pitchFamily="34" charset="0"/>
                      <a:cs typeface="Times New Roman" panose="02020603050405020304" pitchFamily="18" charset="0"/>
                    </a:rPr>
                    <a:t>3496</a:t>
                  </a:r>
                  <a:endParaRPr lang="ko-KR" altLang="en-US" sz="800" b="1" dirty="0">
                    <a:latin typeface="Trebuchet MS" panose="020B060302020202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59" name="TextBox 358"/>
                <p:cNvSpPr txBox="1"/>
                <p:nvPr/>
              </p:nvSpPr>
              <p:spPr>
                <a:xfrm>
                  <a:off x="10565403" y="293040"/>
                  <a:ext cx="757975" cy="3791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ko-KR" sz="800" b="1" dirty="0">
                      <a:latin typeface="Trebuchet MS" panose="020B0603020202020204" pitchFamily="34" charset="0"/>
                      <a:cs typeface="Times New Roman" panose="02020603050405020304" pitchFamily="18" charset="0"/>
                    </a:rPr>
                    <a:t>3497</a:t>
                  </a:r>
                  <a:endParaRPr lang="ko-KR" altLang="en-US" sz="800" b="1" dirty="0">
                    <a:latin typeface="Trebuchet MS" panose="020B060302020202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60" name="오른쪽 화살표 359"/>
                <p:cNvSpPr/>
                <p:nvPr/>
              </p:nvSpPr>
              <p:spPr>
                <a:xfrm flipH="1">
                  <a:off x="11248701" y="575760"/>
                  <a:ext cx="172802" cy="481263"/>
                </a:xfrm>
                <a:prstGeom prst="rightArrow">
                  <a:avLst/>
                </a:prstGeom>
                <a:solidFill>
                  <a:schemeClr val="bg1"/>
                </a:solidFill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400">
                    <a:latin typeface="Trebuchet MS" panose="020B0603020202020204" pitchFamily="34" charset="0"/>
                  </a:endParaRPr>
                </a:p>
              </p:txBody>
            </p:sp>
            <p:sp>
              <p:nvSpPr>
                <p:cNvPr id="361" name="오른쪽 화살표 360"/>
                <p:cNvSpPr/>
                <p:nvPr/>
              </p:nvSpPr>
              <p:spPr>
                <a:xfrm>
                  <a:off x="11542368" y="575760"/>
                  <a:ext cx="172802" cy="481263"/>
                </a:xfrm>
                <a:prstGeom prst="rightArrow">
                  <a:avLst/>
                </a:prstGeom>
                <a:solidFill>
                  <a:schemeClr val="bg1"/>
                </a:solidFill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400">
                    <a:latin typeface="Trebuchet MS" panose="020B0603020202020204" pitchFamily="34" charset="0"/>
                  </a:endParaRPr>
                </a:p>
              </p:txBody>
            </p:sp>
            <p:sp>
              <p:nvSpPr>
                <p:cNvPr id="362" name="TextBox 361"/>
                <p:cNvSpPr txBox="1"/>
                <p:nvPr/>
              </p:nvSpPr>
              <p:spPr>
                <a:xfrm>
                  <a:off x="10998812" y="293029"/>
                  <a:ext cx="757975" cy="3791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ko-KR" sz="800" b="1" dirty="0">
                      <a:latin typeface="Trebuchet MS" panose="020B0603020202020204" pitchFamily="34" charset="0"/>
                      <a:cs typeface="Times New Roman" panose="02020603050405020304" pitchFamily="18" charset="0"/>
                    </a:rPr>
                    <a:t>3498</a:t>
                  </a:r>
                  <a:endParaRPr lang="ko-KR" altLang="en-US" sz="800" b="1" dirty="0">
                    <a:latin typeface="Trebuchet MS" panose="020B060302020202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63" name="TextBox 362"/>
                <p:cNvSpPr txBox="1"/>
                <p:nvPr/>
              </p:nvSpPr>
              <p:spPr>
                <a:xfrm>
                  <a:off x="11445929" y="291030"/>
                  <a:ext cx="757975" cy="3791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ko-KR" sz="800" b="1" dirty="0">
                      <a:latin typeface="Trebuchet MS" panose="020B0603020202020204" pitchFamily="34" charset="0"/>
                      <a:cs typeface="Times New Roman" panose="02020603050405020304" pitchFamily="18" charset="0"/>
                    </a:rPr>
                    <a:t>3499</a:t>
                  </a:r>
                  <a:endParaRPr lang="ko-KR" altLang="en-US" sz="800" b="1" dirty="0">
                    <a:latin typeface="Trebuchet MS" panose="020B060302020202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64" name="TextBox 363"/>
                <p:cNvSpPr txBox="1"/>
                <p:nvPr/>
              </p:nvSpPr>
              <p:spPr>
                <a:xfrm>
                  <a:off x="9770591" y="650750"/>
                  <a:ext cx="706913" cy="3791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800" b="1" i="1" dirty="0" err="1">
                      <a:latin typeface="Trebuchet MS" panose="020B0603020202020204" pitchFamily="34" charset="0"/>
                      <a:cs typeface="Times New Roman" panose="02020603050405020304" pitchFamily="18" charset="0"/>
                    </a:rPr>
                    <a:t>vctA</a:t>
                  </a:r>
                  <a:endParaRPr lang="ko-KR" altLang="en-US" sz="800" b="1" i="1" dirty="0">
                    <a:latin typeface="Trebuchet MS" panose="020B060302020202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65" name="TextBox 364"/>
                <p:cNvSpPr txBox="1"/>
                <p:nvPr/>
              </p:nvSpPr>
              <p:spPr>
                <a:xfrm>
                  <a:off x="7058232" y="655391"/>
                  <a:ext cx="718261" cy="3791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800" b="1" i="1" dirty="0" err="1">
                      <a:latin typeface="Trebuchet MS" panose="020B0603020202020204" pitchFamily="34" charset="0"/>
                      <a:cs typeface="Times New Roman" panose="02020603050405020304" pitchFamily="18" charset="0"/>
                    </a:rPr>
                    <a:t>vctG</a:t>
                  </a:r>
                  <a:endParaRPr lang="ko-KR" altLang="en-US" sz="800" b="1" i="1" dirty="0">
                    <a:latin typeface="Trebuchet MS" panose="020B060302020202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66" name="TextBox 365"/>
                <p:cNvSpPr txBox="1"/>
                <p:nvPr/>
              </p:nvSpPr>
              <p:spPr>
                <a:xfrm>
                  <a:off x="6403229" y="655391"/>
                  <a:ext cx="709752" cy="3791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800" b="1" i="1" dirty="0" err="1">
                      <a:latin typeface="Trebuchet MS" panose="020B0603020202020204" pitchFamily="34" charset="0"/>
                      <a:cs typeface="Times New Roman" panose="02020603050405020304" pitchFamily="18" charset="0"/>
                    </a:rPr>
                    <a:t>vctD</a:t>
                  </a:r>
                  <a:endParaRPr lang="ko-KR" altLang="en-US" sz="800" b="1" i="1" dirty="0">
                    <a:latin typeface="Trebuchet MS" panose="020B0603020202020204" pitchFamily="34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367" name="그룹 366"/>
                <p:cNvGrpSpPr/>
                <p:nvPr/>
              </p:nvGrpSpPr>
              <p:grpSpPr>
                <a:xfrm>
                  <a:off x="6975176" y="1835781"/>
                  <a:ext cx="3743464" cy="1070801"/>
                  <a:chOff x="6175076" y="1835781"/>
                  <a:chExt cx="3743464" cy="1070801"/>
                </a:xfrm>
              </p:grpSpPr>
              <p:cxnSp>
                <p:nvCxnSpPr>
                  <p:cNvPr id="374" name="직선 연결선 373"/>
                  <p:cNvCxnSpPr/>
                  <p:nvPr/>
                </p:nvCxnSpPr>
                <p:spPr>
                  <a:xfrm>
                    <a:off x="6362302" y="2076412"/>
                    <a:ext cx="316800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75" name="오른쪽 화살표 374"/>
                  <p:cNvSpPr/>
                  <p:nvPr/>
                </p:nvSpPr>
                <p:spPr>
                  <a:xfrm>
                    <a:off x="8570629" y="1835781"/>
                    <a:ext cx="144000" cy="481263"/>
                  </a:xfrm>
                  <a:prstGeom prst="rightArrow">
                    <a:avLst/>
                  </a:prstGeom>
                  <a:solidFill>
                    <a:schemeClr val="bg1"/>
                  </a:solidFill>
                  <a:ln w="190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1400">
                      <a:latin typeface="Trebuchet MS" panose="020B0603020202020204" pitchFamily="34" charset="0"/>
                    </a:endParaRPr>
                  </a:p>
                </p:txBody>
              </p:sp>
              <p:sp>
                <p:nvSpPr>
                  <p:cNvPr id="376" name="오른쪽 화살표 375"/>
                  <p:cNvSpPr/>
                  <p:nvPr/>
                </p:nvSpPr>
                <p:spPr>
                  <a:xfrm flipH="1">
                    <a:off x="8308300" y="1835781"/>
                    <a:ext cx="254864" cy="481263"/>
                  </a:xfrm>
                  <a:prstGeom prst="rightArrow">
                    <a:avLst/>
                  </a:prstGeom>
                  <a:solidFill>
                    <a:schemeClr val="bg1"/>
                  </a:solidFill>
                  <a:ln w="190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1400">
                      <a:latin typeface="Trebuchet MS" panose="020B0603020202020204" pitchFamily="34" charset="0"/>
                    </a:endParaRPr>
                  </a:p>
                </p:txBody>
              </p:sp>
              <p:sp>
                <p:nvSpPr>
                  <p:cNvPr id="377" name="오른쪽 화살표 376"/>
                  <p:cNvSpPr/>
                  <p:nvPr/>
                </p:nvSpPr>
                <p:spPr>
                  <a:xfrm>
                    <a:off x="7697692" y="1835781"/>
                    <a:ext cx="509730" cy="481263"/>
                  </a:xfrm>
                  <a:prstGeom prst="rightArrow">
                    <a:avLst/>
                  </a:prstGeom>
                  <a:solidFill>
                    <a:schemeClr val="bg1"/>
                  </a:solidFill>
                  <a:ln w="190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altLang="ko-KR" sz="1400" dirty="0">
                        <a:latin typeface="Trebuchet MS" panose="020B0603020202020204" pitchFamily="34" charset="0"/>
                      </a:rPr>
                      <a:t>‘</a:t>
                    </a:r>
                    <a:endParaRPr lang="ko-KR" altLang="en-US" sz="1400" dirty="0">
                      <a:latin typeface="Trebuchet MS" panose="020B0603020202020204" pitchFamily="34" charset="0"/>
                    </a:endParaRPr>
                  </a:p>
                </p:txBody>
              </p:sp>
              <p:sp>
                <p:nvSpPr>
                  <p:cNvPr id="378" name="오른쪽 화살표 377"/>
                  <p:cNvSpPr/>
                  <p:nvPr/>
                </p:nvSpPr>
                <p:spPr>
                  <a:xfrm>
                    <a:off x="7031147" y="1835781"/>
                    <a:ext cx="637162" cy="481263"/>
                  </a:xfrm>
                  <a:prstGeom prst="rightArrow">
                    <a:avLst/>
                  </a:prstGeom>
                  <a:solidFill>
                    <a:schemeClr val="bg1"/>
                  </a:solidFill>
                  <a:ln w="190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altLang="ko-KR" sz="1400" dirty="0">
                        <a:latin typeface="Trebuchet MS" panose="020B0603020202020204" pitchFamily="34" charset="0"/>
                      </a:rPr>
                      <a:t>‘</a:t>
                    </a:r>
                    <a:endParaRPr lang="ko-KR" altLang="en-US" sz="1400" dirty="0">
                      <a:latin typeface="Trebuchet MS" panose="020B0603020202020204" pitchFamily="34" charset="0"/>
                    </a:endParaRPr>
                  </a:p>
                </p:txBody>
              </p:sp>
              <p:sp>
                <p:nvSpPr>
                  <p:cNvPr id="379" name="오른쪽 화살표 378"/>
                  <p:cNvSpPr/>
                  <p:nvPr/>
                </p:nvSpPr>
                <p:spPr>
                  <a:xfrm>
                    <a:off x="6457411" y="1835781"/>
                    <a:ext cx="637162" cy="481263"/>
                  </a:xfrm>
                  <a:prstGeom prst="rightArrow">
                    <a:avLst/>
                  </a:prstGeom>
                  <a:solidFill>
                    <a:schemeClr val="bg1"/>
                  </a:solidFill>
                  <a:ln w="190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altLang="ko-KR" sz="1400" dirty="0">
                        <a:latin typeface="Trebuchet MS" panose="020B0603020202020204" pitchFamily="34" charset="0"/>
                      </a:rPr>
                      <a:t>‘</a:t>
                    </a:r>
                    <a:endParaRPr lang="ko-KR" altLang="en-US" sz="1400" dirty="0">
                      <a:latin typeface="Trebuchet MS" panose="020B0603020202020204" pitchFamily="34" charset="0"/>
                    </a:endParaRPr>
                  </a:p>
                </p:txBody>
              </p:sp>
              <p:sp>
                <p:nvSpPr>
                  <p:cNvPr id="380" name="TextBox 379"/>
                  <p:cNvSpPr txBox="1"/>
                  <p:nvPr/>
                </p:nvSpPr>
                <p:spPr>
                  <a:xfrm>
                    <a:off x="6175076" y="2375813"/>
                    <a:ext cx="865774" cy="37914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ko-KR" sz="800" b="1" dirty="0">
                        <a:latin typeface="Trebuchet MS" panose="020B0603020202020204" pitchFamily="34" charset="0"/>
                        <a:cs typeface="Times New Roman" panose="02020603050405020304" pitchFamily="18" charset="0"/>
                      </a:rPr>
                      <a:t>03607</a:t>
                    </a:r>
                    <a:endParaRPr lang="ko-KR" altLang="en-US" sz="800" b="1" dirty="0">
                      <a:latin typeface="Trebuchet MS" panose="020B0603020202020204" pitchFamily="34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81" name="TextBox 380"/>
                  <p:cNvSpPr txBox="1"/>
                  <p:nvPr/>
                </p:nvSpPr>
                <p:spPr>
                  <a:xfrm>
                    <a:off x="6736818" y="2375813"/>
                    <a:ext cx="865774" cy="37914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ko-KR" sz="800" b="1" dirty="0">
                        <a:latin typeface="Trebuchet MS" panose="020B0603020202020204" pitchFamily="34" charset="0"/>
                        <a:cs typeface="Times New Roman" panose="02020603050405020304" pitchFamily="18" charset="0"/>
                      </a:rPr>
                      <a:t>03608</a:t>
                    </a:r>
                    <a:endParaRPr lang="ko-KR" altLang="en-US" sz="800" b="1" dirty="0">
                      <a:latin typeface="Trebuchet MS" panose="020B0603020202020204" pitchFamily="34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82" name="TextBox 381"/>
                  <p:cNvSpPr txBox="1"/>
                  <p:nvPr/>
                </p:nvSpPr>
                <p:spPr>
                  <a:xfrm>
                    <a:off x="7344423" y="2375813"/>
                    <a:ext cx="865774" cy="37914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ko-KR" sz="800" b="1" dirty="0">
                        <a:latin typeface="Trebuchet MS" panose="020B0603020202020204" pitchFamily="34" charset="0"/>
                        <a:cs typeface="Times New Roman" panose="02020603050405020304" pitchFamily="18" charset="0"/>
                      </a:rPr>
                      <a:t>03609</a:t>
                    </a:r>
                    <a:endParaRPr lang="ko-KR" altLang="en-US" sz="800" b="1" dirty="0">
                      <a:latin typeface="Trebuchet MS" panose="020B0603020202020204" pitchFamily="34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83" name="TextBox 382"/>
                  <p:cNvSpPr txBox="1"/>
                  <p:nvPr/>
                </p:nvSpPr>
                <p:spPr>
                  <a:xfrm>
                    <a:off x="7878445" y="2375813"/>
                    <a:ext cx="865774" cy="37914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ko-KR" sz="800" b="1" dirty="0">
                        <a:latin typeface="Trebuchet MS" panose="020B0603020202020204" pitchFamily="34" charset="0"/>
                        <a:cs typeface="Times New Roman" panose="02020603050405020304" pitchFamily="18" charset="0"/>
                      </a:rPr>
                      <a:t>03611</a:t>
                    </a:r>
                    <a:endParaRPr lang="ko-KR" altLang="en-US" sz="800" b="1" dirty="0">
                      <a:latin typeface="Trebuchet MS" panose="020B0603020202020204" pitchFamily="34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84" name="TextBox 383"/>
                  <p:cNvSpPr txBox="1"/>
                  <p:nvPr/>
                </p:nvSpPr>
                <p:spPr>
                  <a:xfrm>
                    <a:off x="8170531" y="2527439"/>
                    <a:ext cx="865774" cy="37914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ko-KR" sz="800" b="1" dirty="0">
                        <a:latin typeface="Trebuchet MS" panose="020B0603020202020204" pitchFamily="34" charset="0"/>
                        <a:cs typeface="Times New Roman" panose="02020603050405020304" pitchFamily="18" charset="0"/>
                      </a:rPr>
                      <a:t>03610</a:t>
                    </a:r>
                    <a:endParaRPr lang="ko-KR" altLang="en-US" sz="800" b="1" dirty="0">
                      <a:latin typeface="Trebuchet MS" panose="020B0603020202020204" pitchFamily="34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85" name="오른쪽 화살표 384"/>
                  <p:cNvSpPr/>
                  <p:nvPr/>
                </p:nvSpPr>
                <p:spPr>
                  <a:xfrm flipH="1">
                    <a:off x="8775010" y="1835781"/>
                    <a:ext cx="172802" cy="481263"/>
                  </a:xfrm>
                  <a:prstGeom prst="rightArrow">
                    <a:avLst/>
                  </a:prstGeom>
                  <a:solidFill>
                    <a:schemeClr val="bg1"/>
                  </a:solidFill>
                  <a:ln w="190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1400">
                      <a:latin typeface="Trebuchet MS" panose="020B0603020202020204" pitchFamily="34" charset="0"/>
                    </a:endParaRPr>
                  </a:p>
                </p:txBody>
              </p:sp>
              <p:sp>
                <p:nvSpPr>
                  <p:cNvPr id="386" name="오른쪽 화살표 385"/>
                  <p:cNvSpPr/>
                  <p:nvPr/>
                </p:nvSpPr>
                <p:spPr>
                  <a:xfrm>
                    <a:off x="9083918" y="1835781"/>
                    <a:ext cx="172802" cy="481263"/>
                  </a:xfrm>
                  <a:prstGeom prst="rightArrow">
                    <a:avLst/>
                  </a:prstGeom>
                  <a:solidFill>
                    <a:schemeClr val="bg1"/>
                  </a:solidFill>
                  <a:ln w="190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1400">
                      <a:latin typeface="Trebuchet MS" panose="020B0603020202020204" pitchFamily="34" charset="0"/>
                    </a:endParaRPr>
                  </a:p>
                </p:txBody>
              </p:sp>
              <p:sp>
                <p:nvSpPr>
                  <p:cNvPr id="387" name="TextBox 386"/>
                  <p:cNvSpPr txBox="1"/>
                  <p:nvPr/>
                </p:nvSpPr>
                <p:spPr>
                  <a:xfrm>
                    <a:off x="8497452" y="2373810"/>
                    <a:ext cx="865774" cy="37914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ko-KR" sz="800" b="1" dirty="0">
                        <a:latin typeface="Trebuchet MS" panose="020B0603020202020204" pitchFamily="34" charset="0"/>
                        <a:cs typeface="Times New Roman" panose="02020603050405020304" pitchFamily="18" charset="0"/>
                      </a:rPr>
                      <a:t>03612</a:t>
                    </a:r>
                    <a:endParaRPr lang="ko-KR" altLang="en-US" sz="800" b="1" dirty="0">
                      <a:latin typeface="Trebuchet MS" panose="020B0603020202020204" pitchFamily="34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88" name="TextBox 387"/>
                  <p:cNvSpPr txBox="1"/>
                  <p:nvPr/>
                </p:nvSpPr>
                <p:spPr>
                  <a:xfrm>
                    <a:off x="9052766" y="2373806"/>
                    <a:ext cx="865774" cy="37914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ko-KR" sz="800" b="1" dirty="0">
                        <a:latin typeface="Trebuchet MS" panose="020B0603020202020204" pitchFamily="34" charset="0"/>
                        <a:cs typeface="Times New Roman" panose="02020603050405020304" pitchFamily="18" charset="0"/>
                      </a:rPr>
                      <a:t>03613</a:t>
                    </a:r>
                    <a:endParaRPr lang="ko-KR" altLang="en-US" sz="800" b="1" dirty="0">
                      <a:latin typeface="Trebuchet MS" panose="020B0603020202020204" pitchFamily="34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89" name="TextBox 388"/>
                  <p:cNvSpPr txBox="1"/>
                  <p:nvPr/>
                </p:nvSpPr>
                <p:spPr>
                  <a:xfrm>
                    <a:off x="7029210" y="1925834"/>
                    <a:ext cx="718261" cy="37914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ko-KR" sz="800" b="1" i="1" dirty="0" err="1">
                        <a:latin typeface="Trebuchet MS" panose="020B0603020202020204" pitchFamily="34" charset="0"/>
                        <a:cs typeface="Times New Roman" panose="02020603050405020304" pitchFamily="18" charset="0"/>
                      </a:rPr>
                      <a:t>vctG</a:t>
                    </a:r>
                    <a:endParaRPr lang="ko-KR" altLang="en-US" sz="800" b="1" i="1" dirty="0">
                      <a:latin typeface="Trebuchet MS" panose="020B0603020202020204" pitchFamily="34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90" name="TextBox 389"/>
                  <p:cNvSpPr txBox="1"/>
                  <p:nvPr/>
                </p:nvSpPr>
                <p:spPr>
                  <a:xfrm>
                    <a:off x="6449034" y="1925834"/>
                    <a:ext cx="709752" cy="37914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ko-KR" sz="800" b="1" i="1" dirty="0" err="1">
                        <a:latin typeface="Trebuchet MS" panose="020B0603020202020204" pitchFamily="34" charset="0"/>
                        <a:cs typeface="Times New Roman" panose="02020603050405020304" pitchFamily="18" charset="0"/>
                      </a:rPr>
                      <a:t>vctD</a:t>
                    </a:r>
                    <a:endParaRPr lang="ko-KR" altLang="en-US" sz="800" b="1" i="1" dirty="0">
                      <a:latin typeface="Trebuchet MS" panose="020B0603020202020204" pitchFamily="34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368" name="TextBox 367"/>
                <p:cNvSpPr txBox="1"/>
                <p:nvPr/>
              </p:nvSpPr>
              <p:spPr>
                <a:xfrm>
                  <a:off x="6736056" y="1272885"/>
                  <a:ext cx="749467" cy="43330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000" b="1" dirty="0">
                      <a:latin typeface="Trebuchet MS" panose="020B0603020202020204" pitchFamily="34" charset="0"/>
                      <a:cs typeface="Times New Roman" panose="02020603050405020304" pitchFamily="18" charset="0"/>
                    </a:rPr>
                    <a:t>99%</a:t>
                  </a:r>
                  <a:endParaRPr lang="ko-KR" altLang="en-US" sz="1000" b="1" dirty="0">
                    <a:latin typeface="Trebuchet MS" panose="020B060302020202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69" name="TextBox 368"/>
                <p:cNvSpPr txBox="1"/>
                <p:nvPr/>
              </p:nvSpPr>
              <p:spPr>
                <a:xfrm>
                  <a:off x="7360050" y="1272885"/>
                  <a:ext cx="749467" cy="43330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000" b="1" dirty="0">
                      <a:latin typeface="Trebuchet MS" panose="020B0603020202020204" pitchFamily="34" charset="0"/>
                      <a:cs typeface="Times New Roman" panose="02020603050405020304" pitchFamily="18" charset="0"/>
                    </a:rPr>
                    <a:t>99%</a:t>
                  </a:r>
                  <a:endParaRPr lang="ko-KR" altLang="en-US" sz="1000" b="1" dirty="0">
                    <a:latin typeface="Trebuchet MS" panose="020B060302020202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70" name="TextBox 369"/>
                <p:cNvSpPr txBox="1"/>
                <p:nvPr/>
              </p:nvSpPr>
              <p:spPr>
                <a:xfrm>
                  <a:off x="7962587" y="1272885"/>
                  <a:ext cx="749467" cy="43330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000" b="1" dirty="0">
                      <a:latin typeface="Trebuchet MS" panose="020B0603020202020204" pitchFamily="34" charset="0"/>
                      <a:cs typeface="Times New Roman" panose="02020603050405020304" pitchFamily="18" charset="0"/>
                    </a:rPr>
                    <a:t>97%</a:t>
                  </a:r>
                  <a:endParaRPr lang="ko-KR" altLang="en-US" sz="1000" b="1" dirty="0">
                    <a:latin typeface="Trebuchet MS" panose="020B060302020202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71" name="TextBox 370"/>
                <p:cNvSpPr txBox="1"/>
                <p:nvPr/>
              </p:nvSpPr>
              <p:spPr>
                <a:xfrm>
                  <a:off x="8515983" y="1272885"/>
                  <a:ext cx="749467" cy="43330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000" b="1" dirty="0">
                      <a:latin typeface="Trebuchet MS" panose="020B0603020202020204" pitchFamily="34" charset="0"/>
                      <a:cs typeface="Times New Roman" panose="02020603050405020304" pitchFamily="18" charset="0"/>
                    </a:rPr>
                    <a:t>98%</a:t>
                  </a:r>
                  <a:endParaRPr lang="ko-KR" altLang="en-US" sz="1000" b="1" dirty="0">
                    <a:latin typeface="Trebuchet MS" panose="020B060302020202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72" name="TextBox 371"/>
                <p:cNvSpPr txBox="1"/>
                <p:nvPr/>
              </p:nvSpPr>
              <p:spPr>
                <a:xfrm>
                  <a:off x="10002000" y="1272885"/>
                  <a:ext cx="882793" cy="43330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000" b="1" dirty="0">
                      <a:latin typeface="Trebuchet MS" panose="020B0603020202020204" pitchFamily="34" charset="0"/>
                      <a:cs typeface="Times New Roman" panose="02020603050405020304" pitchFamily="18" charset="0"/>
                    </a:rPr>
                    <a:t>100%</a:t>
                  </a:r>
                  <a:endParaRPr lang="ko-KR" altLang="en-US" sz="1000" b="1" dirty="0">
                    <a:latin typeface="Trebuchet MS" panose="020B060302020202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73" name="TextBox 372"/>
                <p:cNvSpPr txBox="1"/>
                <p:nvPr/>
              </p:nvSpPr>
              <p:spPr>
                <a:xfrm>
                  <a:off x="10625077" y="1272885"/>
                  <a:ext cx="749467" cy="43330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000" b="1" dirty="0">
                      <a:latin typeface="Trebuchet MS" panose="020B0603020202020204" pitchFamily="34" charset="0"/>
                      <a:cs typeface="Times New Roman" panose="02020603050405020304" pitchFamily="18" charset="0"/>
                    </a:rPr>
                    <a:t>99%</a:t>
                  </a:r>
                  <a:endParaRPr lang="ko-KR" altLang="en-US" sz="1000" b="1" dirty="0">
                    <a:latin typeface="Trebuchet MS" panose="020B0603020202020204" pitchFamily="34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336" name="그룹 335"/>
              <p:cNvGrpSpPr/>
              <p:nvPr/>
            </p:nvGrpSpPr>
            <p:grpSpPr>
              <a:xfrm>
                <a:off x="6541291" y="4698250"/>
                <a:ext cx="1135857" cy="1338019"/>
                <a:chOff x="6531131" y="4698250"/>
                <a:chExt cx="1135857" cy="1338019"/>
              </a:xfrm>
            </p:grpSpPr>
            <p:sp>
              <p:nvSpPr>
                <p:cNvPr id="337" name="TextBox 336"/>
                <p:cNvSpPr txBox="1"/>
                <p:nvPr/>
              </p:nvSpPr>
              <p:spPr>
                <a:xfrm>
                  <a:off x="6531131" y="4698250"/>
                  <a:ext cx="1135857" cy="35040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ko-KR" sz="1000" b="1" dirty="0">
                      <a:latin typeface="Trebuchet MS" panose="020B0603020202020204" pitchFamily="34" charset="0"/>
                      <a:cs typeface="Times New Roman" panose="02020603050405020304" pitchFamily="18" charset="0"/>
                    </a:rPr>
                    <a:t>FORC_016</a:t>
                  </a:r>
                  <a:endParaRPr lang="ko-KR" altLang="en-US" sz="1000" b="1" dirty="0">
                    <a:latin typeface="Trebuchet MS" panose="020B060302020202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38" name="TextBox 337"/>
                <p:cNvSpPr txBox="1"/>
                <p:nvPr/>
              </p:nvSpPr>
              <p:spPr>
                <a:xfrm>
                  <a:off x="6547035" y="5685868"/>
                  <a:ext cx="1104049" cy="35040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ko-KR" sz="1000" b="1" dirty="0">
                      <a:latin typeface="Trebuchet MS" panose="020B0603020202020204" pitchFamily="34" charset="0"/>
                      <a:cs typeface="Times New Roman" panose="02020603050405020304" pitchFamily="18" charset="0"/>
                    </a:rPr>
                    <a:t>MO6-24/O</a:t>
                  </a:r>
                  <a:endParaRPr lang="ko-KR" altLang="en-US" sz="1000" b="1" dirty="0">
                    <a:latin typeface="Trebuchet MS" panose="020B0603020202020204" pitchFamily="34" charset="0"/>
                    <a:cs typeface="Times New Roman" panose="02020603050405020304" pitchFamily="18" charset="0"/>
                  </a:endParaRP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18812552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679</TotalTime>
  <Words>297</Words>
  <Application>Microsoft Office PowerPoint</Application>
  <PresentationFormat>와이드스크린</PresentationFormat>
  <Paragraphs>129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HY신명조</vt:lpstr>
      <vt:lpstr>맑은 고딕</vt:lpstr>
      <vt:lpstr>Arial</vt:lpstr>
      <vt:lpstr>Times New Roman</vt:lpstr>
      <vt:lpstr>Trebuchet MS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ChungHY</dc:creator>
  <cp:lastModifiedBy>robinchung88@gmail.com</cp:lastModifiedBy>
  <cp:revision>782</cp:revision>
  <dcterms:created xsi:type="dcterms:W3CDTF">2016-04-07T07:54:00Z</dcterms:created>
  <dcterms:modified xsi:type="dcterms:W3CDTF">2020-12-23T08:49:52Z</dcterms:modified>
</cp:coreProperties>
</file>